
<file path=[Content_Types].xml><?xml version="1.0" encoding="utf-8"?>
<Types xmlns="http://schemas.openxmlformats.org/package/2006/content-types"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4"/>
  </p:notesMasterIdLst>
  <p:sldIdLst>
    <p:sldId id="263" r:id="rId2"/>
    <p:sldId id="265" r:id="rId3"/>
  </p:sldIdLst>
  <p:sldSz cx="6218238" cy="73152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792" userDrawn="1">
          <p15:clr>
            <a:srgbClr val="A4A3A4"/>
          </p15:clr>
        </p15:guide>
        <p15:guide id="2" pos="3903" userDrawn="1">
          <p15:clr>
            <a:srgbClr val="A4A3A4"/>
          </p15:clr>
        </p15:guide>
      </p15:sldGuideLst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4" roundtripDataSignature="AMtx7mj/BDH+bNNjuSv4gyR9t2YOdsqWwA==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ichaela Cain" initials="" lastIdx="9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10"/>
    <p:restoredTop sz="89110"/>
  </p:normalViewPr>
  <p:slideViewPr>
    <p:cSldViewPr snapToGrid="0">
      <p:cViewPr varScale="1">
        <p:scale>
          <a:sx n="105" d="100"/>
          <a:sy n="105" d="100"/>
        </p:scale>
        <p:origin x="3144" y="200"/>
      </p:cViewPr>
      <p:guideLst>
        <p:guide orient="horz" pos="792"/>
        <p:guide pos="3903"/>
      </p:guideLst>
    </p:cSldViewPr>
  </p:slideViewPr>
  <p:notesTextViewPr>
    <p:cViewPr>
      <p:scale>
        <a:sx n="105" d="100"/>
        <a:sy n="10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20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15" Type="http://schemas.openxmlformats.org/officeDocument/2006/relationships/commentAuthors" Target="commentAuthors.xml"/><Relationship Id="rId19" Type="http://schemas.openxmlformats.org/officeDocument/2006/relationships/tableStyles" Target="tableStyles.xml"/><Relationship Id="rId4" Type="http://schemas.openxmlformats.org/officeDocument/2006/relationships/notesMaster" Target="notesMasters/notesMaster1.xml"/><Relationship Id="rId14" Type="http://customschemas.google.com/relationships/presentationmetadata" Target="metadata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uying Liang" userId="jHfLqa0+NHnW/L3/y1HwdzoR61mtDz/AjzlijymjloY=" providerId="None" clId="Web-{6A3DDBA3-8C01-426A-AD90-673A62B33081}"/>
    <pc:docChg chg="modSld">
      <pc:chgData name="Yuying Liang" userId="jHfLqa0+NHnW/L3/y1HwdzoR61mtDz/AjzlijymjloY=" providerId="None" clId="Web-{6A3DDBA3-8C01-426A-AD90-673A62B33081}" dt="2026-02-25T17:35:35.041" v="81" actId="1076"/>
      <pc:docMkLst>
        <pc:docMk/>
      </pc:docMkLst>
      <pc:sldChg chg="modSp">
        <pc:chgData name="Yuying Liang" userId="jHfLqa0+NHnW/L3/y1HwdzoR61mtDz/AjzlijymjloY=" providerId="None" clId="Web-{6A3DDBA3-8C01-426A-AD90-673A62B33081}" dt="2026-02-25T17:35:35.041" v="81" actId="1076"/>
        <pc:sldMkLst>
          <pc:docMk/>
          <pc:sldMk cId="423064511" sldId="267"/>
        </pc:sldMkLst>
        <pc:spChg chg="mod">
          <ac:chgData name="Yuying Liang" userId="jHfLqa0+NHnW/L3/y1HwdzoR61mtDz/AjzlijymjloY=" providerId="None" clId="Web-{6A3DDBA3-8C01-426A-AD90-673A62B33081}" dt="2026-02-25T17:34:32.400" v="61" actId="20577"/>
          <ac:spMkLst>
            <pc:docMk/>
            <pc:sldMk cId="423064511" sldId="267"/>
            <ac:spMk id="191" creationId="{1F25606F-E82D-D541-9540-8F8A82E617EA}"/>
          </ac:spMkLst>
        </pc:spChg>
        <pc:spChg chg="mod">
          <ac:chgData name="Yuying Liang" userId="jHfLqa0+NHnW/L3/y1HwdzoR61mtDz/AjzlijymjloY=" providerId="None" clId="Web-{6A3DDBA3-8C01-426A-AD90-673A62B33081}" dt="2026-02-25T17:35:34.166" v="70" actId="1076"/>
          <ac:spMkLst>
            <pc:docMk/>
            <pc:sldMk cId="423064511" sldId="267"/>
            <ac:spMk id="192" creationId="{DE032EDC-AE41-3241-9E13-33B2127150C5}"/>
          </ac:spMkLst>
        </pc:spChg>
        <pc:spChg chg="mod">
          <ac:chgData name="Yuying Liang" userId="jHfLqa0+NHnW/L3/y1HwdzoR61mtDz/AjzlijymjloY=" providerId="None" clId="Web-{6A3DDBA3-8C01-426A-AD90-673A62B33081}" dt="2026-02-25T17:35:34.244" v="71" actId="1076"/>
          <ac:spMkLst>
            <pc:docMk/>
            <pc:sldMk cId="423064511" sldId="267"/>
            <ac:spMk id="194" creationId="{89D7DF69-24AB-B145-8825-71FDB926CA9D}"/>
          </ac:spMkLst>
        </pc:spChg>
        <pc:spChg chg="mod">
          <ac:chgData name="Yuying Liang" userId="jHfLqa0+NHnW/L3/y1HwdzoR61mtDz/AjzlijymjloY=" providerId="None" clId="Web-{6A3DDBA3-8C01-426A-AD90-673A62B33081}" dt="2026-02-25T17:32:41.602" v="24" actId="1076"/>
          <ac:spMkLst>
            <pc:docMk/>
            <pc:sldMk cId="423064511" sldId="267"/>
            <ac:spMk id="195" creationId="{2FA7C4FB-E919-FC44-AF23-2BE32ED5F48D}"/>
          </ac:spMkLst>
        </pc:spChg>
        <pc:spChg chg="mod">
          <ac:chgData name="Yuying Liang" userId="jHfLqa0+NHnW/L3/y1HwdzoR61mtDz/AjzlijymjloY=" providerId="None" clId="Web-{6A3DDBA3-8C01-426A-AD90-673A62B33081}" dt="2026-02-25T17:32:41.665" v="25" actId="1076"/>
          <ac:spMkLst>
            <pc:docMk/>
            <pc:sldMk cId="423064511" sldId="267"/>
            <ac:spMk id="197" creationId="{D428C8F4-217B-1D4F-88DD-8C88C4EC0E42}"/>
          </ac:spMkLst>
        </pc:spChg>
        <pc:spChg chg="mod">
          <ac:chgData name="Yuying Liang" userId="jHfLqa0+NHnW/L3/y1HwdzoR61mtDz/AjzlijymjloY=" providerId="None" clId="Web-{6A3DDBA3-8C01-426A-AD90-673A62B33081}" dt="2026-02-25T17:32:56.462" v="36" actId="1076"/>
          <ac:spMkLst>
            <pc:docMk/>
            <pc:sldMk cId="423064511" sldId="267"/>
            <ac:spMk id="198" creationId="{22FB9C45-E78D-F74C-ACC6-F64049E66890}"/>
          </ac:spMkLst>
        </pc:spChg>
        <pc:spChg chg="mod">
          <ac:chgData name="Yuying Liang" userId="jHfLqa0+NHnW/L3/y1HwdzoR61mtDz/AjzlijymjloY=" providerId="None" clId="Web-{6A3DDBA3-8C01-426A-AD90-673A62B33081}" dt="2026-02-25T17:34:38.447" v="63" actId="20577"/>
          <ac:spMkLst>
            <pc:docMk/>
            <pc:sldMk cId="423064511" sldId="267"/>
            <ac:spMk id="200" creationId="{E5E98A1B-7FBD-234B-B09F-F360357969C5}"/>
          </ac:spMkLst>
        </pc:spChg>
        <pc:spChg chg="mod">
          <ac:chgData name="Yuying Liang" userId="jHfLqa0+NHnW/L3/y1HwdzoR61mtDz/AjzlijymjloY=" providerId="None" clId="Web-{6A3DDBA3-8C01-426A-AD90-673A62B33081}" dt="2026-02-25T17:35:34.322" v="72" actId="1076"/>
          <ac:spMkLst>
            <pc:docMk/>
            <pc:sldMk cId="423064511" sldId="267"/>
            <ac:spMk id="201" creationId="{675B4E59-7805-7B42-B47C-841736873B7F}"/>
          </ac:spMkLst>
        </pc:spChg>
        <pc:spChg chg="mod">
          <ac:chgData name="Yuying Liang" userId="jHfLqa0+NHnW/L3/y1HwdzoR61mtDz/AjzlijymjloY=" providerId="None" clId="Web-{6A3DDBA3-8C01-426A-AD90-673A62B33081}" dt="2026-02-25T17:35:34.400" v="73" actId="1076"/>
          <ac:spMkLst>
            <pc:docMk/>
            <pc:sldMk cId="423064511" sldId="267"/>
            <ac:spMk id="203" creationId="{F63D9854-72CE-3E46-99DB-5E8E3CFD0836}"/>
          </ac:spMkLst>
        </pc:spChg>
        <pc:spChg chg="mod">
          <ac:chgData name="Yuying Liang" userId="jHfLqa0+NHnW/L3/y1HwdzoR61mtDz/AjzlijymjloY=" providerId="None" clId="Web-{6A3DDBA3-8C01-426A-AD90-673A62B33081}" dt="2026-02-25T17:32:41.743" v="26" actId="1076"/>
          <ac:spMkLst>
            <pc:docMk/>
            <pc:sldMk cId="423064511" sldId="267"/>
            <ac:spMk id="204" creationId="{C83B747F-8F4C-3B46-97D3-E91442BAA5DA}"/>
          </ac:spMkLst>
        </pc:spChg>
        <pc:spChg chg="mod">
          <ac:chgData name="Yuying Liang" userId="jHfLqa0+NHnW/L3/y1HwdzoR61mtDz/AjzlijymjloY=" providerId="None" clId="Web-{6A3DDBA3-8C01-426A-AD90-673A62B33081}" dt="2026-02-25T17:32:41.821" v="27" actId="1076"/>
          <ac:spMkLst>
            <pc:docMk/>
            <pc:sldMk cId="423064511" sldId="267"/>
            <ac:spMk id="206" creationId="{6061AE2B-F62C-C24E-BAF4-078447FADBE7}"/>
          </ac:spMkLst>
        </pc:spChg>
        <pc:spChg chg="mod">
          <ac:chgData name="Yuying Liang" userId="jHfLqa0+NHnW/L3/y1HwdzoR61mtDz/AjzlijymjloY=" providerId="None" clId="Web-{6A3DDBA3-8C01-426A-AD90-673A62B33081}" dt="2026-02-25T17:32:56.665" v="38" actId="1076"/>
          <ac:spMkLst>
            <pc:docMk/>
            <pc:sldMk cId="423064511" sldId="267"/>
            <ac:spMk id="207" creationId="{794DE8A5-954E-6C4E-867A-B2D66AEA3FD2}"/>
          </ac:spMkLst>
        </pc:spChg>
        <pc:spChg chg="mod">
          <ac:chgData name="Yuying Liang" userId="jHfLqa0+NHnW/L3/y1HwdzoR61mtDz/AjzlijymjloY=" providerId="None" clId="Web-{6A3DDBA3-8C01-426A-AD90-673A62B33081}" dt="2026-02-25T17:32:56.743" v="39" actId="1076"/>
          <ac:spMkLst>
            <pc:docMk/>
            <pc:sldMk cId="423064511" sldId="267"/>
            <ac:spMk id="209" creationId="{F93EE7C6-64EE-CE43-8519-E6A2DF82AACB}"/>
          </ac:spMkLst>
        </pc:spChg>
        <pc:spChg chg="mod">
          <ac:chgData name="Yuying Liang" userId="jHfLqa0+NHnW/L3/y1HwdzoR61mtDz/AjzlijymjloY=" providerId="None" clId="Web-{6A3DDBA3-8C01-426A-AD90-673A62B33081}" dt="2026-02-25T17:34:47.213" v="64" actId="20577"/>
          <ac:spMkLst>
            <pc:docMk/>
            <pc:sldMk cId="423064511" sldId="267"/>
            <ac:spMk id="212" creationId="{883016EB-CDF8-5642-8FFF-16149D84F6F1}"/>
          </ac:spMkLst>
        </pc:spChg>
        <pc:spChg chg="mod">
          <ac:chgData name="Yuying Liang" userId="jHfLqa0+NHnW/L3/y1HwdzoR61mtDz/AjzlijymjloY=" providerId="None" clId="Web-{6A3DDBA3-8C01-426A-AD90-673A62B33081}" dt="2026-02-25T17:33:44.681" v="52" actId="20577"/>
          <ac:spMkLst>
            <pc:docMk/>
            <pc:sldMk cId="423064511" sldId="267"/>
            <ac:spMk id="215" creationId="{9951BCA1-9898-954D-AAAE-79CF67C359D5}"/>
          </ac:spMkLst>
        </pc:spChg>
        <pc:spChg chg="mod">
          <ac:chgData name="Yuying Liang" userId="jHfLqa0+NHnW/L3/y1HwdzoR61mtDz/AjzlijymjloY=" providerId="None" clId="Web-{6A3DDBA3-8C01-426A-AD90-673A62B33081}" dt="2026-02-25T17:33:50.400" v="53" actId="20577"/>
          <ac:spMkLst>
            <pc:docMk/>
            <pc:sldMk cId="423064511" sldId="267"/>
            <ac:spMk id="218" creationId="{DEA937AB-88CD-8C4E-A6D2-7EBF35C2654C}"/>
          </ac:spMkLst>
        </pc:spChg>
        <pc:spChg chg="mod">
          <ac:chgData name="Yuying Liang" userId="jHfLqa0+NHnW/L3/y1HwdzoR61mtDz/AjzlijymjloY=" providerId="None" clId="Web-{6A3DDBA3-8C01-426A-AD90-673A62B33081}" dt="2026-02-25T17:34:23.416" v="60" actId="20577"/>
          <ac:spMkLst>
            <pc:docMk/>
            <pc:sldMk cId="423064511" sldId="267"/>
            <ac:spMk id="221" creationId="{E61C830E-E092-8D44-881C-27DE667930E1}"/>
          </ac:spMkLst>
        </pc:spChg>
        <pc:spChg chg="mod">
          <ac:chgData name="Yuying Liang" userId="jHfLqa0+NHnW/L3/y1HwdzoR61mtDz/AjzlijymjloY=" providerId="None" clId="Web-{6A3DDBA3-8C01-426A-AD90-673A62B33081}" dt="2026-02-25T17:34:13.166" v="59" actId="20577"/>
          <ac:spMkLst>
            <pc:docMk/>
            <pc:sldMk cId="423064511" sldId="267"/>
            <ac:spMk id="224" creationId="{43EB3A12-8E86-2E4E-961E-64146EB4C086}"/>
          </ac:spMkLst>
        </pc:spChg>
        <pc:spChg chg="mod">
          <ac:chgData name="Yuying Liang" userId="jHfLqa0+NHnW/L3/y1HwdzoR61mtDz/AjzlijymjloY=" providerId="None" clId="Web-{6A3DDBA3-8C01-426A-AD90-673A62B33081}" dt="2026-02-25T17:35:34.478" v="74" actId="1076"/>
          <ac:spMkLst>
            <pc:docMk/>
            <pc:sldMk cId="423064511" sldId="267"/>
            <ac:spMk id="225" creationId="{A87BC658-59FE-8A4A-A228-FDDF94EE0602}"/>
          </ac:spMkLst>
        </pc:spChg>
        <pc:spChg chg="mod">
          <ac:chgData name="Yuying Liang" userId="jHfLqa0+NHnW/L3/y1HwdzoR61mtDz/AjzlijymjloY=" providerId="None" clId="Web-{6A3DDBA3-8C01-426A-AD90-673A62B33081}" dt="2026-02-25T17:35:34.557" v="75" actId="1076"/>
          <ac:spMkLst>
            <pc:docMk/>
            <pc:sldMk cId="423064511" sldId="267"/>
            <ac:spMk id="227" creationId="{238BB6CA-3CE3-AF4B-B886-3E03BFD6187E}"/>
          </ac:spMkLst>
        </pc:spChg>
        <pc:spChg chg="mod">
          <ac:chgData name="Yuying Liang" userId="jHfLqa0+NHnW/L3/y1HwdzoR61mtDz/AjzlijymjloY=" providerId="None" clId="Web-{6A3DDBA3-8C01-426A-AD90-673A62B33081}" dt="2026-02-25T17:35:34.635" v="76" actId="1076"/>
          <ac:spMkLst>
            <pc:docMk/>
            <pc:sldMk cId="423064511" sldId="267"/>
            <ac:spMk id="228" creationId="{49BE6E4A-2F09-AF45-BA42-8295D1C9950F}"/>
          </ac:spMkLst>
        </pc:spChg>
        <pc:spChg chg="mod">
          <ac:chgData name="Yuying Liang" userId="jHfLqa0+NHnW/L3/y1HwdzoR61mtDz/AjzlijymjloY=" providerId="None" clId="Web-{6A3DDBA3-8C01-426A-AD90-673A62B33081}" dt="2026-02-25T17:35:34.728" v="77" actId="1076"/>
          <ac:spMkLst>
            <pc:docMk/>
            <pc:sldMk cId="423064511" sldId="267"/>
            <ac:spMk id="230" creationId="{79A14033-CC44-5C40-840C-A7667A0801C3}"/>
          </ac:spMkLst>
        </pc:spChg>
        <pc:spChg chg="mod">
          <ac:chgData name="Yuying Liang" userId="jHfLqa0+NHnW/L3/y1HwdzoR61mtDz/AjzlijymjloY=" providerId="None" clId="Web-{6A3DDBA3-8C01-426A-AD90-673A62B33081}" dt="2026-02-25T17:32:41.884" v="28" actId="1076"/>
          <ac:spMkLst>
            <pc:docMk/>
            <pc:sldMk cId="423064511" sldId="267"/>
            <ac:spMk id="234" creationId="{40D379EE-9E6B-414C-A4A4-E5AE024BE0DE}"/>
          </ac:spMkLst>
        </pc:spChg>
        <pc:spChg chg="mod">
          <ac:chgData name="Yuying Liang" userId="jHfLqa0+NHnW/L3/y1HwdzoR61mtDz/AjzlijymjloY=" providerId="None" clId="Web-{6A3DDBA3-8C01-426A-AD90-673A62B33081}" dt="2026-02-25T17:35:00.853" v="69" actId="20577"/>
          <ac:spMkLst>
            <pc:docMk/>
            <pc:sldMk cId="423064511" sldId="267"/>
            <ac:spMk id="236" creationId="{3D584002-E0B6-154E-BE8B-6894BFD9E684}"/>
          </ac:spMkLst>
        </pc:spChg>
        <pc:spChg chg="mod">
          <ac:chgData name="Yuying Liang" userId="jHfLqa0+NHnW/L3/y1HwdzoR61mtDz/AjzlijymjloY=" providerId="None" clId="Web-{6A3DDBA3-8C01-426A-AD90-673A62B33081}" dt="2026-02-25T17:32:42.040" v="30" actId="1076"/>
          <ac:spMkLst>
            <pc:docMk/>
            <pc:sldMk cId="423064511" sldId="267"/>
            <ac:spMk id="237" creationId="{1D6D664F-15D4-FD4F-91E1-236D70938E4C}"/>
          </ac:spMkLst>
        </pc:spChg>
        <pc:spChg chg="mod">
          <ac:chgData name="Yuying Liang" userId="jHfLqa0+NHnW/L3/y1HwdzoR61mtDz/AjzlijymjloY=" providerId="None" clId="Web-{6A3DDBA3-8C01-426A-AD90-673A62B33081}" dt="2026-02-25T17:32:42.118" v="31" actId="1076"/>
          <ac:spMkLst>
            <pc:docMk/>
            <pc:sldMk cId="423064511" sldId="267"/>
            <ac:spMk id="239" creationId="{DA113AE6-312B-4348-8517-693F4A561AB0}"/>
          </ac:spMkLst>
        </pc:spChg>
        <pc:spChg chg="mod">
          <ac:chgData name="Yuying Liang" userId="jHfLqa0+NHnW/L3/y1HwdzoR61mtDz/AjzlijymjloY=" providerId="None" clId="Web-{6A3DDBA3-8C01-426A-AD90-673A62B33081}" dt="2026-02-25T17:35:34.807" v="78" actId="1076"/>
          <ac:spMkLst>
            <pc:docMk/>
            <pc:sldMk cId="423064511" sldId="267"/>
            <ac:spMk id="240" creationId="{105C48AB-48A7-4949-A984-00DD15156468}"/>
          </ac:spMkLst>
        </pc:spChg>
        <pc:spChg chg="mod">
          <ac:chgData name="Yuying Liang" userId="jHfLqa0+NHnW/L3/y1HwdzoR61mtDz/AjzlijymjloY=" providerId="None" clId="Web-{6A3DDBA3-8C01-426A-AD90-673A62B33081}" dt="2026-02-25T17:35:34.885" v="79" actId="1076"/>
          <ac:spMkLst>
            <pc:docMk/>
            <pc:sldMk cId="423064511" sldId="267"/>
            <ac:spMk id="242" creationId="{CAC45503-D23B-274D-87EE-ADB21EC6BCB4}"/>
          </ac:spMkLst>
        </pc:spChg>
        <pc:spChg chg="mod">
          <ac:chgData name="Yuying Liang" userId="jHfLqa0+NHnW/L3/y1HwdzoR61mtDz/AjzlijymjloY=" providerId="None" clId="Web-{6A3DDBA3-8C01-426A-AD90-673A62B33081}" dt="2026-02-25T17:35:34.963" v="80" actId="1076"/>
          <ac:spMkLst>
            <pc:docMk/>
            <pc:sldMk cId="423064511" sldId="267"/>
            <ac:spMk id="243" creationId="{3C0BC64F-B68E-2C47-B9F9-28D020A8ABE4}"/>
          </ac:spMkLst>
        </pc:spChg>
        <pc:spChg chg="mod">
          <ac:chgData name="Yuying Liang" userId="jHfLqa0+NHnW/L3/y1HwdzoR61mtDz/AjzlijymjloY=" providerId="None" clId="Web-{6A3DDBA3-8C01-426A-AD90-673A62B33081}" dt="2026-02-25T17:35:35.041" v="81" actId="1076"/>
          <ac:spMkLst>
            <pc:docMk/>
            <pc:sldMk cId="423064511" sldId="267"/>
            <ac:spMk id="245" creationId="{FC8E1BDA-9D1E-9348-9F2B-2578B6117029}"/>
          </ac:spMkLst>
        </pc:spChg>
        <pc:spChg chg="mod">
          <ac:chgData name="Yuying Liang" userId="jHfLqa0+NHnW/L3/y1HwdzoR61mtDz/AjzlijymjloY=" providerId="None" clId="Web-{6A3DDBA3-8C01-426A-AD90-673A62B33081}" dt="2026-02-25T17:32:42.196" v="32" actId="1076"/>
          <ac:spMkLst>
            <pc:docMk/>
            <pc:sldMk cId="423064511" sldId="267"/>
            <ac:spMk id="246" creationId="{F9448975-35D6-8E45-B27D-42D3BAE99291}"/>
          </ac:spMkLst>
        </pc:spChg>
        <pc:spChg chg="mod">
          <ac:chgData name="Yuying Liang" userId="jHfLqa0+NHnW/L3/y1HwdzoR61mtDz/AjzlijymjloY=" providerId="None" clId="Web-{6A3DDBA3-8C01-426A-AD90-673A62B33081}" dt="2026-02-25T17:33:36.884" v="50" actId="20577"/>
          <ac:spMkLst>
            <pc:docMk/>
            <pc:sldMk cId="423064511" sldId="267"/>
            <ac:spMk id="248" creationId="{CF01DF0A-943A-F043-A3DC-4E809DD0B182}"/>
          </ac:spMkLst>
        </pc:spChg>
        <pc:spChg chg="mod">
          <ac:chgData name="Yuying Liang" userId="jHfLqa0+NHnW/L3/y1HwdzoR61mtDz/AjzlijymjloY=" providerId="None" clId="Web-{6A3DDBA3-8C01-426A-AD90-673A62B33081}" dt="2026-02-25T17:32:42.352" v="34" actId="1076"/>
          <ac:spMkLst>
            <pc:docMk/>
            <pc:sldMk cId="423064511" sldId="267"/>
            <ac:spMk id="249" creationId="{52E79F25-29C1-E34F-99AB-7BF9F66FF1DE}"/>
          </ac:spMkLst>
        </pc:spChg>
        <pc:spChg chg="mod">
          <ac:chgData name="Yuying Liang" userId="jHfLqa0+NHnW/L3/y1HwdzoR61mtDz/AjzlijymjloY=" providerId="None" clId="Web-{6A3DDBA3-8C01-426A-AD90-673A62B33081}" dt="2026-02-25T17:34:04.150" v="55" actId="20577"/>
          <ac:spMkLst>
            <pc:docMk/>
            <pc:sldMk cId="423064511" sldId="267"/>
            <ac:spMk id="251" creationId="{00AAFE26-E9C5-D44B-89E8-81BBE9C081B3}"/>
          </ac:spMkLst>
        </pc:spChg>
        <pc:spChg chg="mod">
          <ac:chgData name="Yuying Liang" userId="jHfLqa0+NHnW/L3/y1HwdzoR61mtDz/AjzlijymjloY=" providerId="None" clId="Web-{6A3DDBA3-8C01-426A-AD90-673A62B33081}" dt="2026-02-25T17:32:56.821" v="40" actId="1076"/>
          <ac:spMkLst>
            <pc:docMk/>
            <pc:sldMk cId="423064511" sldId="267"/>
            <ac:spMk id="252" creationId="{E7352F3C-08DD-FB4D-A03D-9E7D76872887}"/>
          </ac:spMkLst>
        </pc:spChg>
        <pc:spChg chg="mod">
          <ac:chgData name="Yuying Liang" userId="jHfLqa0+NHnW/L3/y1HwdzoR61mtDz/AjzlijymjloY=" providerId="None" clId="Web-{6A3DDBA3-8C01-426A-AD90-673A62B33081}" dt="2026-02-25T17:33:21.431" v="48" actId="20577"/>
          <ac:spMkLst>
            <pc:docMk/>
            <pc:sldMk cId="423064511" sldId="267"/>
            <ac:spMk id="254" creationId="{83E5C181-A77C-F544-A9FD-7C742A8DE4A2}"/>
          </ac:spMkLst>
        </pc:spChg>
        <pc:spChg chg="mod">
          <ac:chgData name="Yuying Liang" userId="jHfLqa0+NHnW/L3/y1HwdzoR61mtDz/AjzlijymjloY=" providerId="None" clId="Web-{6A3DDBA3-8C01-426A-AD90-673A62B33081}" dt="2026-02-25T17:32:56.993" v="42" actId="1076"/>
          <ac:spMkLst>
            <pc:docMk/>
            <pc:sldMk cId="423064511" sldId="267"/>
            <ac:spMk id="255" creationId="{8A4DBC14-A247-9341-BE11-245C1A54CFB1}"/>
          </ac:spMkLst>
        </pc:spChg>
        <pc:spChg chg="mod">
          <ac:chgData name="Yuying Liang" userId="jHfLqa0+NHnW/L3/y1HwdzoR61mtDz/AjzlijymjloY=" providerId="None" clId="Web-{6A3DDBA3-8C01-426A-AD90-673A62B33081}" dt="2026-02-25T17:33:56.587" v="54" actId="20577"/>
          <ac:spMkLst>
            <pc:docMk/>
            <pc:sldMk cId="423064511" sldId="267"/>
            <ac:spMk id="257" creationId="{C94D9FC5-F6F3-C14A-87F4-FE5C4B8EF48B}"/>
          </ac:spMkLst>
        </pc:spChg>
        <pc:spChg chg="mod">
          <ac:chgData name="Yuying Liang" userId="jHfLqa0+NHnW/L3/y1HwdzoR61mtDz/AjzlijymjloY=" providerId="None" clId="Web-{6A3DDBA3-8C01-426A-AD90-673A62B33081}" dt="2026-02-25T17:32:57.134" v="44" actId="1076"/>
          <ac:spMkLst>
            <pc:docMk/>
            <pc:sldMk cId="423064511" sldId="267"/>
            <ac:spMk id="259" creationId="{B7DCC04F-393B-F34F-A422-D838A429936F}"/>
          </ac:spMkLst>
        </pc:spChg>
        <pc:spChg chg="mod">
          <ac:chgData name="Yuying Liang" userId="jHfLqa0+NHnW/L3/y1HwdzoR61mtDz/AjzlijymjloY=" providerId="None" clId="Web-{6A3DDBA3-8C01-426A-AD90-673A62B33081}" dt="2026-02-25T17:32:57.212" v="45" actId="1076"/>
          <ac:spMkLst>
            <pc:docMk/>
            <pc:sldMk cId="423064511" sldId="267"/>
            <ac:spMk id="260" creationId="{BF6EA7E8-90F2-F048-A489-385AC16DE3BC}"/>
          </ac:spMkLst>
        </pc:spChg>
        <pc:spChg chg="mod">
          <ac:chgData name="Yuying Liang" userId="jHfLqa0+NHnW/L3/y1HwdzoR61mtDz/AjzlijymjloY=" providerId="None" clId="Web-{6A3DDBA3-8C01-426A-AD90-673A62B33081}" dt="2026-02-25T17:32:57.290" v="46" actId="1076"/>
          <ac:spMkLst>
            <pc:docMk/>
            <pc:sldMk cId="423064511" sldId="267"/>
            <ac:spMk id="262" creationId="{94C25DE7-A60B-4747-BFFD-070D64AA78E4}"/>
          </ac:spMkLst>
        </pc:spChg>
        <pc:spChg chg="mod">
          <ac:chgData name="Yuying Liang" userId="jHfLqa0+NHnW/L3/y1HwdzoR61mtDz/AjzlijymjloY=" providerId="None" clId="Web-{6A3DDBA3-8C01-426A-AD90-673A62B33081}" dt="2026-02-25T17:32:57.368" v="47" actId="1076"/>
          <ac:spMkLst>
            <pc:docMk/>
            <pc:sldMk cId="423064511" sldId="267"/>
            <ac:spMk id="263" creationId="{08D28CAB-8AEE-9C4F-9D58-934F0BF2C467}"/>
          </ac:spMkLst>
        </pc:spChg>
      </pc:sldChg>
    </pc:docChg>
  </pc:docChgLst>
  <pc:docChgLst>
    <pc:chgData name="Yuying Liang" userId="jHfLqa0+NHnW/L3/y1HwdzoR61mtDz/AjzlijymjloY=" providerId="None" clId="Web-{679789CC-9D96-4E9F-9F7F-A2765F89A6A3}"/>
    <pc:docChg chg="modSld">
      <pc:chgData name="Yuying Liang" userId="jHfLqa0+NHnW/L3/y1HwdzoR61mtDz/AjzlijymjloY=" providerId="None" clId="Web-{679789CC-9D96-4E9F-9F7F-A2765F89A6A3}" dt="2026-02-25T17:40:02.271" v="183" actId="20577"/>
      <pc:docMkLst>
        <pc:docMk/>
      </pc:docMkLst>
      <pc:sldChg chg="addSp modSp">
        <pc:chgData name="Yuying Liang" userId="jHfLqa0+NHnW/L3/y1HwdzoR61mtDz/AjzlijymjloY=" providerId="None" clId="Web-{679789CC-9D96-4E9F-9F7F-A2765F89A6A3}" dt="2026-02-25T17:38:35.357" v="1" actId="20577"/>
        <pc:sldMkLst>
          <pc:docMk/>
          <pc:sldMk cId="2010271802" sldId="257"/>
        </pc:sldMkLst>
        <pc:spChg chg="add mod">
          <ac:chgData name="Yuying Liang" userId="jHfLqa0+NHnW/L3/y1HwdzoR61mtDz/AjzlijymjloY=" providerId="None" clId="Web-{679789CC-9D96-4E9F-9F7F-A2765F89A6A3}" dt="2026-02-25T17:38:35.357" v="1" actId="20577"/>
          <ac:spMkLst>
            <pc:docMk/>
            <pc:sldMk cId="2010271802" sldId="257"/>
            <ac:spMk id="16" creationId="{6C7B1392-3E11-986A-BB89-96F9B7152D56}"/>
          </ac:spMkLst>
        </pc:spChg>
      </pc:sldChg>
      <pc:sldChg chg="addSp modSp">
        <pc:chgData name="Yuying Liang" userId="jHfLqa0+NHnW/L3/y1HwdzoR61mtDz/AjzlijymjloY=" providerId="None" clId="Web-{679789CC-9D96-4E9F-9F7F-A2765F89A6A3}" dt="2026-02-25T17:39:29.284" v="132" actId="1076"/>
        <pc:sldMkLst>
          <pc:docMk/>
          <pc:sldMk cId="875138949" sldId="259"/>
        </pc:sldMkLst>
        <pc:spChg chg="add mod">
          <ac:chgData name="Yuying Liang" userId="jHfLqa0+NHnW/L3/y1HwdzoR61mtDz/AjzlijymjloY=" providerId="None" clId="Web-{679789CC-9D96-4E9F-9F7F-A2765F89A6A3}" dt="2026-02-25T17:39:29.284" v="132" actId="1076"/>
          <ac:spMkLst>
            <pc:docMk/>
            <pc:sldMk cId="875138949" sldId="259"/>
            <ac:spMk id="4" creationId="{A8692072-ECF2-A11E-0D97-451A107758B3}"/>
          </ac:spMkLst>
        </pc:spChg>
        <pc:spChg chg="mod">
          <ac:chgData name="Yuying Liang" userId="jHfLqa0+NHnW/L3/y1HwdzoR61mtDz/AjzlijymjloY=" providerId="None" clId="Web-{679789CC-9D96-4E9F-9F7F-A2765F89A6A3}" dt="2026-02-25T17:39:21.018" v="93" actId="1076"/>
          <ac:spMkLst>
            <pc:docMk/>
            <pc:sldMk cId="875138949" sldId="259"/>
            <ac:spMk id="22" creationId="{F38E496F-1F94-7499-214E-5F08E5318408}"/>
          </ac:spMkLst>
        </pc:spChg>
        <pc:spChg chg="mod">
          <ac:chgData name="Yuying Liang" userId="jHfLqa0+NHnW/L3/y1HwdzoR61mtDz/AjzlijymjloY=" providerId="None" clId="Web-{679789CC-9D96-4E9F-9F7F-A2765F89A6A3}" dt="2026-02-25T17:39:21.237" v="95" actId="1076"/>
          <ac:spMkLst>
            <pc:docMk/>
            <pc:sldMk cId="875138949" sldId="259"/>
            <ac:spMk id="29" creationId="{ECF36B3E-AD7A-B42B-ACA2-65D40784F37C}"/>
          </ac:spMkLst>
        </pc:spChg>
        <pc:spChg chg="mod">
          <ac:chgData name="Yuying Liang" userId="jHfLqa0+NHnW/L3/y1HwdzoR61mtDz/AjzlijymjloY=" providerId="None" clId="Web-{679789CC-9D96-4E9F-9F7F-A2765F89A6A3}" dt="2026-02-25T17:39:20.862" v="91" actId="1076"/>
          <ac:spMkLst>
            <pc:docMk/>
            <pc:sldMk cId="875138949" sldId="259"/>
            <ac:spMk id="40" creationId="{441C4F16-3ACA-3240-984D-895A984E4B0A}"/>
          </ac:spMkLst>
        </pc:spChg>
        <pc:spChg chg="mod">
          <ac:chgData name="Yuying Liang" userId="jHfLqa0+NHnW/L3/y1HwdzoR61mtDz/AjzlijymjloY=" providerId="None" clId="Web-{679789CC-9D96-4E9F-9F7F-A2765F89A6A3}" dt="2026-02-25T17:39:20.940" v="92" actId="1076"/>
          <ac:spMkLst>
            <pc:docMk/>
            <pc:sldMk cId="875138949" sldId="259"/>
            <ac:spMk id="42" creationId="{A46C6EBF-8DEE-A342-BE4C-65356E051D9C}"/>
          </ac:spMkLst>
        </pc:spChg>
        <pc:spChg chg="mod">
          <ac:chgData name="Yuying Liang" userId="jHfLqa0+NHnW/L3/y1HwdzoR61mtDz/AjzlijymjloY=" providerId="None" clId="Web-{679789CC-9D96-4E9F-9F7F-A2765F89A6A3}" dt="2026-02-25T17:39:21.565" v="98" actId="1076"/>
          <ac:spMkLst>
            <pc:docMk/>
            <pc:sldMk cId="875138949" sldId="259"/>
            <ac:spMk id="96" creationId="{F994ED47-47B5-034A-B6DE-7C04C011B044}"/>
          </ac:spMkLst>
        </pc:spChg>
        <pc:spChg chg="mod">
          <ac:chgData name="Yuying Liang" userId="jHfLqa0+NHnW/L3/y1HwdzoR61mtDz/AjzlijymjloY=" providerId="None" clId="Web-{679789CC-9D96-4E9F-9F7F-A2765F89A6A3}" dt="2026-02-25T17:39:21.643" v="99" actId="1076"/>
          <ac:spMkLst>
            <pc:docMk/>
            <pc:sldMk cId="875138949" sldId="259"/>
            <ac:spMk id="97" creationId="{300D12A3-C3AC-E846-8C61-7787E3D223D1}"/>
          </ac:spMkLst>
        </pc:spChg>
        <pc:spChg chg="mod">
          <ac:chgData name="Yuying Liang" userId="jHfLqa0+NHnW/L3/y1HwdzoR61mtDz/AjzlijymjloY=" providerId="None" clId="Web-{679789CC-9D96-4E9F-9F7F-A2765F89A6A3}" dt="2026-02-25T17:39:21.737" v="100" actId="1076"/>
          <ac:spMkLst>
            <pc:docMk/>
            <pc:sldMk cId="875138949" sldId="259"/>
            <ac:spMk id="98" creationId="{2AB5EF72-7F85-DE47-B276-111231832346}"/>
          </ac:spMkLst>
        </pc:spChg>
        <pc:spChg chg="mod">
          <ac:chgData name="Yuying Liang" userId="jHfLqa0+NHnW/L3/y1HwdzoR61mtDz/AjzlijymjloY=" providerId="None" clId="Web-{679789CC-9D96-4E9F-9F7F-A2765F89A6A3}" dt="2026-02-25T17:39:21.815" v="101" actId="1076"/>
          <ac:spMkLst>
            <pc:docMk/>
            <pc:sldMk cId="875138949" sldId="259"/>
            <ac:spMk id="99" creationId="{DA2F9B0A-2F66-3C41-9A91-251994B83B67}"/>
          </ac:spMkLst>
        </pc:spChg>
        <pc:spChg chg="mod">
          <ac:chgData name="Yuying Liang" userId="jHfLqa0+NHnW/L3/y1HwdzoR61mtDz/AjzlijymjloY=" providerId="None" clId="Web-{679789CC-9D96-4E9F-9F7F-A2765F89A6A3}" dt="2026-02-25T17:39:21.893" v="102" actId="1076"/>
          <ac:spMkLst>
            <pc:docMk/>
            <pc:sldMk cId="875138949" sldId="259"/>
            <ac:spMk id="100" creationId="{E5B38591-1811-7F46-AC65-0995BDE7779A}"/>
          </ac:spMkLst>
        </pc:spChg>
        <pc:spChg chg="mod">
          <ac:chgData name="Yuying Liang" userId="jHfLqa0+NHnW/L3/y1HwdzoR61mtDz/AjzlijymjloY=" providerId="None" clId="Web-{679789CC-9D96-4E9F-9F7F-A2765F89A6A3}" dt="2026-02-25T17:39:21.971" v="103" actId="1076"/>
          <ac:spMkLst>
            <pc:docMk/>
            <pc:sldMk cId="875138949" sldId="259"/>
            <ac:spMk id="101" creationId="{14404C18-6065-694D-A262-99965326972B}"/>
          </ac:spMkLst>
        </pc:spChg>
        <pc:spChg chg="mod">
          <ac:chgData name="Yuying Liang" userId="jHfLqa0+NHnW/L3/y1HwdzoR61mtDz/AjzlijymjloY=" providerId="None" clId="Web-{679789CC-9D96-4E9F-9F7F-A2765F89A6A3}" dt="2026-02-25T17:39:22.049" v="104" actId="1076"/>
          <ac:spMkLst>
            <pc:docMk/>
            <pc:sldMk cId="875138949" sldId="259"/>
            <ac:spMk id="102" creationId="{89011DF7-2993-F548-84D8-58E0376D91C8}"/>
          </ac:spMkLst>
        </pc:spChg>
        <pc:spChg chg="mod">
          <ac:chgData name="Yuying Liang" userId="jHfLqa0+NHnW/L3/y1HwdzoR61mtDz/AjzlijymjloY=" providerId="None" clId="Web-{679789CC-9D96-4E9F-9F7F-A2765F89A6A3}" dt="2026-02-25T17:39:22.112" v="105" actId="1076"/>
          <ac:spMkLst>
            <pc:docMk/>
            <pc:sldMk cId="875138949" sldId="259"/>
            <ac:spMk id="103" creationId="{BF183D8C-B32A-9B49-8A5C-A8085A5F2237}"/>
          </ac:spMkLst>
        </pc:spChg>
        <pc:spChg chg="mod">
          <ac:chgData name="Yuying Liang" userId="jHfLqa0+NHnW/L3/y1HwdzoR61mtDz/AjzlijymjloY=" providerId="None" clId="Web-{679789CC-9D96-4E9F-9F7F-A2765F89A6A3}" dt="2026-02-25T17:39:25.643" v="121" actId="1076"/>
          <ac:spMkLst>
            <pc:docMk/>
            <pc:sldMk cId="875138949" sldId="259"/>
            <ac:spMk id="169" creationId="{79C9A34F-CC31-5746-A798-69672F017B8D}"/>
          </ac:spMkLst>
        </pc:spChg>
        <pc:spChg chg="mod">
          <ac:chgData name="Yuying Liang" userId="jHfLqa0+NHnW/L3/y1HwdzoR61mtDz/AjzlijymjloY=" providerId="None" clId="Web-{679789CC-9D96-4E9F-9F7F-A2765F89A6A3}" dt="2026-02-25T17:39:25.737" v="122" actId="1076"/>
          <ac:spMkLst>
            <pc:docMk/>
            <pc:sldMk cId="875138949" sldId="259"/>
            <ac:spMk id="181" creationId="{922CCA8A-074D-6C44-93EA-FDEF765DA0F3}"/>
          </ac:spMkLst>
        </pc:spChg>
        <pc:spChg chg="mod">
          <ac:chgData name="Yuying Liang" userId="jHfLqa0+NHnW/L3/y1HwdzoR61mtDz/AjzlijymjloY=" providerId="None" clId="Web-{679789CC-9D96-4E9F-9F7F-A2765F89A6A3}" dt="2026-02-25T17:39:21.502" v="97" actId="1076"/>
          <ac:spMkLst>
            <pc:docMk/>
            <pc:sldMk cId="875138949" sldId="259"/>
            <ac:spMk id="185" creationId="{4E3BE489-08AD-EF40-B8B8-A79DDDC5434B}"/>
          </ac:spMkLst>
        </pc:spChg>
        <pc:spChg chg="mod">
          <ac:chgData name="Yuying Liang" userId="jHfLqa0+NHnW/L3/y1HwdzoR61mtDz/AjzlijymjloY=" providerId="None" clId="Web-{679789CC-9D96-4E9F-9F7F-A2765F89A6A3}" dt="2026-02-25T17:39:26.393" v="126" actId="1076"/>
          <ac:spMkLst>
            <pc:docMk/>
            <pc:sldMk cId="875138949" sldId="259"/>
            <ac:spMk id="186" creationId="{7597BED4-964F-C444-B695-FC214332FB47}"/>
          </ac:spMkLst>
        </pc:spChg>
        <pc:spChg chg="mod">
          <ac:chgData name="Yuying Liang" userId="jHfLqa0+NHnW/L3/y1HwdzoR61mtDz/AjzlijymjloY=" providerId="None" clId="Web-{679789CC-9D96-4E9F-9F7F-A2765F89A6A3}" dt="2026-02-25T17:39:25.534" v="120" actId="1076"/>
          <ac:spMkLst>
            <pc:docMk/>
            <pc:sldMk cId="875138949" sldId="259"/>
            <ac:spMk id="194" creationId="{101E9A71-B25F-C042-8CEF-183B373537B0}"/>
          </ac:spMkLst>
        </pc:spChg>
        <pc:grpChg chg="mod">
          <ac:chgData name="Yuying Liang" userId="jHfLqa0+NHnW/L3/y1HwdzoR61mtDz/AjzlijymjloY=" providerId="None" clId="Web-{679789CC-9D96-4E9F-9F7F-A2765F89A6A3}" dt="2026-02-25T17:39:21.143" v="94" actId="1076"/>
          <ac:grpSpMkLst>
            <pc:docMk/>
            <pc:sldMk cId="875138949" sldId="259"/>
            <ac:grpSpMk id="27" creationId="{46CE4354-69B0-1C1D-BF2D-D70F61AA054C}"/>
          </ac:grpSpMkLst>
        </pc:grpChg>
        <pc:grpChg chg="mod">
          <ac:chgData name="Yuying Liang" userId="jHfLqa0+NHnW/L3/y1HwdzoR61mtDz/AjzlijymjloY=" providerId="None" clId="Web-{679789CC-9D96-4E9F-9F7F-A2765F89A6A3}" dt="2026-02-25T17:39:26.112" v="124" actId="1076"/>
          <ac:grpSpMkLst>
            <pc:docMk/>
            <pc:sldMk cId="875138949" sldId="259"/>
            <ac:grpSpMk id="106" creationId="{427F5BCB-90F9-BD47-80E4-2175BC1B1251}"/>
          </ac:grpSpMkLst>
        </pc:grpChg>
        <pc:grpChg chg="mod">
          <ac:chgData name="Yuying Liang" userId="jHfLqa0+NHnW/L3/y1HwdzoR61mtDz/AjzlijymjloY=" providerId="None" clId="Web-{679789CC-9D96-4E9F-9F7F-A2765F89A6A3}" dt="2026-02-25T17:39:21.424" v="96" actId="1076"/>
          <ac:grpSpMkLst>
            <pc:docMk/>
            <pc:sldMk cId="875138949" sldId="259"/>
            <ac:grpSpMk id="112" creationId="{799A9E25-B39A-3D44-8358-2173EA335464}"/>
          </ac:grpSpMkLst>
        </pc:grpChg>
        <pc:grpChg chg="mod">
          <ac:chgData name="Yuying Liang" userId="jHfLqa0+NHnW/L3/y1HwdzoR61mtDz/AjzlijymjloY=" providerId="None" clId="Web-{679789CC-9D96-4E9F-9F7F-A2765F89A6A3}" dt="2026-02-25T17:39:26.299" v="125" actId="1076"/>
          <ac:grpSpMkLst>
            <pc:docMk/>
            <pc:sldMk cId="875138949" sldId="259"/>
            <ac:grpSpMk id="122" creationId="{032A1995-D500-E64E-A2DF-188D447CAB7C}"/>
          </ac:grpSpMkLst>
        </pc:grpChg>
        <pc:grpChg chg="mod">
          <ac:chgData name="Yuying Liang" userId="jHfLqa0+NHnW/L3/y1HwdzoR61mtDz/AjzlijymjloY=" providerId="None" clId="Web-{679789CC-9D96-4E9F-9F7F-A2765F89A6A3}" dt="2026-02-25T17:39:25.456" v="119" actId="1076"/>
          <ac:grpSpMkLst>
            <pc:docMk/>
            <pc:sldMk cId="875138949" sldId="259"/>
            <ac:grpSpMk id="133" creationId="{57A2B325-F17D-2441-9C8E-E547C5D8F84A}"/>
          </ac:grpSpMkLst>
        </pc:grpChg>
        <pc:grpChg chg="mod">
          <ac:chgData name="Yuying Liang" userId="jHfLqa0+NHnW/L3/y1HwdzoR61mtDz/AjzlijymjloY=" providerId="None" clId="Web-{679789CC-9D96-4E9F-9F7F-A2765F89A6A3}" dt="2026-02-25T17:39:25.221" v="118" actId="1076"/>
          <ac:grpSpMkLst>
            <pc:docMk/>
            <pc:sldMk cId="875138949" sldId="259"/>
            <ac:grpSpMk id="147" creationId="{87518BED-DF85-AC4A-859B-D40CFA3394E3}"/>
          </ac:grpSpMkLst>
        </pc:grpChg>
        <pc:picChg chg="mod">
          <ac:chgData name="Yuying Liang" userId="jHfLqa0+NHnW/L3/y1HwdzoR61mtDz/AjzlijymjloY=" providerId="None" clId="Web-{679789CC-9D96-4E9F-9F7F-A2765F89A6A3}" dt="2026-02-25T17:39:22.237" v="106" actId="1076"/>
          <ac:picMkLst>
            <pc:docMk/>
            <pc:sldMk cId="875138949" sldId="259"/>
            <ac:picMk id="56" creationId="{5EB17904-EAE6-2441-9463-08670B9723AC}"/>
          </ac:picMkLst>
        </pc:picChg>
        <pc:picChg chg="mod">
          <ac:chgData name="Yuying Liang" userId="jHfLqa0+NHnW/L3/y1HwdzoR61mtDz/AjzlijymjloY=" providerId="None" clId="Web-{679789CC-9D96-4E9F-9F7F-A2765F89A6A3}" dt="2026-02-25T17:39:22.362" v="107" actId="1076"/>
          <ac:picMkLst>
            <pc:docMk/>
            <pc:sldMk cId="875138949" sldId="259"/>
            <ac:picMk id="58" creationId="{EF193280-D82D-7D44-AB20-F1FC8BDB0E95}"/>
          </ac:picMkLst>
        </pc:picChg>
        <pc:picChg chg="mod">
          <ac:chgData name="Yuying Liang" userId="jHfLqa0+NHnW/L3/y1HwdzoR61mtDz/AjzlijymjloY=" providerId="None" clId="Web-{679789CC-9D96-4E9F-9F7F-A2765F89A6A3}" dt="2026-02-25T17:39:22.551" v="108" actId="1076"/>
          <ac:picMkLst>
            <pc:docMk/>
            <pc:sldMk cId="875138949" sldId="259"/>
            <ac:picMk id="60" creationId="{9FCD1F65-6684-F14C-8914-837F1117C896}"/>
          </ac:picMkLst>
        </pc:picChg>
        <pc:picChg chg="mod">
          <ac:chgData name="Yuying Liang" userId="jHfLqa0+NHnW/L3/y1HwdzoR61mtDz/AjzlijymjloY=" providerId="None" clId="Web-{679789CC-9D96-4E9F-9F7F-A2765F89A6A3}" dt="2026-02-25T17:39:22.690" v="109" actId="1076"/>
          <ac:picMkLst>
            <pc:docMk/>
            <pc:sldMk cId="875138949" sldId="259"/>
            <ac:picMk id="75" creationId="{ADC472F8-9F04-CD47-BF8D-78508E262DE2}"/>
          </ac:picMkLst>
        </pc:picChg>
        <pc:picChg chg="mod">
          <ac:chgData name="Yuying Liang" userId="jHfLqa0+NHnW/L3/y1HwdzoR61mtDz/AjzlijymjloY=" providerId="None" clId="Web-{679789CC-9D96-4E9F-9F7F-A2765F89A6A3}" dt="2026-02-25T17:39:22.830" v="110" actId="1076"/>
          <ac:picMkLst>
            <pc:docMk/>
            <pc:sldMk cId="875138949" sldId="259"/>
            <ac:picMk id="81" creationId="{076232A3-257C-5144-B7B8-FB41CAAD2F80}"/>
          </ac:picMkLst>
        </pc:picChg>
        <pc:picChg chg="mod">
          <ac:chgData name="Yuying Liang" userId="jHfLqa0+NHnW/L3/y1HwdzoR61mtDz/AjzlijymjloY=" providerId="None" clId="Web-{679789CC-9D96-4E9F-9F7F-A2765F89A6A3}" dt="2026-02-25T17:39:25.831" v="123" actId="1076"/>
          <ac:picMkLst>
            <pc:docMk/>
            <pc:sldMk cId="875138949" sldId="259"/>
            <ac:picMk id="104" creationId="{95469388-D4F9-D34A-8DBC-DB507B237595}"/>
          </ac:picMkLst>
        </pc:picChg>
        <pc:picChg chg="mod">
          <ac:chgData name="Yuying Liang" userId="jHfLqa0+NHnW/L3/y1HwdzoR61mtDz/AjzlijymjloY=" providerId="None" clId="Web-{679789CC-9D96-4E9F-9F7F-A2765F89A6A3}" dt="2026-02-25T17:39:22.971" v="111" actId="1076"/>
          <ac:picMkLst>
            <pc:docMk/>
            <pc:sldMk cId="875138949" sldId="259"/>
            <ac:picMk id="105" creationId="{505E3E85-0C9F-9F43-A7B8-7A881E112DDB}"/>
          </ac:picMkLst>
        </pc:picChg>
        <pc:picChg chg="mod">
          <ac:chgData name="Yuying Liang" userId="jHfLqa0+NHnW/L3/y1HwdzoR61mtDz/AjzlijymjloY=" providerId="None" clId="Web-{679789CC-9D96-4E9F-9F7F-A2765F89A6A3}" dt="2026-02-25T17:39:23.268" v="112" actId="1076"/>
          <ac:picMkLst>
            <pc:docMk/>
            <pc:sldMk cId="875138949" sldId="259"/>
            <ac:picMk id="107" creationId="{FEACD705-4D5B-3C4C-9E4A-B9163CD417D7}"/>
          </ac:picMkLst>
        </pc:picChg>
        <pc:picChg chg="mod">
          <ac:chgData name="Yuying Liang" userId="jHfLqa0+NHnW/L3/y1HwdzoR61mtDz/AjzlijymjloY=" providerId="None" clId="Web-{679789CC-9D96-4E9F-9F7F-A2765F89A6A3}" dt="2026-02-25T17:39:23.659" v="113" actId="1076"/>
          <ac:picMkLst>
            <pc:docMk/>
            <pc:sldMk cId="875138949" sldId="259"/>
            <ac:picMk id="109" creationId="{9005210E-DA1B-9C4B-A9FF-CE747B695E74}"/>
          </ac:picMkLst>
        </pc:picChg>
        <pc:picChg chg="mod">
          <ac:chgData name="Yuying Liang" userId="jHfLqa0+NHnW/L3/y1HwdzoR61mtDz/AjzlijymjloY=" providerId="None" clId="Web-{679789CC-9D96-4E9F-9F7F-A2765F89A6A3}" dt="2026-02-25T17:39:23.971" v="114" actId="1076"/>
          <ac:picMkLst>
            <pc:docMk/>
            <pc:sldMk cId="875138949" sldId="259"/>
            <ac:picMk id="111" creationId="{4D82EC8E-7512-914C-B130-276899281E44}"/>
          </ac:picMkLst>
        </pc:picChg>
        <pc:picChg chg="mod">
          <ac:chgData name="Yuying Liang" userId="jHfLqa0+NHnW/L3/y1HwdzoR61mtDz/AjzlijymjloY=" providerId="None" clId="Web-{679789CC-9D96-4E9F-9F7F-A2765F89A6A3}" dt="2026-02-25T17:39:24.346" v="115" actId="1076"/>
          <ac:picMkLst>
            <pc:docMk/>
            <pc:sldMk cId="875138949" sldId="259"/>
            <ac:picMk id="113" creationId="{CF23D198-0F95-F54E-8916-0D1E7D7F61E9}"/>
          </ac:picMkLst>
        </pc:picChg>
        <pc:picChg chg="mod">
          <ac:chgData name="Yuying Liang" userId="jHfLqa0+NHnW/L3/y1HwdzoR61mtDz/AjzlijymjloY=" providerId="None" clId="Web-{679789CC-9D96-4E9F-9F7F-A2765F89A6A3}" dt="2026-02-25T17:39:24.643" v="116" actId="1076"/>
          <ac:picMkLst>
            <pc:docMk/>
            <pc:sldMk cId="875138949" sldId="259"/>
            <ac:picMk id="115" creationId="{9833EF04-2CE2-C546-8B53-C34C82A41E00}"/>
          </ac:picMkLst>
        </pc:picChg>
        <pc:picChg chg="mod">
          <ac:chgData name="Yuying Liang" userId="jHfLqa0+NHnW/L3/y1HwdzoR61mtDz/AjzlijymjloY=" providerId="None" clId="Web-{679789CC-9D96-4E9F-9F7F-A2765F89A6A3}" dt="2026-02-25T17:39:25.034" v="117" actId="1076"/>
          <ac:picMkLst>
            <pc:docMk/>
            <pc:sldMk cId="875138949" sldId="259"/>
            <ac:picMk id="117" creationId="{41ACEBD4-D3C9-C14A-B71D-22D1D6F254BA}"/>
          </ac:picMkLst>
        </pc:picChg>
        <pc:picChg chg="mod">
          <ac:chgData name="Yuying Liang" userId="jHfLqa0+NHnW/L3/y1HwdzoR61mtDz/AjzlijymjloY=" providerId="None" clId="Web-{679789CC-9D96-4E9F-9F7F-A2765F89A6A3}" dt="2026-02-25T17:39:20.768" v="90" actId="1076"/>
          <ac:picMkLst>
            <pc:docMk/>
            <pc:sldMk cId="875138949" sldId="259"/>
            <ac:picMk id="152" creationId="{557B8EAE-B024-7944-AAB7-A9CB57F19126}"/>
          </ac:picMkLst>
        </pc:picChg>
      </pc:sldChg>
      <pc:sldChg chg="addSp modSp">
        <pc:chgData name="Yuying Liang" userId="jHfLqa0+NHnW/L3/y1HwdzoR61mtDz/AjzlijymjloY=" providerId="None" clId="Web-{679789CC-9D96-4E9F-9F7F-A2765F89A6A3}" dt="2026-02-25T17:39:47.958" v="173" actId="20577"/>
        <pc:sldMkLst>
          <pc:docMk/>
          <pc:sldMk cId="932640644" sldId="260"/>
        </pc:sldMkLst>
        <pc:spChg chg="mod">
          <ac:chgData name="Yuying Liang" userId="jHfLqa0+NHnW/L3/y1HwdzoR61mtDz/AjzlijymjloY=" providerId="None" clId="Web-{679789CC-9D96-4E9F-9F7F-A2765F89A6A3}" dt="2026-02-25T17:39:44.301" v="154" actId="1076"/>
          <ac:spMkLst>
            <pc:docMk/>
            <pc:sldMk cId="932640644" sldId="260"/>
            <ac:spMk id="6" creationId="{6B2DB20D-532C-3443-9B36-A57F182A61E4}"/>
          </ac:spMkLst>
        </pc:spChg>
        <pc:spChg chg="mod">
          <ac:chgData name="Yuying Liang" userId="jHfLqa0+NHnW/L3/y1HwdzoR61mtDz/AjzlijymjloY=" providerId="None" clId="Web-{679789CC-9D96-4E9F-9F7F-A2765F89A6A3}" dt="2026-02-25T17:39:44.379" v="155" actId="1076"/>
          <ac:spMkLst>
            <pc:docMk/>
            <pc:sldMk cId="932640644" sldId="260"/>
            <ac:spMk id="8" creationId="{6C835855-FB06-394B-88A1-49A482A78D68}"/>
          </ac:spMkLst>
        </pc:spChg>
        <pc:spChg chg="mod">
          <ac:chgData name="Yuying Liang" userId="jHfLqa0+NHnW/L3/y1HwdzoR61mtDz/AjzlijymjloY=" providerId="None" clId="Web-{679789CC-9D96-4E9F-9F7F-A2765F89A6A3}" dt="2026-02-25T17:39:44.457" v="156" actId="1076"/>
          <ac:spMkLst>
            <pc:docMk/>
            <pc:sldMk cId="932640644" sldId="260"/>
            <ac:spMk id="9" creationId="{1AB4A5C8-EFFE-8542-9035-8A6297872811}"/>
          </ac:spMkLst>
        </pc:spChg>
        <pc:spChg chg="mod">
          <ac:chgData name="Yuying Liang" userId="jHfLqa0+NHnW/L3/y1HwdzoR61mtDz/AjzlijymjloY=" providerId="None" clId="Web-{679789CC-9D96-4E9F-9F7F-A2765F89A6A3}" dt="2026-02-25T17:39:44.535" v="157" actId="1076"/>
          <ac:spMkLst>
            <pc:docMk/>
            <pc:sldMk cId="932640644" sldId="260"/>
            <ac:spMk id="47" creationId="{248BD467-3BBD-00C2-28F2-C985CA808909}"/>
          </ac:spMkLst>
        </pc:spChg>
        <pc:spChg chg="mod">
          <ac:chgData name="Yuying Liang" userId="jHfLqa0+NHnW/L3/y1HwdzoR61mtDz/AjzlijymjloY=" providerId="None" clId="Web-{679789CC-9D96-4E9F-9F7F-A2765F89A6A3}" dt="2026-02-25T17:39:44.739" v="159" actId="1076"/>
          <ac:spMkLst>
            <pc:docMk/>
            <pc:sldMk cId="932640644" sldId="260"/>
            <ac:spMk id="55" creationId="{22FE8BBB-5EBB-6282-1BB3-8BEFA143D1E3}"/>
          </ac:spMkLst>
        </pc:spChg>
        <pc:spChg chg="add mod">
          <ac:chgData name="Yuying Liang" userId="jHfLqa0+NHnW/L3/y1HwdzoR61mtDz/AjzlijymjloY=" providerId="None" clId="Web-{679789CC-9D96-4E9F-9F7F-A2765F89A6A3}" dt="2026-02-25T17:39:47.958" v="173" actId="20577"/>
          <ac:spMkLst>
            <pc:docMk/>
            <pc:sldMk cId="932640644" sldId="260"/>
            <ac:spMk id="61" creationId="{D8589874-FA11-EF43-6E69-4B497E217987}"/>
          </ac:spMkLst>
        </pc:spChg>
        <pc:spChg chg="mod">
          <ac:chgData name="Yuying Liang" userId="jHfLqa0+NHnW/L3/y1HwdzoR61mtDz/AjzlijymjloY=" providerId="None" clId="Web-{679789CC-9D96-4E9F-9F7F-A2765F89A6A3}" dt="2026-02-25T17:39:45.270" v="164" actId="1076"/>
          <ac:spMkLst>
            <pc:docMk/>
            <pc:sldMk cId="932640644" sldId="260"/>
            <ac:spMk id="142" creationId="{DC653761-B86D-7742-8D14-EC4A31D38A3B}"/>
          </ac:spMkLst>
        </pc:spChg>
        <pc:spChg chg="mod">
          <ac:chgData name="Yuying Liang" userId="jHfLqa0+NHnW/L3/y1HwdzoR61mtDz/AjzlijymjloY=" providerId="None" clId="Web-{679789CC-9D96-4E9F-9F7F-A2765F89A6A3}" dt="2026-02-25T17:39:45.645" v="166" actId="1076"/>
          <ac:spMkLst>
            <pc:docMk/>
            <pc:sldMk cId="932640644" sldId="260"/>
            <ac:spMk id="164" creationId="{720B8396-429B-9F4E-811B-84B6B49C72C7}"/>
          </ac:spMkLst>
        </pc:spChg>
        <pc:spChg chg="mod">
          <ac:chgData name="Yuying Liang" userId="jHfLqa0+NHnW/L3/y1HwdzoR61mtDz/AjzlijymjloY=" providerId="None" clId="Web-{679789CC-9D96-4E9F-9F7F-A2765F89A6A3}" dt="2026-02-25T17:39:45.723" v="167" actId="1076"/>
          <ac:spMkLst>
            <pc:docMk/>
            <pc:sldMk cId="932640644" sldId="260"/>
            <ac:spMk id="165" creationId="{51F6E72E-64BC-5345-B928-1A3538BC7FBA}"/>
          </ac:spMkLst>
        </pc:spChg>
        <pc:spChg chg="mod">
          <ac:chgData name="Yuying Liang" userId="jHfLqa0+NHnW/L3/y1HwdzoR61mtDz/AjzlijymjloY=" providerId="None" clId="Web-{679789CC-9D96-4E9F-9F7F-A2765F89A6A3}" dt="2026-02-25T17:39:45.145" v="162" actId="1076"/>
          <ac:spMkLst>
            <pc:docMk/>
            <pc:sldMk cId="932640644" sldId="260"/>
            <ac:spMk id="173" creationId="{69FBD148-FC02-5640-9EFD-61FF169C06F1}"/>
          </ac:spMkLst>
        </pc:spChg>
        <pc:spChg chg="mod">
          <ac:chgData name="Yuying Liang" userId="jHfLqa0+NHnW/L3/y1HwdzoR61mtDz/AjzlijymjloY=" providerId="None" clId="Web-{679789CC-9D96-4E9F-9F7F-A2765F89A6A3}" dt="2026-02-25T17:39:45.207" v="163" actId="1076"/>
          <ac:spMkLst>
            <pc:docMk/>
            <pc:sldMk cId="932640644" sldId="260"/>
            <ac:spMk id="174" creationId="{3607125D-C657-484C-8E72-99BD33BF3E84}"/>
          </ac:spMkLst>
        </pc:spChg>
        <pc:spChg chg="mod">
          <ac:chgData name="Yuying Liang" userId="jHfLqa0+NHnW/L3/y1HwdzoR61mtDz/AjzlijymjloY=" providerId="None" clId="Web-{679789CC-9D96-4E9F-9F7F-A2765F89A6A3}" dt="2026-02-25T17:39:46.301" v="170" actId="1076"/>
          <ac:spMkLst>
            <pc:docMk/>
            <pc:sldMk cId="932640644" sldId="260"/>
            <ac:spMk id="178" creationId="{193C35A8-6E34-5C4B-A145-E09DCB58F48F}"/>
          </ac:spMkLst>
        </pc:spChg>
        <pc:grpChg chg="mod">
          <ac:chgData name="Yuying Liang" userId="jHfLqa0+NHnW/L3/y1HwdzoR61mtDz/AjzlijymjloY=" providerId="None" clId="Web-{679789CC-9D96-4E9F-9F7F-A2765F89A6A3}" dt="2026-02-25T17:39:44.239" v="153" actId="1076"/>
          <ac:grpSpMkLst>
            <pc:docMk/>
            <pc:sldMk cId="932640644" sldId="260"/>
            <ac:grpSpMk id="2" creationId="{C70F5A1F-58DD-D043-9CCF-E99CC2BEA96E}"/>
          </ac:grpSpMkLst>
        </pc:grpChg>
        <pc:grpChg chg="mod">
          <ac:chgData name="Yuying Liang" userId="jHfLqa0+NHnW/L3/y1HwdzoR61mtDz/AjzlijymjloY=" providerId="None" clId="Web-{679789CC-9D96-4E9F-9F7F-A2765F89A6A3}" dt="2026-02-25T17:39:44.926" v="160" actId="1076"/>
          <ac:grpSpMkLst>
            <pc:docMk/>
            <pc:sldMk cId="932640644" sldId="260"/>
            <ac:grpSpMk id="33" creationId="{FACAE52C-06EC-AF4D-A99E-6CDA6BB15B4E}"/>
          </ac:grpSpMkLst>
        </pc:grpChg>
        <pc:grpChg chg="mod">
          <ac:chgData name="Yuying Liang" userId="jHfLqa0+NHnW/L3/y1HwdzoR61mtDz/AjzlijymjloY=" providerId="None" clId="Web-{679789CC-9D96-4E9F-9F7F-A2765F89A6A3}" dt="2026-02-25T17:39:45.567" v="165" actId="1076"/>
          <ac:grpSpMkLst>
            <pc:docMk/>
            <pc:sldMk cId="932640644" sldId="260"/>
            <ac:grpSpMk id="34" creationId="{2F5B9DAA-1731-F34B-B7E7-1E4F07F4A2D6}"/>
          </ac:grpSpMkLst>
        </pc:grpChg>
        <pc:grpChg chg="mod">
          <ac:chgData name="Yuying Liang" userId="jHfLqa0+NHnW/L3/y1HwdzoR61mtDz/AjzlijymjloY=" providerId="None" clId="Web-{679789CC-9D96-4E9F-9F7F-A2765F89A6A3}" dt="2026-02-25T17:39:44.676" v="158" actId="1076"/>
          <ac:grpSpMkLst>
            <pc:docMk/>
            <pc:sldMk cId="932640644" sldId="260"/>
            <ac:grpSpMk id="54" creationId="{C7FEA938-9A46-5EE9-4141-599CF03ADD9C}"/>
          </ac:grpSpMkLst>
        </pc:grpChg>
        <pc:grpChg chg="mod">
          <ac:chgData name="Yuying Liang" userId="jHfLqa0+NHnW/L3/y1HwdzoR61mtDz/AjzlijymjloY=" providerId="None" clId="Web-{679789CC-9D96-4E9F-9F7F-A2765F89A6A3}" dt="2026-02-25T17:39:45.911" v="168" actId="1076"/>
          <ac:grpSpMkLst>
            <pc:docMk/>
            <pc:sldMk cId="932640644" sldId="260"/>
            <ac:grpSpMk id="66" creationId="{CB3C17F3-1747-AE4D-A0FC-99F2B8C9EBF1}"/>
          </ac:grpSpMkLst>
        </pc:grpChg>
        <pc:grpChg chg="mod">
          <ac:chgData name="Yuying Liang" userId="jHfLqa0+NHnW/L3/y1HwdzoR61mtDz/AjzlijymjloY=" providerId="None" clId="Web-{679789CC-9D96-4E9F-9F7F-A2765F89A6A3}" dt="2026-02-25T17:39:46.192" v="169" actId="1076"/>
          <ac:grpSpMkLst>
            <pc:docMk/>
            <pc:sldMk cId="932640644" sldId="260"/>
            <ac:grpSpMk id="88" creationId="{2A5B72E1-F028-9245-94B9-96C98F218616}"/>
          </ac:grpSpMkLst>
        </pc:grpChg>
        <pc:grpChg chg="mod">
          <ac:chgData name="Yuying Liang" userId="jHfLqa0+NHnW/L3/y1HwdzoR61mtDz/AjzlijymjloY=" providerId="None" clId="Web-{679789CC-9D96-4E9F-9F7F-A2765F89A6A3}" dt="2026-02-25T17:39:45.082" v="161" actId="1076"/>
          <ac:grpSpMkLst>
            <pc:docMk/>
            <pc:sldMk cId="932640644" sldId="260"/>
            <ac:grpSpMk id="139" creationId="{AFC39302-490E-D74E-8D3D-11AF6065ECAB}"/>
          </ac:grpSpMkLst>
        </pc:grpChg>
        <pc:picChg chg="mod">
          <ac:chgData name="Yuying Liang" userId="jHfLqa0+NHnW/L3/y1HwdzoR61mtDz/AjzlijymjloY=" providerId="None" clId="Web-{679789CC-9D96-4E9F-9F7F-A2765F89A6A3}" dt="2026-02-25T17:39:44.067" v="152" actId="1076"/>
          <ac:picMkLst>
            <pc:docMk/>
            <pc:sldMk cId="932640644" sldId="260"/>
            <ac:picMk id="92" creationId="{53DD4602-18CE-604A-A206-2D2A267AD7A5}"/>
          </ac:picMkLst>
        </pc:picChg>
      </pc:sldChg>
      <pc:sldChg chg="addSp modSp">
        <pc:chgData name="Yuying Liang" userId="jHfLqa0+NHnW/L3/y1HwdzoR61mtDz/AjzlijymjloY=" providerId="None" clId="Web-{679789CC-9D96-4E9F-9F7F-A2765F89A6A3}" dt="2026-02-25T17:40:02.271" v="183" actId="20577"/>
        <pc:sldMkLst>
          <pc:docMk/>
          <pc:sldMk cId="3508077703" sldId="261"/>
        </pc:sldMkLst>
        <pc:spChg chg="mod">
          <ac:chgData name="Yuying Liang" userId="jHfLqa0+NHnW/L3/y1HwdzoR61mtDz/AjzlijymjloY=" providerId="None" clId="Web-{679789CC-9D96-4E9F-9F7F-A2765F89A6A3}" dt="2026-02-25T17:39:58.599" v="174" actId="1076"/>
          <ac:spMkLst>
            <pc:docMk/>
            <pc:sldMk cId="3508077703" sldId="261"/>
            <ac:spMk id="5" creationId="{116871BF-1DFE-F943-AC61-8D3531C551CF}"/>
          </ac:spMkLst>
        </pc:spChg>
        <pc:spChg chg="mod">
          <ac:chgData name="Yuying Liang" userId="jHfLqa0+NHnW/L3/y1HwdzoR61mtDz/AjzlijymjloY=" providerId="None" clId="Web-{679789CC-9D96-4E9F-9F7F-A2765F89A6A3}" dt="2026-02-25T17:39:58.630" v="175" actId="1076"/>
          <ac:spMkLst>
            <pc:docMk/>
            <pc:sldMk cId="3508077703" sldId="261"/>
            <ac:spMk id="22" creationId="{49922EFE-385A-2444-97B7-53BEFD24921D}"/>
          </ac:spMkLst>
        </pc:spChg>
        <pc:spChg chg="mod">
          <ac:chgData name="Yuying Liang" userId="jHfLqa0+NHnW/L3/y1HwdzoR61mtDz/AjzlijymjloY=" providerId="None" clId="Web-{679789CC-9D96-4E9F-9F7F-A2765F89A6A3}" dt="2026-02-25T17:39:58.662" v="176" actId="1076"/>
          <ac:spMkLst>
            <pc:docMk/>
            <pc:sldMk cId="3508077703" sldId="261"/>
            <ac:spMk id="39" creationId="{6EBD3896-5013-8528-846F-02C3A5A8C8A2}"/>
          </ac:spMkLst>
        </pc:spChg>
        <pc:spChg chg="mod">
          <ac:chgData name="Yuying Liang" userId="jHfLqa0+NHnW/L3/y1HwdzoR61mtDz/AjzlijymjloY=" providerId="None" clId="Web-{679789CC-9D96-4E9F-9F7F-A2765F89A6A3}" dt="2026-02-25T17:39:59.459" v="181" actId="1076"/>
          <ac:spMkLst>
            <pc:docMk/>
            <pc:sldMk cId="3508077703" sldId="261"/>
            <ac:spMk id="55" creationId="{CCC57E9C-513E-1241-BBB9-69E5828D4109}"/>
          </ac:spMkLst>
        </pc:spChg>
        <pc:spChg chg="add mod">
          <ac:chgData name="Yuying Liang" userId="jHfLqa0+NHnW/L3/y1HwdzoR61mtDz/AjzlijymjloY=" providerId="None" clId="Web-{679789CC-9D96-4E9F-9F7F-A2765F89A6A3}" dt="2026-02-25T17:40:02.271" v="183" actId="20577"/>
          <ac:spMkLst>
            <pc:docMk/>
            <pc:sldMk cId="3508077703" sldId="261"/>
            <ac:spMk id="57" creationId="{A06761C5-1CCC-BEAB-4B48-93734D7629B5}"/>
          </ac:spMkLst>
        </pc:spChg>
        <pc:grpChg chg="mod">
          <ac:chgData name="Yuying Liang" userId="jHfLqa0+NHnW/L3/y1HwdzoR61mtDz/AjzlijymjloY=" providerId="None" clId="Web-{679789CC-9D96-4E9F-9F7F-A2765F89A6A3}" dt="2026-02-25T17:39:59.427" v="180" actId="1076"/>
          <ac:grpSpMkLst>
            <pc:docMk/>
            <pc:sldMk cId="3508077703" sldId="261"/>
            <ac:grpSpMk id="23" creationId="{317A409D-AA65-8B4A-825F-D39241F103F9}"/>
          </ac:grpSpMkLst>
        </pc:grpChg>
        <pc:grpChg chg="mod">
          <ac:chgData name="Yuying Liang" userId="jHfLqa0+NHnW/L3/y1HwdzoR61mtDz/AjzlijymjloY=" providerId="None" clId="Web-{679789CC-9D96-4E9F-9F7F-A2765F89A6A3}" dt="2026-02-25T17:39:58.724" v="177" actId="1076"/>
          <ac:grpSpMkLst>
            <pc:docMk/>
            <pc:sldMk cId="3508077703" sldId="261"/>
            <ac:grpSpMk id="44" creationId="{318F0066-6E54-66E2-358D-962146F07C5D}"/>
          </ac:grpSpMkLst>
        </pc:grpChg>
        <pc:grpChg chg="mod">
          <ac:chgData name="Yuying Liang" userId="jHfLqa0+NHnW/L3/y1HwdzoR61mtDz/AjzlijymjloY=" providerId="None" clId="Web-{679789CC-9D96-4E9F-9F7F-A2765F89A6A3}" dt="2026-02-25T17:39:58.959" v="179" actId="1076"/>
          <ac:grpSpMkLst>
            <pc:docMk/>
            <pc:sldMk cId="3508077703" sldId="261"/>
            <ac:grpSpMk id="47" creationId="{65AB9AA2-AABE-9C46-BACD-B50517A8F1D9}"/>
          </ac:grpSpMkLst>
        </pc:grpChg>
        <pc:grpChg chg="mod">
          <ac:chgData name="Yuying Liang" userId="jHfLqa0+NHnW/L3/y1HwdzoR61mtDz/AjzlijymjloY=" providerId="None" clId="Web-{679789CC-9D96-4E9F-9F7F-A2765F89A6A3}" dt="2026-02-25T17:39:58.834" v="178" actId="1076"/>
          <ac:grpSpMkLst>
            <pc:docMk/>
            <pc:sldMk cId="3508077703" sldId="261"/>
            <ac:grpSpMk id="48" creationId="{A84B0A67-3E56-D146-B9AF-3074B84786B4}"/>
          </ac:grpSpMkLst>
        </pc:grpChg>
      </pc:sldChg>
      <pc:sldChg chg="addSp modSp">
        <pc:chgData name="Yuying Liang" userId="jHfLqa0+NHnW/L3/y1HwdzoR61mtDz/AjzlijymjloY=" providerId="None" clId="Web-{679789CC-9D96-4E9F-9F7F-A2765F89A6A3}" dt="2026-02-25T17:39:18.689" v="89" actId="20577"/>
        <pc:sldMkLst>
          <pc:docMk/>
          <pc:sldMk cId="423064511" sldId="267"/>
        </pc:sldMkLst>
        <pc:spChg chg="mod">
          <ac:chgData name="Yuying Liang" userId="jHfLqa0+NHnW/L3/y1HwdzoR61mtDz/AjzlijymjloY=" providerId="None" clId="Web-{679789CC-9D96-4E9F-9F7F-A2765F89A6A3}" dt="2026-02-25T17:39:01.110" v="2" actId="1076"/>
          <ac:spMkLst>
            <pc:docMk/>
            <pc:sldMk cId="423064511" sldId="267"/>
            <ac:spMk id="55" creationId="{EF0F235D-208D-544E-8498-B96C374ECFBC}"/>
          </ac:spMkLst>
        </pc:spChg>
        <pc:spChg chg="add mod">
          <ac:chgData name="Yuying Liang" userId="jHfLqa0+NHnW/L3/y1HwdzoR61mtDz/AjzlijymjloY=" providerId="None" clId="Web-{679789CC-9D96-4E9F-9F7F-A2765F89A6A3}" dt="2026-02-25T17:39:18.689" v="89" actId="20577"/>
          <ac:spMkLst>
            <pc:docMk/>
            <pc:sldMk cId="423064511" sldId="267"/>
            <ac:spMk id="56" creationId="{ABED0B35-5691-C0BB-9B87-50423358059C}"/>
          </ac:spMkLst>
        </pc:spChg>
        <pc:spChg chg="mod">
          <ac:chgData name="Yuying Liang" userId="jHfLqa0+NHnW/L3/y1HwdzoR61mtDz/AjzlijymjloY=" providerId="None" clId="Web-{679789CC-9D96-4E9F-9F7F-A2765F89A6A3}" dt="2026-02-25T17:39:01.266" v="3" actId="1076"/>
          <ac:spMkLst>
            <pc:docMk/>
            <pc:sldMk cId="423064511" sldId="267"/>
            <ac:spMk id="119" creationId="{7F036EC0-86DA-3646-8C9C-E7B94412D90D}"/>
          </ac:spMkLst>
        </pc:spChg>
        <pc:spChg chg="mod">
          <ac:chgData name="Yuying Liang" userId="jHfLqa0+NHnW/L3/y1HwdzoR61mtDz/AjzlijymjloY=" providerId="None" clId="Web-{679789CC-9D96-4E9F-9F7F-A2765F89A6A3}" dt="2026-02-25T17:39:04.735" v="7" actId="1076"/>
          <ac:spMkLst>
            <pc:docMk/>
            <pc:sldMk cId="423064511" sldId="267"/>
            <ac:spMk id="188" creationId="{195D6A14-763B-3149-BC08-EEE5074E0BE4}"/>
          </ac:spMkLst>
        </pc:spChg>
        <pc:spChg chg="mod">
          <ac:chgData name="Yuying Liang" userId="jHfLqa0+NHnW/L3/y1HwdzoR61mtDz/AjzlijymjloY=" providerId="None" clId="Web-{679789CC-9D96-4E9F-9F7F-A2765F89A6A3}" dt="2026-02-25T17:39:04.829" v="8" actId="1076"/>
          <ac:spMkLst>
            <pc:docMk/>
            <pc:sldMk cId="423064511" sldId="267"/>
            <ac:spMk id="189" creationId="{9C23E919-A96F-C443-ABD3-2C63FF775128}"/>
          </ac:spMkLst>
        </pc:spChg>
        <pc:spChg chg="mod">
          <ac:chgData name="Yuying Liang" userId="jHfLqa0+NHnW/L3/y1HwdzoR61mtDz/AjzlijymjloY=" providerId="None" clId="Web-{679789CC-9D96-4E9F-9F7F-A2765F89A6A3}" dt="2026-02-25T17:39:04.938" v="9" actId="1076"/>
          <ac:spMkLst>
            <pc:docMk/>
            <pc:sldMk cId="423064511" sldId="267"/>
            <ac:spMk id="190" creationId="{5FF3C505-F557-0A43-8817-885B564AC7CB}"/>
          </ac:spMkLst>
        </pc:spChg>
        <pc:spChg chg="mod">
          <ac:chgData name="Yuying Liang" userId="jHfLqa0+NHnW/L3/y1HwdzoR61mtDz/AjzlijymjloY=" providerId="None" clId="Web-{679789CC-9D96-4E9F-9F7F-A2765F89A6A3}" dt="2026-02-25T17:39:05.032" v="10" actId="1076"/>
          <ac:spMkLst>
            <pc:docMk/>
            <pc:sldMk cId="423064511" sldId="267"/>
            <ac:spMk id="191" creationId="{1F25606F-E82D-D541-9540-8F8A82E617EA}"/>
          </ac:spMkLst>
        </pc:spChg>
        <pc:spChg chg="mod">
          <ac:chgData name="Yuying Liang" userId="jHfLqa0+NHnW/L3/y1HwdzoR61mtDz/AjzlijymjloY=" providerId="None" clId="Web-{679789CC-9D96-4E9F-9F7F-A2765F89A6A3}" dt="2026-02-25T17:39:05.110" v="11" actId="1076"/>
          <ac:spMkLst>
            <pc:docMk/>
            <pc:sldMk cId="423064511" sldId="267"/>
            <ac:spMk id="192" creationId="{DE032EDC-AE41-3241-9E13-33B2127150C5}"/>
          </ac:spMkLst>
        </pc:spChg>
        <pc:spChg chg="mod">
          <ac:chgData name="Yuying Liang" userId="jHfLqa0+NHnW/L3/y1HwdzoR61mtDz/AjzlijymjloY=" providerId="None" clId="Web-{679789CC-9D96-4E9F-9F7F-A2765F89A6A3}" dt="2026-02-25T17:39:05.204" v="12" actId="1076"/>
          <ac:spMkLst>
            <pc:docMk/>
            <pc:sldMk cId="423064511" sldId="267"/>
            <ac:spMk id="193" creationId="{FFE7D41B-289D-4C46-86F7-80F15718EC96}"/>
          </ac:spMkLst>
        </pc:spChg>
        <pc:spChg chg="mod">
          <ac:chgData name="Yuying Liang" userId="jHfLqa0+NHnW/L3/y1HwdzoR61mtDz/AjzlijymjloY=" providerId="None" clId="Web-{679789CC-9D96-4E9F-9F7F-A2765F89A6A3}" dt="2026-02-25T17:39:05.282" v="13" actId="1076"/>
          <ac:spMkLst>
            <pc:docMk/>
            <pc:sldMk cId="423064511" sldId="267"/>
            <ac:spMk id="194" creationId="{89D7DF69-24AB-B145-8825-71FDB926CA9D}"/>
          </ac:spMkLst>
        </pc:spChg>
        <pc:spChg chg="mod">
          <ac:chgData name="Yuying Liang" userId="jHfLqa0+NHnW/L3/y1HwdzoR61mtDz/AjzlijymjloY=" providerId="None" clId="Web-{679789CC-9D96-4E9F-9F7F-A2765F89A6A3}" dt="2026-02-25T17:39:05.360" v="14" actId="1076"/>
          <ac:spMkLst>
            <pc:docMk/>
            <pc:sldMk cId="423064511" sldId="267"/>
            <ac:spMk id="195" creationId="{2FA7C4FB-E919-FC44-AF23-2BE32ED5F48D}"/>
          </ac:spMkLst>
        </pc:spChg>
        <pc:spChg chg="mod">
          <ac:chgData name="Yuying Liang" userId="jHfLqa0+NHnW/L3/y1HwdzoR61mtDz/AjzlijymjloY=" providerId="None" clId="Web-{679789CC-9D96-4E9F-9F7F-A2765F89A6A3}" dt="2026-02-25T17:39:05.469" v="15" actId="1076"/>
          <ac:spMkLst>
            <pc:docMk/>
            <pc:sldMk cId="423064511" sldId="267"/>
            <ac:spMk id="196" creationId="{B4B1DAFF-C098-D342-B0F2-542940A50E4D}"/>
          </ac:spMkLst>
        </pc:spChg>
        <pc:spChg chg="mod">
          <ac:chgData name="Yuying Liang" userId="jHfLqa0+NHnW/L3/y1HwdzoR61mtDz/AjzlijymjloY=" providerId="None" clId="Web-{679789CC-9D96-4E9F-9F7F-A2765F89A6A3}" dt="2026-02-25T17:39:05.594" v="16" actId="1076"/>
          <ac:spMkLst>
            <pc:docMk/>
            <pc:sldMk cId="423064511" sldId="267"/>
            <ac:spMk id="197" creationId="{D428C8F4-217B-1D4F-88DD-8C88C4EC0E42}"/>
          </ac:spMkLst>
        </pc:spChg>
        <pc:spChg chg="mod">
          <ac:chgData name="Yuying Liang" userId="jHfLqa0+NHnW/L3/y1HwdzoR61mtDz/AjzlijymjloY=" providerId="None" clId="Web-{679789CC-9D96-4E9F-9F7F-A2765F89A6A3}" dt="2026-02-25T17:39:05.688" v="17" actId="1076"/>
          <ac:spMkLst>
            <pc:docMk/>
            <pc:sldMk cId="423064511" sldId="267"/>
            <ac:spMk id="198" creationId="{22FB9C45-E78D-F74C-ACC6-F64049E66890}"/>
          </ac:spMkLst>
        </pc:spChg>
        <pc:spChg chg="mod">
          <ac:chgData name="Yuying Liang" userId="jHfLqa0+NHnW/L3/y1HwdzoR61mtDz/AjzlijymjloY=" providerId="None" clId="Web-{679789CC-9D96-4E9F-9F7F-A2765F89A6A3}" dt="2026-02-25T17:39:05.766" v="18" actId="1076"/>
          <ac:spMkLst>
            <pc:docMk/>
            <pc:sldMk cId="423064511" sldId="267"/>
            <ac:spMk id="199" creationId="{E4B6022B-E84A-374D-B424-9F972DC40B1D}"/>
          </ac:spMkLst>
        </pc:spChg>
        <pc:spChg chg="mod">
          <ac:chgData name="Yuying Liang" userId="jHfLqa0+NHnW/L3/y1HwdzoR61mtDz/AjzlijymjloY=" providerId="None" clId="Web-{679789CC-9D96-4E9F-9F7F-A2765F89A6A3}" dt="2026-02-25T17:39:05.876" v="19" actId="1076"/>
          <ac:spMkLst>
            <pc:docMk/>
            <pc:sldMk cId="423064511" sldId="267"/>
            <ac:spMk id="200" creationId="{E5E98A1B-7FBD-234B-B09F-F360357969C5}"/>
          </ac:spMkLst>
        </pc:spChg>
        <pc:spChg chg="mod">
          <ac:chgData name="Yuying Liang" userId="jHfLqa0+NHnW/L3/y1HwdzoR61mtDz/AjzlijymjloY=" providerId="None" clId="Web-{679789CC-9D96-4E9F-9F7F-A2765F89A6A3}" dt="2026-02-25T17:39:05.985" v="20" actId="1076"/>
          <ac:spMkLst>
            <pc:docMk/>
            <pc:sldMk cId="423064511" sldId="267"/>
            <ac:spMk id="201" creationId="{675B4E59-7805-7B42-B47C-841736873B7F}"/>
          </ac:spMkLst>
        </pc:spChg>
        <pc:spChg chg="mod">
          <ac:chgData name="Yuying Liang" userId="jHfLqa0+NHnW/L3/y1HwdzoR61mtDz/AjzlijymjloY=" providerId="None" clId="Web-{679789CC-9D96-4E9F-9F7F-A2765F89A6A3}" dt="2026-02-25T17:39:06.079" v="21" actId="1076"/>
          <ac:spMkLst>
            <pc:docMk/>
            <pc:sldMk cId="423064511" sldId="267"/>
            <ac:spMk id="202" creationId="{EE1444BC-80D0-D843-A44D-CC62B87798AE}"/>
          </ac:spMkLst>
        </pc:spChg>
        <pc:spChg chg="mod">
          <ac:chgData name="Yuying Liang" userId="jHfLqa0+NHnW/L3/y1HwdzoR61mtDz/AjzlijymjloY=" providerId="None" clId="Web-{679789CC-9D96-4E9F-9F7F-A2765F89A6A3}" dt="2026-02-25T17:39:06.173" v="22" actId="1076"/>
          <ac:spMkLst>
            <pc:docMk/>
            <pc:sldMk cId="423064511" sldId="267"/>
            <ac:spMk id="203" creationId="{F63D9854-72CE-3E46-99DB-5E8E3CFD0836}"/>
          </ac:spMkLst>
        </pc:spChg>
        <pc:spChg chg="mod">
          <ac:chgData name="Yuying Liang" userId="jHfLqa0+NHnW/L3/y1HwdzoR61mtDz/AjzlijymjloY=" providerId="None" clId="Web-{679789CC-9D96-4E9F-9F7F-A2765F89A6A3}" dt="2026-02-25T17:39:06.251" v="23" actId="1076"/>
          <ac:spMkLst>
            <pc:docMk/>
            <pc:sldMk cId="423064511" sldId="267"/>
            <ac:spMk id="204" creationId="{C83B747F-8F4C-3B46-97D3-E91442BAA5DA}"/>
          </ac:spMkLst>
        </pc:spChg>
        <pc:spChg chg="mod">
          <ac:chgData name="Yuying Liang" userId="jHfLqa0+NHnW/L3/y1HwdzoR61mtDz/AjzlijymjloY=" providerId="None" clId="Web-{679789CC-9D96-4E9F-9F7F-A2765F89A6A3}" dt="2026-02-25T17:39:06.329" v="24" actId="1076"/>
          <ac:spMkLst>
            <pc:docMk/>
            <pc:sldMk cId="423064511" sldId="267"/>
            <ac:spMk id="205" creationId="{F5F77A2E-C5FE-FC4E-A948-E95B05B96153}"/>
          </ac:spMkLst>
        </pc:spChg>
        <pc:spChg chg="mod">
          <ac:chgData name="Yuying Liang" userId="jHfLqa0+NHnW/L3/y1HwdzoR61mtDz/AjzlijymjloY=" providerId="None" clId="Web-{679789CC-9D96-4E9F-9F7F-A2765F89A6A3}" dt="2026-02-25T17:39:06.423" v="25" actId="1076"/>
          <ac:spMkLst>
            <pc:docMk/>
            <pc:sldMk cId="423064511" sldId="267"/>
            <ac:spMk id="206" creationId="{6061AE2B-F62C-C24E-BAF4-078447FADBE7}"/>
          </ac:spMkLst>
        </pc:spChg>
        <pc:spChg chg="mod">
          <ac:chgData name="Yuying Liang" userId="jHfLqa0+NHnW/L3/y1HwdzoR61mtDz/AjzlijymjloY=" providerId="None" clId="Web-{679789CC-9D96-4E9F-9F7F-A2765F89A6A3}" dt="2026-02-25T17:39:06.516" v="26" actId="1076"/>
          <ac:spMkLst>
            <pc:docMk/>
            <pc:sldMk cId="423064511" sldId="267"/>
            <ac:spMk id="207" creationId="{794DE8A5-954E-6C4E-867A-B2D66AEA3FD2}"/>
          </ac:spMkLst>
        </pc:spChg>
        <pc:spChg chg="mod">
          <ac:chgData name="Yuying Liang" userId="jHfLqa0+NHnW/L3/y1HwdzoR61mtDz/AjzlijymjloY=" providerId="None" clId="Web-{679789CC-9D96-4E9F-9F7F-A2765F89A6A3}" dt="2026-02-25T17:39:06.626" v="27" actId="1076"/>
          <ac:spMkLst>
            <pc:docMk/>
            <pc:sldMk cId="423064511" sldId="267"/>
            <ac:spMk id="209" creationId="{F93EE7C6-64EE-CE43-8519-E6A2DF82AACB}"/>
          </ac:spMkLst>
        </pc:spChg>
        <pc:spChg chg="mod">
          <ac:chgData name="Yuying Liang" userId="jHfLqa0+NHnW/L3/y1HwdzoR61mtDz/AjzlijymjloY=" providerId="None" clId="Web-{679789CC-9D96-4E9F-9F7F-A2765F89A6A3}" dt="2026-02-25T17:39:06.720" v="28" actId="1076"/>
          <ac:spMkLst>
            <pc:docMk/>
            <pc:sldMk cId="423064511" sldId="267"/>
            <ac:spMk id="210" creationId="{62B711D5-2FF8-7F4E-AAB2-03117E529981}"/>
          </ac:spMkLst>
        </pc:spChg>
        <pc:spChg chg="mod">
          <ac:chgData name="Yuying Liang" userId="jHfLqa0+NHnW/L3/y1HwdzoR61mtDz/AjzlijymjloY=" providerId="None" clId="Web-{679789CC-9D96-4E9F-9F7F-A2765F89A6A3}" dt="2026-02-25T17:39:06.813" v="29" actId="1076"/>
          <ac:spMkLst>
            <pc:docMk/>
            <pc:sldMk cId="423064511" sldId="267"/>
            <ac:spMk id="211" creationId="{1EF326AC-EE6B-1F41-9F52-B3BCB925A7BB}"/>
          </ac:spMkLst>
        </pc:spChg>
        <pc:spChg chg="mod">
          <ac:chgData name="Yuying Liang" userId="jHfLqa0+NHnW/L3/y1HwdzoR61mtDz/AjzlijymjloY=" providerId="None" clId="Web-{679789CC-9D96-4E9F-9F7F-A2765F89A6A3}" dt="2026-02-25T17:39:06.891" v="30" actId="1076"/>
          <ac:spMkLst>
            <pc:docMk/>
            <pc:sldMk cId="423064511" sldId="267"/>
            <ac:spMk id="212" creationId="{883016EB-CDF8-5642-8FFF-16149D84F6F1}"/>
          </ac:spMkLst>
        </pc:spChg>
        <pc:spChg chg="mod">
          <ac:chgData name="Yuying Liang" userId="jHfLqa0+NHnW/L3/y1HwdzoR61mtDz/AjzlijymjloY=" providerId="None" clId="Web-{679789CC-9D96-4E9F-9F7F-A2765F89A6A3}" dt="2026-02-25T17:39:07.001" v="31" actId="1076"/>
          <ac:spMkLst>
            <pc:docMk/>
            <pc:sldMk cId="423064511" sldId="267"/>
            <ac:spMk id="213" creationId="{1AC39964-709B-D749-A153-434CAEC11496}"/>
          </ac:spMkLst>
        </pc:spChg>
        <pc:spChg chg="mod">
          <ac:chgData name="Yuying Liang" userId="jHfLqa0+NHnW/L3/y1HwdzoR61mtDz/AjzlijymjloY=" providerId="None" clId="Web-{679789CC-9D96-4E9F-9F7F-A2765F89A6A3}" dt="2026-02-25T17:39:07.110" v="32" actId="1076"/>
          <ac:spMkLst>
            <pc:docMk/>
            <pc:sldMk cId="423064511" sldId="267"/>
            <ac:spMk id="214" creationId="{68897138-F94F-3240-B5B4-A5E369D6AAE0}"/>
          </ac:spMkLst>
        </pc:spChg>
        <pc:spChg chg="mod">
          <ac:chgData name="Yuying Liang" userId="jHfLqa0+NHnW/L3/y1HwdzoR61mtDz/AjzlijymjloY=" providerId="None" clId="Web-{679789CC-9D96-4E9F-9F7F-A2765F89A6A3}" dt="2026-02-25T17:39:07.204" v="33" actId="1076"/>
          <ac:spMkLst>
            <pc:docMk/>
            <pc:sldMk cId="423064511" sldId="267"/>
            <ac:spMk id="215" creationId="{9951BCA1-9898-954D-AAAE-79CF67C359D5}"/>
          </ac:spMkLst>
        </pc:spChg>
        <pc:spChg chg="mod">
          <ac:chgData name="Yuying Liang" userId="jHfLqa0+NHnW/L3/y1HwdzoR61mtDz/AjzlijymjloY=" providerId="None" clId="Web-{679789CC-9D96-4E9F-9F7F-A2765F89A6A3}" dt="2026-02-25T17:39:07.313" v="34" actId="1076"/>
          <ac:spMkLst>
            <pc:docMk/>
            <pc:sldMk cId="423064511" sldId="267"/>
            <ac:spMk id="216" creationId="{699F062F-25B1-524C-946E-FC922F6AA967}"/>
          </ac:spMkLst>
        </pc:spChg>
        <pc:spChg chg="mod">
          <ac:chgData name="Yuying Liang" userId="jHfLqa0+NHnW/L3/y1HwdzoR61mtDz/AjzlijymjloY=" providerId="None" clId="Web-{679789CC-9D96-4E9F-9F7F-A2765F89A6A3}" dt="2026-02-25T17:39:07.423" v="35" actId="1076"/>
          <ac:spMkLst>
            <pc:docMk/>
            <pc:sldMk cId="423064511" sldId="267"/>
            <ac:spMk id="217" creationId="{20A62992-17D3-AD43-AC65-C7F0076FD1BE}"/>
          </ac:spMkLst>
        </pc:spChg>
        <pc:spChg chg="mod">
          <ac:chgData name="Yuying Liang" userId="jHfLqa0+NHnW/L3/y1HwdzoR61mtDz/AjzlijymjloY=" providerId="None" clId="Web-{679789CC-9D96-4E9F-9F7F-A2765F89A6A3}" dt="2026-02-25T17:39:07.517" v="36" actId="1076"/>
          <ac:spMkLst>
            <pc:docMk/>
            <pc:sldMk cId="423064511" sldId="267"/>
            <ac:spMk id="218" creationId="{DEA937AB-88CD-8C4E-A6D2-7EBF35C2654C}"/>
          </ac:spMkLst>
        </pc:spChg>
        <pc:spChg chg="mod">
          <ac:chgData name="Yuying Liang" userId="jHfLqa0+NHnW/L3/y1HwdzoR61mtDz/AjzlijymjloY=" providerId="None" clId="Web-{679789CC-9D96-4E9F-9F7F-A2765F89A6A3}" dt="2026-02-25T17:39:07.626" v="37" actId="1076"/>
          <ac:spMkLst>
            <pc:docMk/>
            <pc:sldMk cId="423064511" sldId="267"/>
            <ac:spMk id="219" creationId="{82A0A384-916E-C44B-B9C6-60E23670DC52}"/>
          </ac:spMkLst>
        </pc:spChg>
        <pc:spChg chg="mod">
          <ac:chgData name="Yuying Liang" userId="jHfLqa0+NHnW/L3/y1HwdzoR61mtDz/AjzlijymjloY=" providerId="None" clId="Web-{679789CC-9D96-4E9F-9F7F-A2765F89A6A3}" dt="2026-02-25T17:39:07.735" v="38" actId="1076"/>
          <ac:spMkLst>
            <pc:docMk/>
            <pc:sldMk cId="423064511" sldId="267"/>
            <ac:spMk id="220" creationId="{FB5DC02D-F262-CE4E-BE52-FA37581B16F0}"/>
          </ac:spMkLst>
        </pc:spChg>
        <pc:spChg chg="mod">
          <ac:chgData name="Yuying Liang" userId="jHfLqa0+NHnW/L3/y1HwdzoR61mtDz/AjzlijymjloY=" providerId="None" clId="Web-{679789CC-9D96-4E9F-9F7F-A2765F89A6A3}" dt="2026-02-25T17:39:07.829" v="39" actId="1076"/>
          <ac:spMkLst>
            <pc:docMk/>
            <pc:sldMk cId="423064511" sldId="267"/>
            <ac:spMk id="221" creationId="{E61C830E-E092-8D44-881C-27DE667930E1}"/>
          </ac:spMkLst>
        </pc:spChg>
        <pc:spChg chg="mod">
          <ac:chgData name="Yuying Liang" userId="jHfLqa0+NHnW/L3/y1HwdzoR61mtDz/AjzlijymjloY=" providerId="None" clId="Web-{679789CC-9D96-4E9F-9F7F-A2765F89A6A3}" dt="2026-02-25T17:39:07.923" v="40" actId="1076"/>
          <ac:spMkLst>
            <pc:docMk/>
            <pc:sldMk cId="423064511" sldId="267"/>
            <ac:spMk id="222" creationId="{05FD87E7-F860-7D4B-BA06-51DC085520E0}"/>
          </ac:spMkLst>
        </pc:spChg>
        <pc:spChg chg="mod">
          <ac:chgData name="Yuying Liang" userId="jHfLqa0+NHnW/L3/y1HwdzoR61mtDz/AjzlijymjloY=" providerId="None" clId="Web-{679789CC-9D96-4E9F-9F7F-A2765F89A6A3}" dt="2026-02-25T17:39:08.079" v="41" actId="1076"/>
          <ac:spMkLst>
            <pc:docMk/>
            <pc:sldMk cId="423064511" sldId="267"/>
            <ac:spMk id="223" creationId="{D1753135-B85F-CD42-AD69-EC4277B806E3}"/>
          </ac:spMkLst>
        </pc:spChg>
        <pc:spChg chg="mod">
          <ac:chgData name="Yuying Liang" userId="jHfLqa0+NHnW/L3/y1HwdzoR61mtDz/AjzlijymjloY=" providerId="None" clId="Web-{679789CC-9D96-4E9F-9F7F-A2765F89A6A3}" dt="2026-02-25T17:39:08.220" v="42" actId="1076"/>
          <ac:spMkLst>
            <pc:docMk/>
            <pc:sldMk cId="423064511" sldId="267"/>
            <ac:spMk id="224" creationId="{43EB3A12-8E86-2E4E-961E-64146EB4C086}"/>
          </ac:spMkLst>
        </pc:spChg>
        <pc:spChg chg="mod">
          <ac:chgData name="Yuying Liang" userId="jHfLqa0+NHnW/L3/y1HwdzoR61mtDz/AjzlijymjloY=" providerId="None" clId="Web-{679789CC-9D96-4E9F-9F7F-A2765F89A6A3}" dt="2026-02-25T17:39:08.329" v="43" actId="1076"/>
          <ac:spMkLst>
            <pc:docMk/>
            <pc:sldMk cId="423064511" sldId="267"/>
            <ac:spMk id="225" creationId="{A87BC658-59FE-8A4A-A228-FDDF94EE0602}"/>
          </ac:spMkLst>
        </pc:spChg>
        <pc:spChg chg="mod">
          <ac:chgData name="Yuying Liang" userId="jHfLqa0+NHnW/L3/y1HwdzoR61mtDz/AjzlijymjloY=" providerId="None" clId="Web-{679789CC-9D96-4E9F-9F7F-A2765F89A6A3}" dt="2026-02-25T17:39:08.423" v="44" actId="1076"/>
          <ac:spMkLst>
            <pc:docMk/>
            <pc:sldMk cId="423064511" sldId="267"/>
            <ac:spMk id="226" creationId="{E9560AC4-544B-E14B-BEAF-AC8A8C269A9F}"/>
          </ac:spMkLst>
        </pc:spChg>
        <pc:spChg chg="mod">
          <ac:chgData name="Yuying Liang" userId="jHfLqa0+NHnW/L3/y1HwdzoR61mtDz/AjzlijymjloY=" providerId="None" clId="Web-{679789CC-9D96-4E9F-9F7F-A2765F89A6A3}" dt="2026-02-25T17:39:08.548" v="45" actId="1076"/>
          <ac:spMkLst>
            <pc:docMk/>
            <pc:sldMk cId="423064511" sldId="267"/>
            <ac:spMk id="227" creationId="{238BB6CA-3CE3-AF4B-B886-3E03BFD6187E}"/>
          </ac:spMkLst>
        </pc:spChg>
        <pc:spChg chg="mod">
          <ac:chgData name="Yuying Liang" userId="jHfLqa0+NHnW/L3/y1HwdzoR61mtDz/AjzlijymjloY=" providerId="None" clId="Web-{679789CC-9D96-4E9F-9F7F-A2765F89A6A3}" dt="2026-02-25T17:39:08.658" v="46" actId="1076"/>
          <ac:spMkLst>
            <pc:docMk/>
            <pc:sldMk cId="423064511" sldId="267"/>
            <ac:spMk id="228" creationId="{49BE6E4A-2F09-AF45-BA42-8295D1C9950F}"/>
          </ac:spMkLst>
        </pc:spChg>
        <pc:spChg chg="mod">
          <ac:chgData name="Yuying Liang" userId="jHfLqa0+NHnW/L3/y1HwdzoR61mtDz/AjzlijymjloY=" providerId="None" clId="Web-{679789CC-9D96-4E9F-9F7F-A2765F89A6A3}" dt="2026-02-25T17:39:08.751" v="47" actId="1076"/>
          <ac:spMkLst>
            <pc:docMk/>
            <pc:sldMk cId="423064511" sldId="267"/>
            <ac:spMk id="229" creationId="{C4694894-DE19-2241-92D2-53C12378BE04}"/>
          </ac:spMkLst>
        </pc:spChg>
        <pc:spChg chg="mod">
          <ac:chgData name="Yuying Liang" userId="jHfLqa0+NHnW/L3/y1HwdzoR61mtDz/AjzlijymjloY=" providerId="None" clId="Web-{679789CC-9D96-4E9F-9F7F-A2765F89A6A3}" dt="2026-02-25T17:39:08.845" v="48" actId="1076"/>
          <ac:spMkLst>
            <pc:docMk/>
            <pc:sldMk cId="423064511" sldId="267"/>
            <ac:spMk id="230" creationId="{79A14033-CC44-5C40-840C-A7667A0801C3}"/>
          </ac:spMkLst>
        </pc:spChg>
        <pc:spChg chg="mod">
          <ac:chgData name="Yuying Liang" userId="jHfLqa0+NHnW/L3/y1HwdzoR61mtDz/AjzlijymjloY=" providerId="None" clId="Web-{679789CC-9D96-4E9F-9F7F-A2765F89A6A3}" dt="2026-02-25T17:39:08.939" v="49" actId="1076"/>
          <ac:spMkLst>
            <pc:docMk/>
            <pc:sldMk cId="423064511" sldId="267"/>
            <ac:spMk id="234" creationId="{40D379EE-9E6B-414C-A4A4-E5AE024BE0DE}"/>
          </ac:spMkLst>
        </pc:spChg>
        <pc:spChg chg="mod">
          <ac:chgData name="Yuying Liang" userId="jHfLqa0+NHnW/L3/y1HwdzoR61mtDz/AjzlijymjloY=" providerId="None" clId="Web-{679789CC-9D96-4E9F-9F7F-A2765F89A6A3}" dt="2026-02-25T17:39:09.032" v="50" actId="1076"/>
          <ac:spMkLst>
            <pc:docMk/>
            <pc:sldMk cId="423064511" sldId="267"/>
            <ac:spMk id="235" creationId="{98F91732-31A3-C947-8B25-16BB79228514}"/>
          </ac:spMkLst>
        </pc:spChg>
        <pc:spChg chg="mod">
          <ac:chgData name="Yuying Liang" userId="jHfLqa0+NHnW/L3/y1HwdzoR61mtDz/AjzlijymjloY=" providerId="None" clId="Web-{679789CC-9D96-4E9F-9F7F-A2765F89A6A3}" dt="2026-02-25T17:39:09.142" v="51" actId="1076"/>
          <ac:spMkLst>
            <pc:docMk/>
            <pc:sldMk cId="423064511" sldId="267"/>
            <ac:spMk id="236" creationId="{3D584002-E0B6-154E-BE8B-6894BFD9E684}"/>
          </ac:spMkLst>
        </pc:spChg>
        <pc:spChg chg="mod">
          <ac:chgData name="Yuying Liang" userId="jHfLqa0+NHnW/L3/y1HwdzoR61mtDz/AjzlijymjloY=" providerId="None" clId="Web-{679789CC-9D96-4E9F-9F7F-A2765F89A6A3}" dt="2026-02-25T17:39:09.235" v="52" actId="1076"/>
          <ac:spMkLst>
            <pc:docMk/>
            <pc:sldMk cId="423064511" sldId="267"/>
            <ac:spMk id="237" creationId="{1D6D664F-15D4-FD4F-91E1-236D70938E4C}"/>
          </ac:spMkLst>
        </pc:spChg>
        <pc:spChg chg="mod">
          <ac:chgData name="Yuying Liang" userId="jHfLqa0+NHnW/L3/y1HwdzoR61mtDz/AjzlijymjloY=" providerId="None" clId="Web-{679789CC-9D96-4E9F-9F7F-A2765F89A6A3}" dt="2026-02-25T17:39:09.329" v="53" actId="1076"/>
          <ac:spMkLst>
            <pc:docMk/>
            <pc:sldMk cId="423064511" sldId="267"/>
            <ac:spMk id="238" creationId="{370383B7-DEB6-754E-9460-2A48B59023B2}"/>
          </ac:spMkLst>
        </pc:spChg>
        <pc:spChg chg="mod">
          <ac:chgData name="Yuying Liang" userId="jHfLqa0+NHnW/L3/y1HwdzoR61mtDz/AjzlijymjloY=" providerId="None" clId="Web-{679789CC-9D96-4E9F-9F7F-A2765F89A6A3}" dt="2026-02-25T17:39:09.423" v="54" actId="1076"/>
          <ac:spMkLst>
            <pc:docMk/>
            <pc:sldMk cId="423064511" sldId="267"/>
            <ac:spMk id="239" creationId="{DA113AE6-312B-4348-8517-693F4A561AB0}"/>
          </ac:spMkLst>
        </pc:spChg>
        <pc:spChg chg="mod">
          <ac:chgData name="Yuying Liang" userId="jHfLqa0+NHnW/L3/y1HwdzoR61mtDz/AjzlijymjloY=" providerId="None" clId="Web-{679789CC-9D96-4E9F-9F7F-A2765F89A6A3}" dt="2026-02-25T17:39:09.501" v="55" actId="1076"/>
          <ac:spMkLst>
            <pc:docMk/>
            <pc:sldMk cId="423064511" sldId="267"/>
            <ac:spMk id="240" creationId="{105C48AB-48A7-4949-A984-00DD15156468}"/>
          </ac:spMkLst>
        </pc:spChg>
        <pc:spChg chg="mod">
          <ac:chgData name="Yuying Liang" userId="jHfLqa0+NHnW/L3/y1HwdzoR61mtDz/AjzlijymjloY=" providerId="None" clId="Web-{679789CC-9D96-4E9F-9F7F-A2765F89A6A3}" dt="2026-02-25T17:39:09.626" v="56" actId="1076"/>
          <ac:spMkLst>
            <pc:docMk/>
            <pc:sldMk cId="423064511" sldId="267"/>
            <ac:spMk id="241" creationId="{46872EBD-FA97-9949-AB14-796BA68FED49}"/>
          </ac:spMkLst>
        </pc:spChg>
        <pc:spChg chg="mod">
          <ac:chgData name="Yuying Liang" userId="jHfLqa0+NHnW/L3/y1HwdzoR61mtDz/AjzlijymjloY=" providerId="None" clId="Web-{679789CC-9D96-4E9F-9F7F-A2765F89A6A3}" dt="2026-02-25T17:39:09.721" v="57" actId="1076"/>
          <ac:spMkLst>
            <pc:docMk/>
            <pc:sldMk cId="423064511" sldId="267"/>
            <ac:spMk id="242" creationId="{CAC45503-D23B-274D-87EE-ADB21EC6BCB4}"/>
          </ac:spMkLst>
        </pc:spChg>
        <pc:spChg chg="mod">
          <ac:chgData name="Yuying Liang" userId="jHfLqa0+NHnW/L3/y1HwdzoR61mtDz/AjzlijymjloY=" providerId="None" clId="Web-{679789CC-9D96-4E9F-9F7F-A2765F89A6A3}" dt="2026-02-25T17:39:09.860" v="58" actId="1076"/>
          <ac:spMkLst>
            <pc:docMk/>
            <pc:sldMk cId="423064511" sldId="267"/>
            <ac:spMk id="243" creationId="{3C0BC64F-B68E-2C47-B9F9-28D020A8ABE4}"/>
          </ac:spMkLst>
        </pc:spChg>
        <pc:spChg chg="mod">
          <ac:chgData name="Yuying Liang" userId="jHfLqa0+NHnW/L3/y1HwdzoR61mtDz/AjzlijymjloY=" providerId="None" clId="Web-{679789CC-9D96-4E9F-9F7F-A2765F89A6A3}" dt="2026-02-25T17:39:09.970" v="59" actId="1076"/>
          <ac:spMkLst>
            <pc:docMk/>
            <pc:sldMk cId="423064511" sldId="267"/>
            <ac:spMk id="244" creationId="{443B7DD1-251F-464E-843E-B4C938FC2DFA}"/>
          </ac:spMkLst>
        </pc:spChg>
        <pc:spChg chg="mod">
          <ac:chgData name="Yuying Liang" userId="jHfLqa0+NHnW/L3/y1HwdzoR61mtDz/AjzlijymjloY=" providerId="None" clId="Web-{679789CC-9D96-4E9F-9F7F-A2765F89A6A3}" dt="2026-02-25T17:39:10.095" v="60" actId="1076"/>
          <ac:spMkLst>
            <pc:docMk/>
            <pc:sldMk cId="423064511" sldId="267"/>
            <ac:spMk id="245" creationId="{FC8E1BDA-9D1E-9348-9F2B-2578B6117029}"/>
          </ac:spMkLst>
        </pc:spChg>
        <pc:spChg chg="mod">
          <ac:chgData name="Yuying Liang" userId="jHfLqa0+NHnW/L3/y1HwdzoR61mtDz/AjzlijymjloY=" providerId="None" clId="Web-{679789CC-9D96-4E9F-9F7F-A2765F89A6A3}" dt="2026-02-25T17:39:10.189" v="61" actId="1076"/>
          <ac:spMkLst>
            <pc:docMk/>
            <pc:sldMk cId="423064511" sldId="267"/>
            <ac:spMk id="246" creationId="{F9448975-35D6-8E45-B27D-42D3BAE99291}"/>
          </ac:spMkLst>
        </pc:spChg>
        <pc:spChg chg="mod">
          <ac:chgData name="Yuying Liang" userId="jHfLqa0+NHnW/L3/y1HwdzoR61mtDz/AjzlijymjloY=" providerId="None" clId="Web-{679789CC-9D96-4E9F-9F7F-A2765F89A6A3}" dt="2026-02-25T17:39:10.282" v="62" actId="1076"/>
          <ac:spMkLst>
            <pc:docMk/>
            <pc:sldMk cId="423064511" sldId="267"/>
            <ac:spMk id="247" creationId="{4DF947CA-08D7-1B46-97A1-AC02A7FB7D10}"/>
          </ac:spMkLst>
        </pc:spChg>
        <pc:spChg chg="mod">
          <ac:chgData name="Yuying Liang" userId="jHfLqa0+NHnW/L3/y1HwdzoR61mtDz/AjzlijymjloY=" providerId="None" clId="Web-{679789CC-9D96-4E9F-9F7F-A2765F89A6A3}" dt="2026-02-25T17:39:10.376" v="63" actId="1076"/>
          <ac:spMkLst>
            <pc:docMk/>
            <pc:sldMk cId="423064511" sldId="267"/>
            <ac:spMk id="248" creationId="{CF01DF0A-943A-F043-A3DC-4E809DD0B182}"/>
          </ac:spMkLst>
        </pc:spChg>
        <pc:spChg chg="mod">
          <ac:chgData name="Yuying Liang" userId="jHfLqa0+NHnW/L3/y1HwdzoR61mtDz/AjzlijymjloY=" providerId="None" clId="Web-{679789CC-9D96-4E9F-9F7F-A2765F89A6A3}" dt="2026-02-25T17:39:10.470" v="64" actId="1076"/>
          <ac:spMkLst>
            <pc:docMk/>
            <pc:sldMk cId="423064511" sldId="267"/>
            <ac:spMk id="249" creationId="{52E79F25-29C1-E34F-99AB-7BF9F66FF1DE}"/>
          </ac:spMkLst>
        </pc:spChg>
        <pc:spChg chg="mod">
          <ac:chgData name="Yuying Liang" userId="jHfLqa0+NHnW/L3/y1HwdzoR61mtDz/AjzlijymjloY=" providerId="None" clId="Web-{679789CC-9D96-4E9F-9F7F-A2765F89A6A3}" dt="2026-02-25T17:39:10.564" v="65" actId="1076"/>
          <ac:spMkLst>
            <pc:docMk/>
            <pc:sldMk cId="423064511" sldId="267"/>
            <ac:spMk id="250" creationId="{E7DAEE8F-ED64-2A48-8132-B33FF3DB6322}"/>
          </ac:spMkLst>
        </pc:spChg>
        <pc:spChg chg="mod">
          <ac:chgData name="Yuying Liang" userId="jHfLqa0+NHnW/L3/y1HwdzoR61mtDz/AjzlijymjloY=" providerId="None" clId="Web-{679789CC-9D96-4E9F-9F7F-A2765F89A6A3}" dt="2026-02-25T17:39:10.689" v="66" actId="1076"/>
          <ac:spMkLst>
            <pc:docMk/>
            <pc:sldMk cId="423064511" sldId="267"/>
            <ac:spMk id="251" creationId="{00AAFE26-E9C5-D44B-89E8-81BBE9C081B3}"/>
          </ac:spMkLst>
        </pc:spChg>
        <pc:spChg chg="mod">
          <ac:chgData name="Yuying Liang" userId="jHfLqa0+NHnW/L3/y1HwdzoR61mtDz/AjzlijymjloY=" providerId="None" clId="Web-{679789CC-9D96-4E9F-9F7F-A2765F89A6A3}" dt="2026-02-25T17:39:10.829" v="67" actId="1076"/>
          <ac:spMkLst>
            <pc:docMk/>
            <pc:sldMk cId="423064511" sldId="267"/>
            <ac:spMk id="252" creationId="{E7352F3C-08DD-FB4D-A03D-9E7D76872887}"/>
          </ac:spMkLst>
        </pc:spChg>
        <pc:spChg chg="mod">
          <ac:chgData name="Yuying Liang" userId="jHfLqa0+NHnW/L3/y1HwdzoR61mtDz/AjzlijymjloY=" providerId="None" clId="Web-{679789CC-9D96-4E9F-9F7F-A2765F89A6A3}" dt="2026-02-25T17:39:10.954" v="68" actId="1076"/>
          <ac:spMkLst>
            <pc:docMk/>
            <pc:sldMk cId="423064511" sldId="267"/>
            <ac:spMk id="253" creationId="{BD7FDC88-FD57-1647-942C-761BBE70D4A8}"/>
          </ac:spMkLst>
        </pc:spChg>
        <pc:spChg chg="mod">
          <ac:chgData name="Yuying Liang" userId="jHfLqa0+NHnW/L3/y1HwdzoR61mtDz/AjzlijymjloY=" providerId="None" clId="Web-{679789CC-9D96-4E9F-9F7F-A2765F89A6A3}" dt="2026-02-25T17:39:11.079" v="69" actId="1076"/>
          <ac:spMkLst>
            <pc:docMk/>
            <pc:sldMk cId="423064511" sldId="267"/>
            <ac:spMk id="254" creationId="{83E5C181-A77C-F544-A9FD-7C742A8DE4A2}"/>
          </ac:spMkLst>
        </pc:spChg>
        <pc:spChg chg="mod">
          <ac:chgData name="Yuying Liang" userId="jHfLqa0+NHnW/L3/y1HwdzoR61mtDz/AjzlijymjloY=" providerId="None" clId="Web-{679789CC-9D96-4E9F-9F7F-A2765F89A6A3}" dt="2026-02-25T17:39:11.220" v="70" actId="1076"/>
          <ac:spMkLst>
            <pc:docMk/>
            <pc:sldMk cId="423064511" sldId="267"/>
            <ac:spMk id="255" creationId="{8A4DBC14-A247-9341-BE11-245C1A54CFB1}"/>
          </ac:spMkLst>
        </pc:spChg>
        <pc:spChg chg="mod">
          <ac:chgData name="Yuying Liang" userId="jHfLqa0+NHnW/L3/y1HwdzoR61mtDz/AjzlijymjloY=" providerId="None" clId="Web-{679789CC-9D96-4E9F-9F7F-A2765F89A6A3}" dt="2026-02-25T17:39:11.407" v="71" actId="1076"/>
          <ac:spMkLst>
            <pc:docMk/>
            <pc:sldMk cId="423064511" sldId="267"/>
            <ac:spMk id="256" creationId="{6F15B922-B05D-4546-A945-93E199BE917D}"/>
          </ac:spMkLst>
        </pc:spChg>
        <pc:spChg chg="mod">
          <ac:chgData name="Yuying Liang" userId="jHfLqa0+NHnW/L3/y1HwdzoR61mtDz/AjzlijymjloY=" providerId="None" clId="Web-{679789CC-9D96-4E9F-9F7F-A2765F89A6A3}" dt="2026-02-25T17:39:11.533" v="72" actId="1076"/>
          <ac:spMkLst>
            <pc:docMk/>
            <pc:sldMk cId="423064511" sldId="267"/>
            <ac:spMk id="257" creationId="{C94D9FC5-F6F3-C14A-87F4-FE5C4B8EF48B}"/>
          </ac:spMkLst>
        </pc:spChg>
        <pc:spChg chg="mod">
          <ac:chgData name="Yuying Liang" userId="jHfLqa0+NHnW/L3/y1HwdzoR61mtDz/AjzlijymjloY=" providerId="None" clId="Web-{679789CC-9D96-4E9F-9F7F-A2765F89A6A3}" dt="2026-02-25T17:39:11.689" v="73" actId="1076"/>
          <ac:spMkLst>
            <pc:docMk/>
            <pc:sldMk cId="423064511" sldId="267"/>
            <ac:spMk id="258" creationId="{3D77D185-A792-264C-8C45-826476C69517}"/>
          </ac:spMkLst>
        </pc:spChg>
        <pc:spChg chg="mod">
          <ac:chgData name="Yuying Liang" userId="jHfLqa0+NHnW/L3/y1HwdzoR61mtDz/AjzlijymjloY=" providerId="None" clId="Web-{679789CC-9D96-4E9F-9F7F-A2765F89A6A3}" dt="2026-02-25T17:39:11.829" v="74" actId="1076"/>
          <ac:spMkLst>
            <pc:docMk/>
            <pc:sldMk cId="423064511" sldId="267"/>
            <ac:spMk id="259" creationId="{B7DCC04F-393B-F34F-A422-D838A429936F}"/>
          </ac:spMkLst>
        </pc:spChg>
        <pc:spChg chg="mod">
          <ac:chgData name="Yuying Liang" userId="jHfLqa0+NHnW/L3/y1HwdzoR61mtDz/AjzlijymjloY=" providerId="None" clId="Web-{679789CC-9D96-4E9F-9F7F-A2765F89A6A3}" dt="2026-02-25T17:39:11.954" v="75" actId="1076"/>
          <ac:spMkLst>
            <pc:docMk/>
            <pc:sldMk cId="423064511" sldId="267"/>
            <ac:spMk id="260" creationId="{BF6EA7E8-90F2-F048-A489-385AC16DE3BC}"/>
          </ac:spMkLst>
        </pc:spChg>
        <pc:spChg chg="mod">
          <ac:chgData name="Yuying Liang" userId="jHfLqa0+NHnW/L3/y1HwdzoR61mtDz/AjzlijymjloY=" providerId="None" clId="Web-{679789CC-9D96-4E9F-9F7F-A2765F89A6A3}" dt="2026-02-25T17:39:12.079" v="76" actId="1076"/>
          <ac:spMkLst>
            <pc:docMk/>
            <pc:sldMk cId="423064511" sldId="267"/>
            <ac:spMk id="261" creationId="{B81E041E-4821-2F41-91F3-527D7A97E416}"/>
          </ac:spMkLst>
        </pc:spChg>
        <pc:spChg chg="mod">
          <ac:chgData name="Yuying Liang" userId="jHfLqa0+NHnW/L3/y1HwdzoR61mtDz/AjzlijymjloY=" providerId="None" clId="Web-{679789CC-9D96-4E9F-9F7F-A2765F89A6A3}" dt="2026-02-25T17:39:12.204" v="77" actId="1076"/>
          <ac:spMkLst>
            <pc:docMk/>
            <pc:sldMk cId="423064511" sldId="267"/>
            <ac:spMk id="262" creationId="{94C25DE7-A60B-4747-BFFD-070D64AA78E4}"/>
          </ac:spMkLst>
        </pc:spChg>
        <pc:spChg chg="mod">
          <ac:chgData name="Yuying Liang" userId="jHfLqa0+NHnW/L3/y1HwdzoR61mtDz/AjzlijymjloY=" providerId="None" clId="Web-{679789CC-9D96-4E9F-9F7F-A2765F89A6A3}" dt="2026-02-25T17:39:12.329" v="78" actId="1076"/>
          <ac:spMkLst>
            <pc:docMk/>
            <pc:sldMk cId="423064511" sldId="267"/>
            <ac:spMk id="263" creationId="{08D28CAB-8AEE-9C4F-9D58-934F0BF2C467}"/>
          </ac:spMkLst>
        </pc:spChg>
        <pc:spChg chg="mod">
          <ac:chgData name="Yuying Liang" userId="jHfLqa0+NHnW/L3/y1HwdzoR61mtDz/AjzlijymjloY=" providerId="None" clId="Web-{679789CC-9D96-4E9F-9F7F-A2765F89A6A3}" dt="2026-02-25T17:39:12.439" v="79" actId="1076"/>
          <ac:spMkLst>
            <pc:docMk/>
            <pc:sldMk cId="423064511" sldId="267"/>
            <ac:spMk id="264" creationId="{13F23D97-0E63-A042-87FD-545883DA9EE3}"/>
          </ac:spMkLst>
        </pc:spChg>
        <pc:spChg chg="mod">
          <ac:chgData name="Yuying Liang" userId="jHfLqa0+NHnW/L3/y1HwdzoR61mtDz/AjzlijymjloY=" providerId="None" clId="Web-{679789CC-9D96-4E9F-9F7F-A2765F89A6A3}" dt="2026-02-25T17:39:12.548" v="80" actId="1076"/>
          <ac:spMkLst>
            <pc:docMk/>
            <pc:sldMk cId="423064511" sldId="267"/>
            <ac:spMk id="265" creationId="{B8183262-EA9E-9348-A3D4-E4900CED9D32}"/>
          </ac:spMkLst>
        </pc:spChg>
        <pc:spChg chg="mod">
          <ac:chgData name="Yuying Liang" userId="jHfLqa0+NHnW/L3/y1HwdzoR61mtDz/AjzlijymjloY=" providerId="None" clId="Web-{679789CC-9D96-4E9F-9F7F-A2765F89A6A3}" dt="2026-02-25T17:39:12.673" v="81" actId="1076"/>
          <ac:spMkLst>
            <pc:docMk/>
            <pc:sldMk cId="423064511" sldId="267"/>
            <ac:spMk id="266" creationId="{B1B4A465-57C2-BE46-B421-C35CFD6F3A84}"/>
          </ac:spMkLst>
        </pc:spChg>
        <pc:spChg chg="mod">
          <ac:chgData name="Yuying Liang" userId="jHfLqa0+NHnW/L3/y1HwdzoR61mtDz/AjzlijymjloY=" providerId="None" clId="Web-{679789CC-9D96-4E9F-9F7F-A2765F89A6A3}" dt="2026-02-25T17:39:12.798" v="82" actId="1076"/>
          <ac:spMkLst>
            <pc:docMk/>
            <pc:sldMk cId="423064511" sldId="267"/>
            <ac:spMk id="267" creationId="{71F9DDF3-8D6F-E341-88F4-82FFDA489F52}"/>
          </ac:spMkLst>
        </pc:spChg>
        <pc:spChg chg="mod">
          <ac:chgData name="Yuying Liang" userId="jHfLqa0+NHnW/L3/y1HwdzoR61mtDz/AjzlijymjloY=" providerId="None" clId="Web-{679789CC-9D96-4E9F-9F7F-A2765F89A6A3}" dt="2026-02-25T17:39:12.892" v="83" actId="1076"/>
          <ac:spMkLst>
            <pc:docMk/>
            <pc:sldMk cId="423064511" sldId="267"/>
            <ac:spMk id="268" creationId="{1EA542F3-5AE9-CA40-96C1-3223F4B5E89E}"/>
          </ac:spMkLst>
        </pc:spChg>
        <pc:spChg chg="mod">
          <ac:chgData name="Yuying Liang" userId="jHfLqa0+NHnW/L3/y1HwdzoR61mtDz/AjzlijymjloY=" providerId="None" clId="Web-{679789CC-9D96-4E9F-9F7F-A2765F89A6A3}" dt="2026-02-25T17:39:13.017" v="84" actId="1076"/>
          <ac:spMkLst>
            <pc:docMk/>
            <pc:sldMk cId="423064511" sldId="267"/>
            <ac:spMk id="269" creationId="{B750676D-6836-8146-B0C6-E28958CD2E69}"/>
          </ac:spMkLst>
        </pc:spChg>
        <pc:spChg chg="mod">
          <ac:chgData name="Yuying Liang" userId="jHfLqa0+NHnW/L3/y1HwdzoR61mtDz/AjzlijymjloY=" providerId="None" clId="Web-{679789CC-9D96-4E9F-9F7F-A2765F89A6A3}" dt="2026-02-25T17:39:13.189" v="85" actId="1076"/>
          <ac:spMkLst>
            <pc:docMk/>
            <pc:sldMk cId="423064511" sldId="267"/>
            <ac:spMk id="270" creationId="{6E72BA95-F7EB-AA40-BFF9-D27BBFBDC206}"/>
          </ac:spMkLst>
        </pc:spChg>
        <pc:spChg chg="mod">
          <ac:chgData name="Yuying Liang" userId="jHfLqa0+NHnW/L3/y1HwdzoR61mtDz/AjzlijymjloY=" providerId="None" clId="Web-{679789CC-9D96-4E9F-9F7F-A2765F89A6A3}" dt="2026-02-25T17:39:13.330" v="86" actId="1076"/>
          <ac:spMkLst>
            <pc:docMk/>
            <pc:sldMk cId="423064511" sldId="267"/>
            <ac:spMk id="271" creationId="{DA1CF805-4046-CC45-A4BD-EDDD39F97D2B}"/>
          </ac:spMkLst>
        </pc:spChg>
        <pc:grpChg chg="mod">
          <ac:chgData name="Yuying Liang" userId="jHfLqa0+NHnW/L3/y1HwdzoR61mtDz/AjzlijymjloY=" providerId="None" clId="Web-{679789CC-9D96-4E9F-9F7F-A2765F89A6A3}" dt="2026-02-25T17:39:01.922" v="4" actId="1076"/>
          <ac:grpSpMkLst>
            <pc:docMk/>
            <pc:sldMk cId="423064511" sldId="267"/>
            <ac:grpSpMk id="7" creationId="{553BCDC8-539B-0245-B787-FC055969A03D}"/>
          </ac:grpSpMkLst>
        </pc:grpChg>
        <pc:grpChg chg="mod">
          <ac:chgData name="Yuying Liang" userId="jHfLqa0+NHnW/L3/y1HwdzoR61mtDz/AjzlijymjloY=" providerId="None" clId="Web-{679789CC-9D96-4E9F-9F7F-A2765F89A6A3}" dt="2026-02-25T17:39:04.454" v="5" actId="1076"/>
          <ac:grpSpMkLst>
            <pc:docMk/>
            <pc:sldMk cId="423064511" sldId="267"/>
            <ac:grpSpMk id="44" creationId="{965F907C-E343-0142-B8B8-5C9584F306B7}"/>
          </ac:grpSpMkLst>
        </pc:grpChg>
        <pc:grpChg chg="mod">
          <ac:chgData name="Yuying Liang" userId="jHfLqa0+NHnW/L3/y1HwdzoR61mtDz/AjzlijymjloY=" providerId="None" clId="Web-{679789CC-9D96-4E9F-9F7F-A2765F89A6A3}" dt="2026-02-25T17:39:04.641" v="6" actId="1076"/>
          <ac:grpSpMkLst>
            <pc:docMk/>
            <pc:sldMk cId="423064511" sldId="267"/>
            <ac:grpSpMk id="54" creationId="{19B54067-D41E-9748-9AE3-1D680CD4D6C4}"/>
          </ac:grpSpMkLst>
        </pc:grpChg>
      </pc:sldChg>
    </pc:docChg>
  </pc:docChgLst>
  <pc:docChgLst>
    <pc:chgData name="Yuying Liang" userId="jHfLqa0+NHnW/L3/y1HwdzoR61mtDz/AjzlijymjloY=" providerId="None" clId="Web-{5D263207-5A79-408E-BC24-853A4FF13710}"/>
    <pc:docChg chg="modSld">
      <pc:chgData name="Yuying Liang" userId="jHfLqa0+NHnW/L3/y1HwdzoR61mtDz/AjzlijymjloY=" providerId="None" clId="Web-{5D263207-5A79-408E-BC24-853A4FF13710}" dt="2026-02-25T17:29:20.445" v="473" actId="1076"/>
      <pc:docMkLst>
        <pc:docMk/>
      </pc:docMkLst>
      <pc:sldChg chg="modSp">
        <pc:chgData name="Yuying Liang" userId="jHfLqa0+NHnW/L3/y1HwdzoR61mtDz/AjzlijymjloY=" providerId="None" clId="Web-{5D263207-5A79-408E-BC24-853A4FF13710}" dt="2026-02-25T17:07:15.188" v="2" actId="1076"/>
        <pc:sldMkLst>
          <pc:docMk/>
          <pc:sldMk cId="2010271802" sldId="257"/>
        </pc:sldMkLst>
        <pc:spChg chg="mod">
          <ac:chgData name="Yuying Liang" userId="jHfLqa0+NHnW/L3/y1HwdzoR61mtDz/AjzlijymjloY=" providerId="None" clId="Web-{5D263207-5A79-408E-BC24-853A4FF13710}" dt="2026-02-25T17:07:06.110" v="0" actId="1076"/>
          <ac:spMkLst>
            <pc:docMk/>
            <pc:sldMk cId="2010271802" sldId="257"/>
            <ac:spMk id="3" creationId="{CDD54AB3-AC07-1B41-A492-3D275F4B446C}"/>
          </ac:spMkLst>
        </pc:spChg>
        <pc:spChg chg="mod">
          <ac:chgData name="Yuying Liang" userId="jHfLqa0+NHnW/L3/y1HwdzoR61mtDz/AjzlijymjloY=" providerId="None" clId="Web-{5D263207-5A79-408E-BC24-853A4FF13710}" dt="2026-02-25T17:07:14.798" v="1" actId="1076"/>
          <ac:spMkLst>
            <pc:docMk/>
            <pc:sldMk cId="2010271802" sldId="257"/>
            <ac:spMk id="66" creationId="{DA1D9CFA-1987-5746-8ABC-CB0C4419044C}"/>
          </ac:spMkLst>
        </pc:spChg>
        <pc:spChg chg="mod">
          <ac:chgData name="Yuying Liang" userId="jHfLqa0+NHnW/L3/y1HwdzoR61mtDz/AjzlijymjloY=" providerId="None" clId="Web-{5D263207-5A79-408E-BC24-853A4FF13710}" dt="2026-02-25T17:07:15.188" v="2" actId="1076"/>
          <ac:spMkLst>
            <pc:docMk/>
            <pc:sldMk cId="2010271802" sldId="257"/>
            <ac:spMk id="67" creationId="{6C011704-1E08-6C45-860E-78B2F95EE848}"/>
          </ac:spMkLst>
        </pc:spChg>
      </pc:sldChg>
      <pc:sldChg chg="addSp delSp modSp">
        <pc:chgData name="Yuying Liang" userId="jHfLqa0+NHnW/L3/y1HwdzoR61mtDz/AjzlijymjloY=" providerId="None" clId="Web-{5D263207-5A79-408E-BC24-853A4FF13710}" dt="2026-02-25T17:29:20.445" v="473" actId="1076"/>
        <pc:sldMkLst>
          <pc:docMk/>
          <pc:sldMk cId="423064511" sldId="267"/>
        </pc:sldMkLst>
        <pc:spChg chg="mod">
          <ac:chgData name="Yuying Liang" userId="jHfLqa0+NHnW/L3/y1HwdzoR61mtDz/AjzlijymjloY=" providerId="None" clId="Web-{5D263207-5A79-408E-BC24-853A4FF13710}" dt="2026-02-25T17:27:28.726" v="430" actId="1076"/>
          <ac:spMkLst>
            <pc:docMk/>
            <pc:sldMk cId="423064511" sldId="267"/>
            <ac:spMk id="188" creationId="{195D6A14-763B-3149-BC08-EEE5074E0BE4}"/>
          </ac:spMkLst>
        </pc:spChg>
        <pc:spChg chg="mod">
          <ac:chgData name="Yuying Liang" userId="jHfLqa0+NHnW/L3/y1HwdzoR61mtDz/AjzlijymjloY=" providerId="None" clId="Web-{5D263207-5A79-408E-BC24-853A4FF13710}" dt="2026-02-25T17:27:06.988" v="420" actId="1076"/>
          <ac:spMkLst>
            <pc:docMk/>
            <pc:sldMk cId="423064511" sldId="267"/>
            <ac:spMk id="189" creationId="{9C23E919-A96F-C443-ABD3-2C63FF775128}"/>
          </ac:spMkLst>
        </pc:spChg>
        <pc:spChg chg="mod">
          <ac:chgData name="Yuying Liang" userId="jHfLqa0+NHnW/L3/y1HwdzoR61mtDz/AjzlijymjloY=" providerId="None" clId="Web-{5D263207-5A79-408E-BC24-853A4FF13710}" dt="2026-02-25T17:27:07.066" v="421" actId="1076"/>
          <ac:spMkLst>
            <pc:docMk/>
            <pc:sldMk cId="423064511" sldId="267"/>
            <ac:spMk id="190" creationId="{5FF3C505-F557-0A43-8817-885B564AC7CB}"/>
          </ac:spMkLst>
        </pc:spChg>
        <pc:spChg chg="mod">
          <ac:chgData name="Yuying Liang" userId="jHfLqa0+NHnW/L3/y1HwdzoR61mtDz/AjzlijymjloY=" providerId="None" clId="Web-{5D263207-5A79-408E-BC24-853A4FF13710}" dt="2026-02-25T17:26:49.831" v="417" actId="1076"/>
          <ac:spMkLst>
            <pc:docMk/>
            <pc:sldMk cId="423064511" sldId="267"/>
            <ac:spMk id="191" creationId="{1F25606F-E82D-D541-9540-8F8A82E617EA}"/>
          </ac:spMkLst>
        </pc:spChg>
        <pc:spChg chg="mod">
          <ac:chgData name="Yuying Liang" userId="jHfLqa0+NHnW/L3/y1HwdzoR61mtDz/AjzlijymjloY=" providerId="None" clId="Web-{5D263207-5A79-408E-BC24-853A4FF13710}" dt="2026-02-25T17:28:00.216" v="440" actId="1076"/>
          <ac:spMkLst>
            <pc:docMk/>
            <pc:sldMk cId="423064511" sldId="267"/>
            <ac:spMk id="192" creationId="{DE032EDC-AE41-3241-9E13-33B2127150C5}"/>
          </ac:spMkLst>
        </pc:spChg>
        <pc:spChg chg="mod">
          <ac:chgData name="Yuying Liang" userId="jHfLqa0+NHnW/L3/y1HwdzoR61mtDz/AjzlijymjloY=" providerId="None" clId="Web-{5D263207-5A79-408E-BC24-853A4FF13710}" dt="2026-02-25T17:28:00.310" v="441" actId="1076"/>
          <ac:spMkLst>
            <pc:docMk/>
            <pc:sldMk cId="423064511" sldId="267"/>
            <ac:spMk id="193" creationId="{FFE7D41B-289D-4C46-86F7-80F15718EC96}"/>
          </ac:spMkLst>
        </pc:spChg>
        <pc:spChg chg="add del mod">
          <ac:chgData name="Yuying Liang" userId="jHfLqa0+NHnW/L3/y1HwdzoR61mtDz/AjzlijymjloY=" providerId="None" clId="Web-{5D263207-5A79-408E-BC24-853A4FF13710}" dt="2026-02-25T17:27:45.839" v="437" actId="1076"/>
          <ac:spMkLst>
            <pc:docMk/>
            <pc:sldMk cId="423064511" sldId="267"/>
            <ac:spMk id="194" creationId="{89D7DF69-24AB-B145-8825-71FDB926CA9D}"/>
          </ac:spMkLst>
        </pc:spChg>
        <pc:spChg chg="mod">
          <ac:chgData name="Yuying Liang" userId="jHfLqa0+NHnW/L3/y1HwdzoR61mtDz/AjzlijymjloY=" providerId="None" clId="Web-{5D263207-5A79-408E-BC24-853A4FF13710}" dt="2026-02-25T17:27:07.144" v="422" actId="1076"/>
          <ac:spMkLst>
            <pc:docMk/>
            <pc:sldMk cId="423064511" sldId="267"/>
            <ac:spMk id="195" creationId="{2FA7C4FB-E919-FC44-AF23-2BE32ED5F48D}"/>
          </ac:spMkLst>
        </pc:spChg>
        <pc:spChg chg="mod">
          <ac:chgData name="Yuying Liang" userId="jHfLqa0+NHnW/L3/y1HwdzoR61mtDz/AjzlijymjloY=" providerId="None" clId="Web-{5D263207-5A79-408E-BC24-853A4FF13710}" dt="2026-02-25T17:27:07.238" v="423" actId="1076"/>
          <ac:spMkLst>
            <pc:docMk/>
            <pc:sldMk cId="423064511" sldId="267"/>
            <ac:spMk id="196" creationId="{B4B1DAFF-C098-D342-B0F2-542940A50E4D}"/>
          </ac:spMkLst>
        </pc:spChg>
        <pc:spChg chg="mod">
          <ac:chgData name="Yuying Liang" userId="jHfLqa0+NHnW/L3/y1HwdzoR61mtDz/AjzlijymjloY=" providerId="None" clId="Web-{5D263207-5A79-408E-BC24-853A4FF13710}" dt="2026-02-25T17:26:49.925" v="418" actId="1076"/>
          <ac:spMkLst>
            <pc:docMk/>
            <pc:sldMk cId="423064511" sldId="267"/>
            <ac:spMk id="197" creationId="{D428C8F4-217B-1D4F-88DD-8C88C4EC0E42}"/>
          </ac:spMkLst>
        </pc:spChg>
        <pc:spChg chg="mod">
          <ac:chgData name="Yuying Liang" userId="jHfLqa0+NHnW/L3/y1HwdzoR61mtDz/AjzlijymjloY=" providerId="None" clId="Web-{5D263207-5A79-408E-BC24-853A4FF13710}" dt="2026-02-25T17:25:43.706" v="377" actId="1076"/>
          <ac:spMkLst>
            <pc:docMk/>
            <pc:sldMk cId="423064511" sldId="267"/>
            <ac:spMk id="198" creationId="{22FB9C45-E78D-F74C-ACC6-F64049E66890}"/>
          </ac:spMkLst>
        </pc:spChg>
        <pc:spChg chg="mod">
          <ac:chgData name="Yuying Liang" userId="jHfLqa0+NHnW/L3/y1HwdzoR61mtDz/AjzlijymjloY=" providerId="None" clId="Web-{5D263207-5A79-408E-BC24-853A4FF13710}" dt="2026-02-25T17:27:07.316" v="424" actId="1076"/>
          <ac:spMkLst>
            <pc:docMk/>
            <pc:sldMk cId="423064511" sldId="267"/>
            <ac:spMk id="199" creationId="{E4B6022B-E84A-374D-B424-9F972DC40B1D}"/>
          </ac:spMkLst>
        </pc:spChg>
        <pc:spChg chg="mod">
          <ac:chgData name="Yuying Liang" userId="jHfLqa0+NHnW/L3/y1HwdzoR61mtDz/AjzlijymjloY=" providerId="None" clId="Web-{5D263207-5A79-408E-BC24-853A4FF13710}" dt="2026-02-25T17:26:50.003" v="419" actId="1076"/>
          <ac:spMkLst>
            <pc:docMk/>
            <pc:sldMk cId="423064511" sldId="267"/>
            <ac:spMk id="200" creationId="{E5E98A1B-7FBD-234B-B09F-F360357969C5}"/>
          </ac:spMkLst>
        </pc:spChg>
        <pc:spChg chg="mod">
          <ac:chgData name="Yuying Liang" userId="jHfLqa0+NHnW/L3/y1HwdzoR61mtDz/AjzlijymjloY=" providerId="None" clId="Web-{5D263207-5A79-408E-BC24-853A4FF13710}" dt="2026-02-25T17:27:28.804" v="431" actId="1076"/>
          <ac:spMkLst>
            <pc:docMk/>
            <pc:sldMk cId="423064511" sldId="267"/>
            <ac:spMk id="201" creationId="{675B4E59-7805-7B42-B47C-841736873B7F}"/>
          </ac:spMkLst>
        </pc:spChg>
        <pc:spChg chg="mod">
          <ac:chgData name="Yuying Liang" userId="jHfLqa0+NHnW/L3/y1HwdzoR61mtDz/AjzlijymjloY=" providerId="None" clId="Web-{5D263207-5A79-408E-BC24-853A4FF13710}" dt="2026-02-25T17:27:28.882" v="432" actId="1076"/>
          <ac:spMkLst>
            <pc:docMk/>
            <pc:sldMk cId="423064511" sldId="267"/>
            <ac:spMk id="202" creationId="{EE1444BC-80D0-D843-A44D-CC62B87798AE}"/>
          </ac:spMkLst>
        </pc:spChg>
        <pc:spChg chg="mod">
          <ac:chgData name="Yuying Liang" userId="jHfLqa0+NHnW/L3/y1HwdzoR61mtDz/AjzlijymjloY=" providerId="None" clId="Web-{5D263207-5A79-408E-BC24-853A4FF13710}" dt="2026-02-25T17:27:18.693" v="427" actId="1076"/>
          <ac:spMkLst>
            <pc:docMk/>
            <pc:sldMk cId="423064511" sldId="267"/>
            <ac:spMk id="203" creationId="{F63D9854-72CE-3E46-99DB-5E8E3CFD0836}"/>
          </ac:spMkLst>
        </pc:spChg>
        <pc:spChg chg="mod">
          <ac:chgData name="Yuying Liang" userId="jHfLqa0+NHnW/L3/y1HwdzoR61mtDz/AjzlijymjloY=" providerId="None" clId="Web-{5D263207-5A79-408E-BC24-853A4FF13710}" dt="2026-02-25T17:28:40.441" v="450" actId="1076"/>
          <ac:spMkLst>
            <pc:docMk/>
            <pc:sldMk cId="423064511" sldId="267"/>
            <ac:spMk id="204" creationId="{C83B747F-8F4C-3B46-97D3-E91442BAA5DA}"/>
          </ac:spMkLst>
        </pc:spChg>
        <pc:spChg chg="mod">
          <ac:chgData name="Yuying Liang" userId="jHfLqa0+NHnW/L3/y1HwdzoR61mtDz/AjzlijymjloY=" providerId="None" clId="Web-{5D263207-5A79-408E-BC24-853A4FF13710}" dt="2026-02-25T17:28:40.550" v="451" actId="1076"/>
          <ac:spMkLst>
            <pc:docMk/>
            <pc:sldMk cId="423064511" sldId="267"/>
            <ac:spMk id="205" creationId="{F5F77A2E-C5FE-FC4E-A948-E95B05B96153}"/>
          </ac:spMkLst>
        </pc:spChg>
        <pc:spChg chg="mod">
          <ac:chgData name="Yuying Liang" userId="jHfLqa0+NHnW/L3/y1HwdzoR61mtDz/AjzlijymjloY=" providerId="None" clId="Web-{5D263207-5A79-408E-BC24-853A4FF13710}" dt="2026-02-25T17:28:07.671" v="447" actId="1076"/>
          <ac:spMkLst>
            <pc:docMk/>
            <pc:sldMk cId="423064511" sldId="267"/>
            <ac:spMk id="206" creationId="{6061AE2B-F62C-C24E-BAF4-078447FADBE7}"/>
          </ac:spMkLst>
        </pc:spChg>
        <pc:spChg chg="mod">
          <ac:chgData name="Yuying Liang" userId="jHfLqa0+NHnW/L3/y1HwdzoR61mtDz/AjzlijymjloY=" providerId="None" clId="Web-{5D263207-5A79-408E-BC24-853A4FF13710}" dt="2026-02-25T17:27:28.960" v="433" actId="1076"/>
          <ac:spMkLst>
            <pc:docMk/>
            <pc:sldMk cId="423064511" sldId="267"/>
            <ac:spMk id="207" creationId="{794DE8A5-954E-6C4E-867A-B2D66AEA3FD2}"/>
          </ac:spMkLst>
        </pc:spChg>
        <pc:spChg chg="mod">
          <ac:chgData name="Yuying Liang" userId="jHfLqa0+NHnW/L3/y1HwdzoR61mtDz/AjzlijymjloY=" providerId="None" clId="Web-{5D263207-5A79-408E-BC24-853A4FF13710}" dt="2026-02-25T17:25:43.987" v="380" actId="1076"/>
          <ac:spMkLst>
            <pc:docMk/>
            <pc:sldMk cId="423064511" sldId="267"/>
            <ac:spMk id="209" creationId="{F93EE7C6-64EE-CE43-8519-E6A2DF82AACB}"/>
          </ac:spMkLst>
        </pc:spChg>
        <pc:spChg chg="mod">
          <ac:chgData name="Yuying Liang" userId="jHfLqa0+NHnW/L3/y1HwdzoR61mtDz/AjzlijymjloY=" providerId="None" clId="Web-{5D263207-5A79-408E-BC24-853A4FF13710}" dt="2026-02-25T17:27:29.039" v="434" actId="1076"/>
          <ac:spMkLst>
            <pc:docMk/>
            <pc:sldMk cId="423064511" sldId="267"/>
            <ac:spMk id="210" creationId="{62B711D5-2FF8-7F4E-AAB2-03117E529981}"/>
          </ac:spMkLst>
        </pc:spChg>
        <pc:spChg chg="add del mod">
          <ac:chgData name="Yuying Liang" userId="jHfLqa0+NHnW/L3/y1HwdzoR61mtDz/AjzlijymjloY=" providerId="None" clId="Web-{5D263207-5A79-408E-BC24-853A4FF13710}" dt="2026-02-25T17:22:59.970" v="263" actId="1076"/>
          <ac:spMkLst>
            <pc:docMk/>
            <pc:sldMk cId="423064511" sldId="267"/>
            <ac:spMk id="211" creationId="{1EF326AC-EE6B-1F41-9F52-B3BCB925A7BB}"/>
          </ac:spMkLst>
        </pc:spChg>
        <pc:spChg chg="mod">
          <ac:chgData name="Yuying Liang" userId="jHfLqa0+NHnW/L3/y1HwdzoR61mtDz/AjzlijymjloY=" providerId="None" clId="Web-{5D263207-5A79-408E-BC24-853A4FF13710}" dt="2026-02-25T17:27:18.802" v="428" actId="1076"/>
          <ac:spMkLst>
            <pc:docMk/>
            <pc:sldMk cId="423064511" sldId="267"/>
            <ac:spMk id="212" creationId="{883016EB-CDF8-5642-8FFF-16149D84F6F1}"/>
          </ac:spMkLst>
        </pc:spChg>
        <pc:spChg chg="mod">
          <ac:chgData name="Yuying Liang" userId="jHfLqa0+NHnW/L3/y1HwdzoR61mtDz/AjzlijymjloY=" providerId="None" clId="Web-{5D263207-5A79-408E-BC24-853A4FF13710}" dt="2026-02-25T17:22:17.939" v="241" actId="1076"/>
          <ac:spMkLst>
            <pc:docMk/>
            <pc:sldMk cId="423064511" sldId="267"/>
            <ac:spMk id="213" creationId="{1AC39964-709B-D749-A153-434CAEC11496}"/>
          </ac:spMkLst>
        </pc:spChg>
        <pc:spChg chg="mod">
          <ac:chgData name="Yuying Liang" userId="jHfLqa0+NHnW/L3/y1HwdzoR61mtDz/AjzlijymjloY=" providerId="None" clId="Web-{5D263207-5A79-408E-BC24-853A4FF13710}" dt="2026-02-25T17:28:00.404" v="442" actId="1076"/>
          <ac:spMkLst>
            <pc:docMk/>
            <pc:sldMk cId="423064511" sldId="267"/>
            <ac:spMk id="214" creationId="{68897138-F94F-3240-B5B4-A5E369D6AAE0}"/>
          </ac:spMkLst>
        </pc:spChg>
        <pc:spChg chg="mod">
          <ac:chgData name="Yuying Liang" userId="jHfLqa0+NHnW/L3/y1HwdzoR61mtDz/AjzlijymjloY=" providerId="None" clId="Web-{5D263207-5A79-408E-BC24-853A4FF13710}" dt="2026-02-25T17:27:45.917" v="438" actId="1076"/>
          <ac:spMkLst>
            <pc:docMk/>
            <pc:sldMk cId="423064511" sldId="267"/>
            <ac:spMk id="215" creationId="{9951BCA1-9898-954D-AAAE-79CF67C359D5}"/>
          </ac:spMkLst>
        </pc:spChg>
        <pc:spChg chg="mod">
          <ac:chgData name="Yuying Liang" userId="jHfLqa0+NHnW/L3/y1HwdzoR61mtDz/AjzlijymjloY=" providerId="None" clId="Web-{5D263207-5A79-408E-BC24-853A4FF13710}" dt="2026-02-25T17:28:40.644" v="452" actId="1076"/>
          <ac:spMkLst>
            <pc:docMk/>
            <pc:sldMk cId="423064511" sldId="267"/>
            <ac:spMk id="216" creationId="{699F062F-25B1-524C-946E-FC922F6AA967}"/>
          </ac:spMkLst>
        </pc:spChg>
        <pc:spChg chg="mod">
          <ac:chgData name="Yuying Liang" userId="jHfLqa0+NHnW/L3/y1HwdzoR61mtDz/AjzlijymjloY=" providerId="None" clId="Web-{5D263207-5A79-408E-BC24-853A4FF13710}" dt="2026-02-25T17:23:00.127" v="265" actId="1076"/>
          <ac:spMkLst>
            <pc:docMk/>
            <pc:sldMk cId="423064511" sldId="267"/>
            <ac:spMk id="217" creationId="{20A62992-17D3-AD43-AC65-C7F0076FD1BE}"/>
          </ac:spMkLst>
        </pc:spChg>
        <pc:spChg chg="mod">
          <ac:chgData name="Yuying Liang" userId="jHfLqa0+NHnW/L3/y1HwdzoR61mtDz/AjzlijymjloY=" providerId="None" clId="Web-{5D263207-5A79-408E-BC24-853A4FF13710}" dt="2026-02-25T17:22:18.236" v="244" actId="1076"/>
          <ac:spMkLst>
            <pc:docMk/>
            <pc:sldMk cId="423064511" sldId="267"/>
            <ac:spMk id="218" creationId="{DEA937AB-88CD-8C4E-A6D2-7EBF35C2654C}"/>
          </ac:spMkLst>
        </pc:spChg>
        <pc:spChg chg="mod">
          <ac:chgData name="Yuying Liang" userId="jHfLqa0+NHnW/L3/y1HwdzoR61mtDz/AjzlijymjloY=" providerId="None" clId="Web-{5D263207-5A79-408E-BC24-853A4FF13710}" dt="2026-02-25T17:29:19.929" v="467" actId="1076"/>
          <ac:spMkLst>
            <pc:docMk/>
            <pc:sldMk cId="423064511" sldId="267"/>
            <ac:spMk id="219" creationId="{82A0A384-916E-C44B-B9C6-60E23670DC52}"/>
          </ac:spMkLst>
        </pc:spChg>
        <pc:spChg chg="mod">
          <ac:chgData name="Yuying Liang" userId="jHfLqa0+NHnW/L3/y1HwdzoR61mtDz/AjzlijymjloY=" providerId="None" clId="Web-{5D263207-5A79-408E-BC24-853A4FF13710}" dt="2026-02-25T17:23:00.220" v="266" actId="1076"/>
          <ac:spMkLst>
            <pc:docMk/>
            <pc:sldMk cId="423064511" sldId="267"/>
            <ac:spMk id="220" creationId="{FB5DC02D-F262-CE4E-BE52-FA37581B16F0}"/>
          </ac:spMkLst>
        </pc:spChg>
        <pc:spChg chg="mod">
          <ac:chgData name="Yuying Liang" userId="jHfLqa0+NHnW/L3/y1HwdzoR61mtDz/AjzlijymjloY=" providerId="None" clId="Web-{5D263207-5A79-408E-BC24-853A4FF13710}" dt="2026-02-25T17:22:18.454" v="246" actId="1076"/>
          <ac:spMkLst>
            <pc:docMk/>
            <pc:sldMk cId="423064511" sldId="267"/>
            <ac:spMk id="221" creationId="{E61C830E-E092-8D44-881C-27DE667930E1}"/>
          </ac:spMkLst>
        </pc:spChg>
        <pc:spChg chg="mod">
          <ac:chgData name="Yuying Liang" userId="jHfLqa0+NHnW/L3/y1HwdzoR61mtDz/AjzlijymjloY=" providerId="None" clId="Web-{5D263207-5A79-408E-BC24-853A4FF13710}" dt="2026-02-25T17:29:07.116" v="460" actId="1076"/>
          <ac:spMkLst>
            <pc:docMk/>
            <pc:sldMk cId="423064511" sldId="267"/>
            <ac:spMk id="222" creationId="{05FD87E7-F860-7D4B-BA06-51DC085520E0}"/>
          </ac:spMkLst>
        </pc:spChg>
        <pc:spChg chg="mod">
          <ac:chgData name="Yuying Liang" userId="jHfLqa0+NHnW/L3/y1HwdzoR61mtDz/AjzlijymjloY=" providerId="None" clId="Web-{5D263207-5A79-408E-BC24-853A4FF13710}" dt="2026-02-25T17:29:07.209" v="461" actId="1076"/>
          <ac:spMkLst>
            <pc:docMk/>
            <pc:sldMk cId="423064511" sldId="267"/>
            <ac:spMk id="223" creationId="{D1753135-B85F-CD42-AD69-EC4277B806E3}"/>
          </ac:spMkLst>
        </pc:spChg>
        <pc:spChg chg="mod">
          <ac:chgData name="Yuying Liang" userId="jHfLqa0+NHnW/L3/y1HwdzoR61mtDz/AjzlijymjloY=" providerId="None" clId="Web-{5D263207-5A79-408E-BC24-853A4FF13710}" dt="2026-02-25T17:28:48.504" v="457" actId="1076"/>
          <ac:spMkLst>
            <pc:docMk/>
            <pc:sldMk cId="423064511" sldId="267"/>
            <ac:spMk id="224" creationId="{43EB3A12-8E86-2E4E-961E-64146EB4C086}"/>
          </ac:spMkLst>
        </pc:spChg>
        <pc:spChg chg="mod">
          <ac:chgData name="Yuying Liang" userId="jHfLqa0+NHnW/L3/y1HwdzoR61mtDz/AjzlijymjloY=" providerId="None" clId="Web-{5D263207-5A79-408E-BC24-853A4FF13710}" dt="2026-02-25T17:28:40.753" v="453" actId="1076"/>
          <ac:spMkLst>
            <pc:docMk/>
            <pc:sldMk cId="423064511" sldId="267"/>
            <ac:spMk id="225" creationId="{A87BC658-59FE-8A4A-A228-FDDF94EE0602}"/>
          </ac:spMkLst>
        </pc:spChg>
        <pc:spChg chg="mod">
          <ac:chgData name="Yuying Liang" userId="jHfLqa0+NHnW/L3/y1HwdzoR61mtDz/AjzlijymjloY=" providerId="None" clId="Web-{5D263207-5A79-408E-BC24-853A4FF13710}" dt="2026-02-25T17:28:40.863" v="454" actId="1076"/>
          <ac:spMkLst>
            <pc:docMk/>
            <pc:sldMk cId="423064511" sldId="267"/>
            <ac:spMk id="226" creationId="{E9560AC4-544B-E14B-BEAF-AC8A8C269A9F}"/>
          </ac:spMkLst>
        </pc:spChg>
        <pc:spChg chg="mod">
          <ac:chgData name="Yuying Liang" userId="jHfLqa0+NHnW/L3/y1HwdzoR61mtDz/AjzlijymjloY=" providerId="None" clId="Web-{5D263207-5A79-408E-BC24-853A4FF13710}" dt="2026-02-25T17:28:07.764" v="448" actId="1076"/>
          <ac:spMkLst>
            <pc:docMk/>
            <pc:sldMk cId="423064511" sldId="267"/>
            <ac:spMk id="227" creationId="{238BB6CA-3CE3-AF4B-B886-3E03BFD6187E}"/>
          </ac:spMkLst>
        </pc:spChg>
        <pc:spChg chg="mod">
          <ac:chgData name="Yuying Liang" userId="jHfLqa0+NHnW/L3/y1HwdzoR61mtDz/AjzlijymjloY=" providerId="None" clId="Web-{5D263207-5A79-408E-BC24-853A4FF13710}" dt="2026-02-25T17:29:20.007" v="468" actId="1076"/>
          <ac:spMkLst>
            <pc:docMk/>
            <pc:sldMk cId="423064511" sldId="267"/>
            <ac:spMk id="228" creationId="{49BE6E4A-2F09-AF45-BA42-8295D1C9950F}"/>
          </ac:spMkLst>
        </pc:spChg>
        <pc:spChg chg="mod">
          <ac:chgData name="Yuying Liang" userId="jHfLqa0+NHnW/L3/y1HwdzoR61mtDz/AjzlijymjloY=" providerId="None" clId="Web-{5D263207-5A79-408E-BC24-853A4FF13710}" dt="2026-02-25T17:29:20.101" v="469" actId="1076"/>
          <ac:spMkLst>
            <pc:docMk/>
            <pc:sldMk cId="423064511" sldId="267"/>
            <ac:spMk id="229" creationId="{C4694894-DE19-2241-92D2-53C12378BE04}"/>
          </ac:spMkLst>
        </pc:spChg>
        <pc:spChg chg="mod">
          <ac:chgData name="Yuying Liang" userId="jHfLqa0+NHnW/L3/y1HwdzoR61mtDz/AjzlijymjloY=" providerId="None" clId="Web-{5D263207-5A79-408E-BC24-853A4FF13710}" dt="2026-02-25T17:23:51.690" v="288" actId="1076"/>
          <ac:spMkLst>
            <pc:docMk/>
            <pc:sldMk cId="423064511" sldId="267"/>
            <ac:spMk id="230" creationId="{79A14033-CC44-5C40-840C-A7667A0801C3}"/>
          </ac:spMkLst>
        </pc:spChg>
        <pc:spChg chg="mod">
          <ac:chgData name="Yuying Liang" userId="jHfLqa0+NHnW/L3/y1HwdzoR61mtDz/AjzlijymjloY=" providerId="None" clId="Web-{5D263207-5A79-408E-BC24-853A4FF13710}" dt="2026-02-25T17:27:29.117" v="435" actId="1076"/>
          <ac:spMkLst>
            <pc:docMk/>
            <pc:sldMk cId="423064511" sldId="267"/>
            <ac:spMk id="234" creationId="{40D379EE-9E6B-414C-A4A4-E5AE024BE0DE}"/>
          </ac:spMkLst>
        </pc:spChg>
        <pc:spChg chg="mod">
          <ac:chgData name="Yuying Liang" userId="jHfLqa0+NHnW/L3/y1HwdzoR61mtDz/AjzlijymjloY=" providerId="None" clId="Web-{5D263207-5A79-408E-BC24-853A4FF13710}" dt="2026-02-25T17:27:29.195" v="436" actId="1076"/>
          <ac:spMkLst>
            <pc:docMk/>
            <pc:sldMk cId="423064511" sldId="267"/>
            <ac:spMk id="235" creationId="{98F91732-31A3-C947-8B25-16BB79228514}"/>
          </ac:spMkLst>
        </pc:spChg>
        <pc:spChg chg="mod">
          <ac:chgData name="Yuying Liang" userId="jHfLqa0+NHnW/L3/y1HwdzoR61mtDz/AjzlijymjloY=" providerId="None" clId="Web-{5D263207-5A79-408E-BC24-853A4FF13710}" dt="2026-02-25T17:27:18.927" v="429" actId="1076"/>
          <ac:spMkLst>
            <pc:docMk/>
            <pc:sldMk cId="423064511" sldId="267"/>
            <ac:spMk id="236" creationId="{3D584002-E0B6-154E-BE8B-6894BFD9E684}"/>
          </ac:spMkLst>
        </pc:spChg>
        <pc:spChg chg="mod">
          <ac:chgData name="Yuying Liang" userId="jHfLqa0+NHnW/L3/y1HwdzoR61mtDz/AjzlijymjloY=" providerId="None" clId="Web-{5D263207-5A79-408E-BC24-853A4FF13710}" dt="2026-02-25T17:29:20.179" v="470" actId="1076"/>
          <ac:spMkLst>
            <pc:docMk/>
            <pc:sldMk cId="423064511" sldId="267"/>
            <ac:spMk id="237" creationId="{1D6D664F-15D4-FD4F-91E1-236D70938E4C}"/>
          </ac:spMkLst>
        </pc:spChg>
        <pc:spChg chg="mod">
          <ac:chgData name="Yuying Liang" userId="jHfLqa0+NHnW/L3/y1HwdzoR61mtDz/AjzlijymjloY=" providerId="None" clId="Web-{5D263207-5A79-408E-BC24-853A4FF13710}" dt="2026-02-25T17:29:20.257" v="471" actId="1076"/>
          <ac:spMkLst>
            <pc:docMk/>
            <pc:sldMk cId="423064511" sldId="267"/>
            <ac:spMk id="238" creationId="{370383B7-DEB6-754E-9460-2A48B59023B2}"/>
          </ac:spMkLst>
        </pc:spChg>
        <pc:spChg chg="mod">
          <ac:chgData name="Yuying Liang" userId="jHfLqa0+NHnW/L3/y1HwdzoR61mtDz/AjzlijymjloY=" providerId="None" clId="Web-{5D263207-5A79-408E-BC24-853A4FF13710}" dt="2026-02-25T17:24:24.190" v="324" actId="1076"/>
          <ac:spMkLst>
            <pc:docMk/>
            <pc:sldMk cId="423064511" sldId="267"/>
            <ac:spMk id="239" creationId="{DA113AE6-312B-4348-8517-693F4A561AB0}"/>
          </ac:spMkLst>
        </pc:spChg>
        <pc:spChg chg="mod">
          <ac:chgData name="Yuying Liang" userId="jHfLqa0+NHnW/L3/y1HwdzoR61mtDz/AjzlijymjloY=" providerId="None" clId="Web-{5D263207-5A79-408E-BC24-853A4FF13710}" dt="2026-02-25T17:27:07.425" v="425" actId="1076"/>
          <ac:spMkLst>
            <pc:docMk/>
            <pc:sldMk cId="423064511" sldId="267"/>
            <ac:spMk id="240" creationId="{105C48AB-48A7-4949-A984-00DD15156468}"/>
          </ac:spMkLst>
        </pc:spChg>
        <pc:spChg chg="mod">
          <ac:chgData name="Yuying Liang" userId="jHfLqa0+NHnW/L3/y1HwdzoR61mtDz/AjzlijymjloY=" providerId="None" clId="Web-{5D263207-5A79-408E-BC24-853A4FF13710}" dt="2026-02-25T17:27:07.519" v="426" actId="1076"/>
          <ac:spMkLst>
            <pc:docMk/>
            <pc:sldMk cId="423064511" sldId="267"/>
            <ac:spMk id="241" creationId="{46872EBD-FA97-9949-AB14-796BA68FED49}"/>
          </ac:spMkLst>
        </pc:spChg>
        <pc:spChg chg="mod">
          <ac:chgData name="Yuying Liang" userId="jHfLqa0+NHnW/L3/y1HwdzoR61mtDz/AjzlijymjloY=" providerId="None" clId="Web-{5D263207-5A79-408E-BC24-853A4FF13710}" dt="2026-02-25T17:23:51.924" v="290" actId="1076"/>
          <ac:spMkLst>
            <pc:docMk/>
            <pc:sldMk cId="423064511" sldId="267"/>
            <ac:spMk id="242" creationId="{CAC45503-D23B-274D-87EE-ADB21EC6BCB4}"/>
          </ac:spMkLst>
        </pc:spChg>
        <pc:spChg chg="mod">
          <ac:chgData name="Yuying Liang" userId="jHfLqa0+NHnW/L3/y1HwdzoR61mtDz/AjzlijymjloY=" providerId="None" clId="Web-{5D263207-5A79-408E-BC24-853A4FF13710}" dt="2026-02-25T17:29:07.303" v="462" actId="1076"/>
          <ac:spMkLst>
            <pc:docMk/>
            <pc:sldMk cId="423064511" sldId="267"/>
            <ac:spMk id="243" creationId="{3C0BC64F-B68E-2C47-B9F9-28D020A8ABE4}"/>
          </ac:spMkLst>
        </pc:spChg>
        <pc:spChg chg="mod">
          <ac:chgData name="Yuying Liang" userId="jHfLqa0+NHnW/L3/y1HwdzoR61mtDz/AjzlijymjloY=" providerId="None" clId="Web-{5D263207-5A79-408E-BC24-853A4FF13710}" dt="2026-02-25T17:29:07.397" v="463" actId="1076"/>
          <ac:spMkLst>
            <pc:docMk/>
            <pc:sldMk cId="423064511" sldId="267"/>
            <ac:spMk id="244" creationId="{443B7DD1-251F-464E-843E-B4C938FC2DFA}"/>
          </ac:spMkLst>
        </pc:spChg>
        <pc:spChg chg="mod">
          <ac:chgData name="Yuying Liang" userId="jHfLqa0+NHnW/L3/y1HwdzoR61mtDz/AjzlijymjloY=" providerId="None" clId="Web-{5D263207-5A79-408E-BC24-853A4FF13710}" dt="2026-02-25T17:28:48.582" v="458" actId="1076"/>
          <ac:spMkLst>
            <pc:docMk/>
            <pc:sldMk cId="423064511" sldId="267"/>
            <ac:spMk id="245" creationId="{FC8E1BDA-9D1E-9348-9F2B-2578B6117029}"/>
          </ac:spMkLst>
        </pc:spChg>
        <pc:spChg chg="mod">
          <ac:chgData name="Yuying Liang" userId="jHfLqa0+NHnW/L3/y1HwdzoR61mtDz/AjzlijymjloY=" providerId="None" clId="Web-{5D263207-5A79-408E-BC24-853A4FF13710}" dt="2026-02-25T17:28:00.498" v="443" actId="1076"/>
          <ac:spMkLst>
            <pc:docMk/>
            <pc:sldMk cId="423064511" sldId="267"/>
            <ac:spMk id="246" creationId="{F9448975-35D6-8E45-B27D-42D3BAE99291}"/>
          </ac:spMkLst>
        </pc:spChg>
        <pc:spChg chg="mod">
          <ac:chgData name="Yuying Liang" userId="jHfLqa0+NHnW/L3/y1HwdzoR61mtDz/AjzlijymjloY=" providerId="None" clId="Web-{5D263207-5A79-408E-BC24-853A4FF13710}" dt="2026-02-25T17:28:00.576" v="444" actId="1076"/>
          <ac:spMkLst>
            <pc:docMk/>
            <pc:sldMk cId="423064511" sldId="267"/>
            <ac:spMk id="247" creationId="{4DF947CA-08D7-1B46-97A1-AC02A7FB7D10}"/>
          </ac:spMkLst>
        </pc:spChg>
        <pc:spChg chg="mod">
          <ac:chgData name="Yuying Liang" userId="jHfLqa0+NHnW/L3/y1HwdzoR61mtDz/AjzlijymjloY=" providerId="None" clId="Web-{5D263207-5A79-408E-BC24-853A4FF13710}" dt="2026-02-25T17:27:45.995" v="439" actId="1076"/>
          <ac:spMkLst>
            <pc:docMk/>
            <pc:sldMk cId="423064511" sldId="267"/>
            <ac:spMk id="248" creationId="{CF01DF0A-943A-F043-A3DC-4E809DD0B182}"/>
          </ac:spMkLst>
        </pc:spChg>
        <pc:spChg chg="mod">
          <ac:chgData name="Yuying Liang" userId="jHfLqa0+NHnW/L3/y1HwdzoR61mtDz/AjzlijymjloY=" providerId="None" clId="Web-{5D263207-5A79-408E-BC24-853A4FF13710}" dt="2026-02-25T17:29:07.506" v="464" actId="1076"/>
          <ac:spMkLst>
            <pc:docMk/>
            <pc:sldMk cId="423064511" sldId="267"/>
            <ac:spMk id="249" creationId="{52E79F25-29C1-E34F-99AB-7BF9F66FF1DE}"/>
          </ac:spMkLst>
        </pc:spChg>
        <pc:spChg chg="mod">
          <ac:chgData name="Yuying Liang" userId="jHfLqa0+NHnW/L3/y1HwdzoR61mtDz/AjzlijymjloY=" providerId="None" clId="Web-{5D263207-5A79-408E-BC24-853A4FF13710}" dt="2026-02-25T17:29:07.600" v="465" actId="1076"/>
          <ac:spMkLst>
            <pc:docMk/>
            <pc:sldMk cId="423064511" sldId="267"/>
            <ac:spMk id="250" creationId="{E7DAEE8F-ED64-2A48-8132-B33FF3DB6322}"/>
          </ac:spMkLst>
        </pc:spChg>
        <pc:spChg chg="mod">
          <ac:chgData name="Yuying Liang" userId="jHfLqa0+NHnW/L3/y1HwdzoR61mtDz/AjzlijymjloY=" providerId="None" clId="Web-{5D263207-5A79-408E-BC24-853A4FF13710}" dt="2026-02-25T17:28:48.660" v="459" actId="1076"/>
          <ac:spMkLst>
            <pc:docMk/>
            <pc:sldMk cId="423064511" sldId="267"/>
            <ac:spMk id="251" creationId="{00AAFE26-E9C5-D44B-89E8-81BBE9C081B3}"/>
          </ac:spMkLst>
        </pc:spChg>
        <pc:spChg chg="mod">
          <ac:chgData name="Yuying Liang" userId="jHfLqa0+NHnW/L3/y1HwdzoR61mtDz/AjzlijymjloY=" providerId="None" clId="Web-{5D263207-5A79-408E-BC24-853A4FF13710}" dt="2026-02-25T17:28:00.654" v="445" actId="1076"/>
          <ac:spMkLst>
            <pc:docMk/>
            <pc:sldMk cId="423064511" sldId="267"/>
            <ac:spMk id="252" creationId="{E7352F3C-08DD-FB4D-A03D-9E7D76872887}"/>
          </ac:spMkLst>
        </pc:spChg>
        <pc:spChg chg="mod">
          <ac:chgData name="Yuying Liang" userId="jHfLqa0+NHnW/L3/y1HwdzoR61mtDz/AjzlijymjloY=" providerId="None" clId="Web-{5D263207-5A79-408E-BC24-853A4FF13710}" dt="2026-02-25T17:28:00.732" v="446" actId="1076"/>
          <ac:spMkLst>
            <pc:docMk/>
            <pc:sldMk cId="423064511" sldId="267"/>
            <ac:spMk id="253" creationId="{BD7FDC88-FD57-1647-942C-761BBE70D4A8}"/>
          </ac:spMkLst>
        </pc:spChg>
        <pc:spChg chg="mod">
          <ac:chgData name="Yuying Liang" userId="jHfLqa0+NHnW/L3/y1HwdzoR61mtDz/AjzlijymjloY=" providerId="None" clId="Web-{5D263207-5A79-408E-BC24-853A4FF13710}" dt="2026-02-25T17:25:44.206" v="382" actId="1076"/>
          <ac:spMkLst>
            <pc:docMk/>
            <pc:sldMk cId="423064511" sldId="267"/>
            <ac:spMk id="254" creationId="{83E5C181-A77C-F544-A9FD-7C742A8DE4A2}"/>
          </ac:spMkLst>
        </pc:spChg>
        <pc:spChg chg="mod">
          <ac:chgData name="Yuying Liang" userId="jHfLqa0+NHnW/L3/y1HwdzoR61mtDz/AjzlijymjloY=" providerId="None" clId="Web-{5D263207-5A79-408E-BC24-853A4FF13710}" dt="2026-02-25T17:29:07.709" v="466" actId="1076"/>
          <ac:spMkLst>
            <pc:docMk/>
            <pc:sldMk cId="423064511" sldId="267"/>
            <ac:spMk id="255" creationId="{8A4DBC14-A247-9341-BE11-245C1A54CFB1}"/>
          </ac:spMkLst>
        </pc:spChg>
        <pc:spChg chg="mod">
          <ac:chgData name="Yuying Liang" userId="jHfLqa0+NHnW/L3/y1HwdzoR61mtDz/AjzlijymjloY=" providerId="None" clId="Web-{5D263207-5A79-408E-BC24-853A4FF13710}" dt="2026-02-25T17:25:58.065" v="398" actId="1076"/>
          <ac:spMkLst>
            <pc:docMk/>
            <pc:sldMk cId="423064511" sldId="267"/>
            <ac:spMk id="256" creationId="{6F15B922-B05D-4546-A945-93E199BE917D}"/>
          </ac:spMkLst>
        </pc:spChg>
        <pc:spChg chg="add del mod">
          <ac:chgData name="Yuying Liang" userId="jHfLqa0+NHnW/L3/y1HwdzoR61mtDz/AjzlijymjloY=" providerId="None" clId="Web-{5D263207-5A79-408E-BC24-853A4FF13710}" dt="2026-02-25T17:25:44.425" v="384" actId="1076"/>
          <ac:spMkLst>
            <pc:docMk/>
            <pc:sldMk cId="423064511" sldId="267"/>
            <ac:spMk id="257" creationId="{C94D9FC5-F6F3-C14A-87F4-FE5C4B8EF48B}"/>
          </ac:spMkLst>
        </pc:spChg>
        <pc:spChg chg="mod">
          <ac:chgData name="Yuying Liang" userId="jHfLqa0+NHnW/L3/y1HwdzoR61mtDz/AjzlijymjloY=" providerId="None" clId="Web-{5D263207-5A79-408E-BC24-853A4FF13710}" dt="2026-02-25T17:28:40.956" v="455" actId="1076"/>
          <ac:spMkLst>
            <pc:docMk/>
            <pc:sldMk cId="423064511" sldId="267"/>
            <ac:spMk id="258" creationId="{3D77D185-A792-264C-8C45-826476C69517}"/>
          </ac:spMkLst>
        </pc:spChg>
        <pc:spChg chg="mod">
          <ac:chgData name="Yuying Liang" userId="jHfLqa0+NHnW/L3/y1HwdzoR61mtDz/AjzlijymjloY=" providerId="None" clId="Web-{5D263207-5A79-408E-BC24-853A4FF13710}" dt="2026-02-25T17:28:41.097" v="456" actId="1076"/>
          <ac:spMkLst>
            <pc:docMk/>
            <pc:sldMk cId="423064511" sldId="267"/>
            <ac:spMk id="259" creationId="{B7DCC04F-393B-F34F-A422-D838A429936F}"/>
          </ac:spMkLst>
        </pc:spChg>
        <pc:spChg chg="mod">
          <ac:chgData name="Yuying Liang" userId="jHfLqa0+NHnW/L3/y1HwdzoR61mtDz/AjzlijymjloY=" providerId="None" clId="Web-{5D263207-5A79-408E-BC24-853A4FF13710}" dt="2026-02-25T17:28:07.858" v="449" actId="1076"/>
          <ac:spMkLst>
            <pc:docMk/>
            <pc:sldMk cId="423064511" sldId="267"/>
            <ac:spMk id="260" creationId="{BF6EA7E8-90F2-F048-A489-385AC16DE3BC}"/>
          </ac:spMkLst>
        </pc:spChg>
        <pc:spChg chg="mod">
          <ac:chgData name="Yuying Liang" userId="jHfLqa0+NHnW/L3/y1HwdzoR61mtDz/AjzlijymjloY=" providerId="None" clId="Web-{5D263207-5A79-408E-BC24-853A4FF13710}" dt="2026-02-25T17:29:20.351" v="472" actId="1076"/>
          <ac:spMkLst>
            <pc:docMk/>
            <pc:sldMk cId="423064511" sldId="267"/>
            <ac:spMk id="261" creationId="{B81E041E-4821-2F41-91F3-527D7A97E416}"/>
          </ac:spMkLst>
        </pc:spChg>
        <pc:spChg chg="mod">
          <ac:chgData name="Yuying Liang" userId="jHfLqa0+NHnW/L3/y1HwdzoR61mtDz/AjzlijymjloY=" providerId="None" clId="Web-{5D263207-5A79-408E-BC24-853A4FF13710}" dt="2026-02-25T17:29:20.445" v="473" actId="1076"/>
          <ac:spMkLst>
            <pc:docMk/>
            <pc:sldMk cId="423064511" sldId="267"/>
            <ac:spMk id="262" creationId="{94C25DE7-A60B-4747-BFFD-070D64AA78E4}"/>
          </ac:spMkLst>
        </pc:spChg>
        <pc:spChg chg="mod">
          <ac:chgData name="Yuying Liang" userId="jHfLqa0+NHnW/L3/y1HwdzoR61mtDz/AjzlijymjloY=" providerId="None" clId="Web-{5D263207-5A79-408E-BC24-853A4FF13710}" dt="2026-02-25T17:25:44.862" v="388" actId="1076"/>
          <ac:spMkLst>
            <pc:docMk/>
            <pc:sldMk cId="423064511" sldId="267"/>
            <ac:spMk id="263" creationId="{08D28CAB-8AEE-9C4F-9D58-934F0BF2C467}"/>
          </ac:spMkLst>
        </pc:spChg>
        <pc:spChg chg="add del mod">
          <ac:chgData name="Yuying Liang" userId="jHfLqa0+NHnW/L3/y1HwdzoR61mtDz/AjzlijymjloY=" providerId="None" clId="Web-{5D263207-5A79-408E-BC24-853A4FF13710}" dt="2026-02-25T17:26:29.925" v="409" actId="1076"/>
          <ac:spMkLst>
            <pc:docMk/>
            <pc:sldMk cId="423064511" sldId="267"/>
            <ac:spMk id="264" creationId="{13F23D97-0E63-A042-87FD-545883DA9EE3}"/>
          </ac:spMkLst>
        </pc:spChg>
        <pc:spChg chg="mod">
          <ac:chgData name="Yuying Liang" userId="jHfLqa0+NHnW/L3/y1HwdzoR61mtDz/AjzlijymjloY=" providerId="None" clId="Web-{5D263207-5A79-408E-BC24-853A4FF13710}" dt="2026-02-25T17:26:37.894" v="413" actId="1076"/>
          <ac:spMkLst>
            <pc:docMk/>
            <pc:sldMk cId="423064511" sldId="267"/>
            <ac:spMk id="265" creationId="{B8183262-EA9E-9348-A3D4-E4900CED9D32}"/>
          </ac:spMkLst>
        </pc:spChg>
        <pc:spChg chg="mod">
          <ac:chgData name="Yuying Liang" userId="jHfLqa0+NHnW/L3/y1HwdzoR61mtDz/AjzlijymjloY=" providerId="None" clId="Web-{5D263207-5A79-408E-BC24-853A4FF13710}" dt="2026-02-25T17:26:37.972" v="414" actId="1076"/>
          <ac:spMkLst>
            <pc:docMk/>
            <pc:sldMk cId="423064511" sldId="267"/>
            <ac:spMk id="266" creationId="{B1B4A465-57C2-BE46-B421-C35CFD6F3A84}"/>
          </ac:spMkLst>
        </pc:spChg>
        <pc:spChg chg="mod">
          <ac:chgData name="Yuying Liang" userId="jHfLqa0+NHnW/L3/y1HwdzoR61mtDz/AjzlijymjloY=" providerId="None" clId="Web-{5D263207-5A79-408E-BC24-853A4FF13710}" dt="2026-02-25T17:26:38.066" v="415" actId="1076"/>
          <ac:spMkLst>
            <pc:docMk/>
            <pc:sldMk cId="423064511" sldId="267"/>
            <ac:spMk id="267" creationId="{71F9DDF3-8D6F-E341-88F4-82FFDA489F52}"/>
          </ac:spMkLst>
        </pc:spChg>
        <pc:spChg chg="mod">
          <ac:chgData name="Yuying Liang" userId="jHfLqa0+NHnW/L3/y1HwdzoR61mtDz/AjzlijymjloY=" providerId="None" clId="Web-{5D263207-5A79-408E-BC24-853A4FF13710}" dt="2026-02-25T17:26:38.144" v="416" actId="1076"/>
          <ac:spMkLst>
            <pc:docMk/>
            <pc:sldMk cId="423064511" sldId="267"/>
            <ac:spMk id="268" creationId="{1EA542F3-5AE9-CA40-96C1-3223F4B5E89E}"/>
          </ac:spMkLst>
        </pc:spChg>
        <pc:spChg chg="mod">
          <ac:chgData name="Yuying Liang" userId="jHfLqa0+NHnW/L3/y1HwdzoR61mtDz/AjzlijymjloY=" providerId="None" clId="Web-{5D263207-5A79-408E-BC24-853A4FF13710}" dt="2026-02-25T17:26:30.019" v="410" actId="1076"/>
          <ac:spMkLst>
            <pc:docMk/>
            <pc:sldMk cId="423064511" sldId="267"/>
            <ac:spMk id="269" creationId="{B750676D-6836-8146-B0C6-E28958CD2E69}"/>
          </ac:spMkLst>
        </pc:spChg>
        <pc:spChg chg="mod">
          <ac:chgData name="Yuying Liang" userId="jHfLqa0+NHnW/L3/y1HwdzoR61mtDz/AjzlijymjloY=" providerId="None" clId="Web-{5D263207-5A79-408E-BC24-853A4FF13710}" dt="2026-02-25T17:26:30.112" v="411" actId="1076"/>
          <ac:spMkLst>
            <pc:docMk/>
            <pc:sldMk cId="423064511" sldId="267"/>
            <ac:spMk id="270" creationId="{6E72BA95-F7EB-AA40-BFF9-D27BBFBDC206}"/>
          </ac:spMkLst>
        </pc:spChg>
        <pc:spChg chg="mod">
          <ac:chgData name="Yuying Liang" userId="jHfLqa0+NHnW/L3/y1HwdzoR61mtDz/AjzlijymjloY=" providerId="None" clId="Web-{5D263207-5A79-408E-BC24-853A4FF13710}" dt="2026-02-25T17:26:30.191" v="412" actId="1076"/>
          <ac:spMkLst>
            <pc:docMk/>
            <pc:sldMk cId="423064511" sldId="267"/>
            <ac:spMk id="271" creationId="{DA1CF805-4046-CC45-A4BD-EDDD39F97D2B}"/>
          </ac:spMkLst>
        </pc:spChg>
        <pc:grpChg chg="mod">
          <ac:chgData name="Yuying Liang" userId="jHfLqa0+NHnW/L3/y1HwdzoR61mtDz/AjzlijymjloY=" providerId="None" clId="Web-{5D263207-5A79-408E-BC24-853A4FF13710}" dt="2026-02-25T17:12:03.446" v="73" actId="1076"/>
          <ac:grpSpMkLst>
            <pc:docMk/>
            <pc:sldMk cId="423064511" sldId="267"/>
            <ac:grpSpMk id="7" creationId="{553BCDC8-539B-0245-B787-FC055969A03D}"/>
          </ac:grpSpMkLst>
        </pc:gr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117725" y="1143000"/>
            <a:ext cx="262255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i="0" u="none" strike="noStrike" cap="none" dirty="0">
                <a:solidFill>
                  <a:schemeClr val="dk1"/>
                </a:solidFill>
                <a:effectLst/>
                <a:latin typeface="Calibri"/>
                <a:cs typeface="Calibri"/>
                <a:sym typeface="Calibri"/>
              </a:rPr>
              <a:t>Supplemental Figure S1: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cs typeface="Calibri"/>
                <a:sym typeface="Calibri"/>
              </a:rPr>
              <a:t>Gating Strategy for </a:t>
            </a:r>
            <a:r>
              <a:rPr lang="en-US" sz="1200" b="1" i="0" u="none" strike="noStrike" cap="none" dirty="0">
                <a:solidFill>
                  <a:schemeClr val="dk1"/>
                </a:solidFill>
                <a:effectLst/>
                <a:latin typeface="Calibri"/>
                <a:cs typeface="Calibri"/>
                <a:sym typeface="Calibri"/>
              </a:rPr>
              <a:t>(A)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cs typeface="Calibri"/>
                <a:sym typeface="Calibri"/>
              </a:rPr>
              <a:t>Ag85B/MHC-II CD4 Tetramer and </a:t>
            </a:r>
            <a:r>
              <a:rPr lang="en-US" sz="1200" b="1" i="0" u="none" strike="noStrike" cap="none" dirty="0">
                <a:solidFill>
                  <a:schemeClr val="dk1"/>
                </a:solidFill>
                <a:effectLst/>
                <a:latin typeface="Calibri"/>
                <a:cs typeface="Calibri"/>
                <a:sym typeface="Calibri"/>
              </a:rPr>
              <a:t>(B)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cs typeface="Calibri"/>
                <a:sym typeface="Calibri"/>
              </a:rPr>
              <a:t>ESAT6/MHC-I CD8 Tetramer staining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fld>
            <a:endParaRPr lang="en-US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3101640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i="0" u="none" strike="noStrike" cap="none" dirty="0">
                <a:solidFill>
                  <a:schemeClr val="dk1"/>
                </a:solidFill>
                <a:effectLst/>
                <a:latin typeface="Calibri"/>
                <a:cs typeface="Calibri"/>
                <a:sym typeface="Calibri"/>
              </a:rPr>
              <a:t>Supplemental Figure S2: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cs typeface="Calibri"/>
                <a:sym typeface="Calibri"/>
              </a:rPr>
              <a:t>Gating Strategy for the Intracellular Cytokine Staining of double-positive Th1 CD4 T cells (</a:t>
            </a:r>
            <a:r>
              <a:rPr lang="en-US" sz="1200" b="1" i="0" u="none" strike="noStrike" cap="none" dirty="0">
                <a:solidFill>
                  <a:schemeClr val="dk1"/>
                </a:solidFill>
                <a:effectLst/>
                <a:latin typeface="Calibri"/>
                <a:cs typeface="Calibri"/>
                <a:sym typeface="Calibri"/>
              </a:rPr>
              <a:t>A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cs typeface="Calibri"/>
                <a:sym typeface="Calibri"/>
              </a:rPr>
              <a:t>) and IL-17-positive Th17 Cells (</a:t>
            </a:r>
            <a:r>
              <a:rPr lang="en-US" sz="1200" b="1" i="0" u="none" strike="noStrike" cap="none" dirty="0">
                <a:solidFill>
                  <a:schemeClr val="dk1"/>
                </a:solidFill>
                <a:effectLst/>
                <a:latin typeface="Calibri"/>
                <a:cs typeface="Calibri"/>
                <a:sym typeface="Calibri"/>
              </a:rPr>
              <a:t>B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cs typeface="Calibri"/>
                <a:sym typeface="Calibri"/>
              </a:rPr>
              <a:t>)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fld>
            <a:endParaRPr lang="en-US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6487391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10"/>
          <p:cNvSpPr txBox="1">
            <a:spLocks noGrp="1"/>
          </p:cNvSpPr>
          <p:nvPr>
            <p:ph type="ctrTitle"/>
          </p:nvPr>
        </p:nvSpPr>
        <p:spPr>
          <a:xfrm>
            <a:off x="466368" y="1197187"/>
            <a:ext cx="5285502" cy="25467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80"/>
              <a:buFont typeface="Calibri"/>
              <a:buNone/>
              <a:defRPr sz="408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10"/>
          <p:cNvSpPr txBox="1">
            <a:spLocks noGrp="1"/>
          </p:cNvSpPr>
          <p:nvPr>
            <p:ph type="subTitle" idx="1"/>
          </p:nvPr>
        </p:nvSpPr>
        <p:spPr>
          <a:xfrm>
            <a:off x="777280" y="3842174"/>
            <a:ext cx="4663679" cy="176614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1632"/>
              <a:buNone/>
              <a:defRPr sz="1632"/>
            </a:lvl1pPr>
            <a:lvl2pPr lvl="1" algn="ctr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360"/>
              <a:buNone/>
              <a:defRPr sz="1360"/>
            </a:lvl2pPr>
            <a:lvl3pPr lvl="2" algn="ctr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224"/>
              <a:buNone/>
              <a:defRPr sz="1224"/>
            </a:lvl3pPr>
            <a:lvl4pPr lvl="3" algn="ctr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088"/>
            </a:lvl4pPr>
            <a:lvl5pPr lvl="4" algn="ctr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088"/>
            </a:lvl5pPr>
            <a:lvl6pPr lvl="5" algn="ctr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088"/>
            </a:lvl6pPr>
            <a:lvl7pPr lvl="6" algn="ctr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088"/>
            </a:lvl7pPr>
            <a:lvl8pPr lvl="7" algn="ctr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088"/>
            </a:lvl8pPr>
            <a:lvl9pPr lvl="8" algn="ctr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088"/>
            </a:lvl9pPr>
          </a:lstStyle>
          <a:p>
            <a:endParaRPr/>
          </a:p>
        </p:txBody>
      </p:sp>
      <p:sp>
        <p:nvSpPr>
          <p:cNvPr id="18" name="Google Shape;18;p10"/>
          <p:cNvSpPr txBox="1">
            <a:spLocks noGrp="1"/>
          </p:cNvSpPr>
          <p:nvPr>
            <p:ph type="dt" idx="10"/>
          </p:nvPr>
        </p:nvSpPr>
        <p:spPr>
          <a:xfrm>
            <a:off x="427504" y="6780108"/>
            <a:ext cx="1399104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10"/>
          <p:cNvSpPr txBox="1">
            <a:spLocks noGrp="1"/>
          </p:cNvSpPr>
          <p:nvPr>
            <p:ph type="ftr" idx="11"/>
          </p:nvPr>
        </p:nvSpPr>
        <p:spPr>
          <a:xfrm>
            <a:off x="2059792" y="6780108"/>
            <a:ext cx="2098655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10"/>
          <p:cNvSpPr txBox="1">
            <a:spLocks noGrp="1"/>
          </p:cNvSpPr>
          <p:nvPr>
            <p:ph type="sldNum" idx="12"/>
          </p:nvPr>
        </p:nvSpPr>
        <p:spPr>
          <a:xfrm>
            <a:off x="4391630" y="6780108"/>
            <a:ext cx="1399104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11"/>
          <p:cNvSpPr txBox="1">
            <a:spLocks noGrp="1"/>
          </p:cNvSpPr>
          <p:nvPr>
            <p:ph type="title"/>
          </p:nvPr>
        </p:nvSpPr>
        <p:spPr>
          <a:xfrm>
            <a:off x="427504" y="389468"/>
            <a:ext cx="5363230" cy="14139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1"/>
          <p:cNvSpPr txBox="1">
            <a:spLocks noGrp="1"/>
          </p:cNvSpPr>
          <p:nvPr>
            <p:ph type="body" idx="1"/>
          </p:nvPr>
        </p:nvSpPr>
        <p:spPr>
          <a:xfrm>
            <a:off x="427504" y="1947333"/>
            <a:ext cx="5363230" cy="46414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11"/>
          <p:cNvSpPr txBox="1">
            <a:spLocks noGrp="1"/>
          </p:cNvSpPr>
          <p:nvPr>
            <p:ph type="dt" idx="10"/>
          </p:nvPr>
        </p:nvSpPr>
        <p:spPr>
          <a:xfrm>
            <a:off x="427504" y="6780108"/>
            <a:ext cx="1399104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1"/>
          <p:cNvSpPr txBox="1">
            <a:spLocks noGrp="1"/>
          </p:cNvSpPr>
          <p:nvPr>
            <p:ph type="ftr" idx="11"/>
          </p:nvPr>
        </p:nvSpPr>
        <p:spPr>
          <a:xfrm>
            <a:off x="2059792" y="6780108"/>
            <a:ext cx="2098655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11"/>
          <p:cNvSpPr txBox="1">
            <a:spLocks noGrp="1"/>
          </p:cNvSpPr>
          <p:nvPr>
            <p:ph type="sldNum" idx="12"/>
          </p:nvPr>
        </p:nvSpPr>
        <p:spPr>
          <a:xfrm>
            <a:off x="4391630" y="6780108"/>
            <a:ext cx="1399104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13"/>
          <p:cNvSpPr txBox="1">
            <a:spLocks noGrp="1"/>
          </p:cNvSpPr>
          <p:nvPr>
            <p:ph type="title"/>
          </p:nvPr>
        </p:nvSpPr>
        <p:spPr>
          <a:xfrm>
            <a:off x="424266" y="1823722"/>
            <a:ext cx="5363230" cy="304291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80"/>
              <a:buFont typeface="Calibri"/>
              <a:buNone/>
              <a:defRPr sz="408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3"/>
          <p:cNvSpPr txBox="1">
            <a:spLocks noGrp="1"/>
          </p:cNvSpPr>
          <p:nvPr>
            <p:ph type="body" idx="1"/>
          </p:nvPr>
        </p:nvSpPr>
        <p:spPr>
          <a:xfrm>
            <a:off x="424266" y="4895429"/>
            <a:ext cx="5363230" cy="16001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1632"/>
              <a:buNone/>
              <a:defRPr sz="1632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rgbClr val="888888"/>
              </a:buClr>
              <a:buSzPts val="1360"/>
              <a:buNone/>
              <a:defRPr sz="136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rgbClr val="888888"/>
              </a:buClr>
              <a:buSzPts val="1224"/>
              <a:buNone/>
              <a:defRPr sz="1224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rgbClr val="888888"/>
              </a:buClr>
              <a:buSzPts val="1088"/>
              <a:buNone/>
              <a:defRPr sz="1088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rgbClr val="888888"/>
              </a:buClr>
              <a:buSzPts val="1088"/>
              <a:buNone/>
              <a:defRPr sz="1088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rgbClr val="888888"/>
              </a:buClr>
              <a:buSzPts val="1088"/>
              <a:buNone/>
              <a:defRPr sz="1088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rgbClr val="888888"/>
              </a:buClr>
              <a:buSzPts val="1088"/>
              <a:buNone/>
              <a:defRPr sz="1088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rgbClr val="888888"/>
              </a:buClr>
              <a:buSzPts val="1088"/>
              <a:buNone/>
              <a:defRPr sz="1088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rgbClr val="888888"/>
              </a:buClr>
              <a:buSzPts val="1088"/>
              <a:buNone/>
              <a:defRPr sz="1088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13"/>
          <p:cNvSpPr txBox="1">
            <a:spLocks noGrp="1"/>
          </p:cNvSpPr>
          <p:nvPr>
            <p:ph type="dt" idx="10"/>
          </p:nvPr>
        </p:nvSpPr>
        <p:spPr>
          <a:xfrm>
            <a:off x="427504" y="6780108"/>
            <a:ext cx="1399104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3"/>
          <p:cNvSpPr txBox="1">
            <a:spLocks noGrp="1"/>
          </p:cNvSpPr>
          <p:nvPr>
            <p:ph type="ftr" idx="11"/>
          </p:nvPr>
        </p:nvSpPr>
        <p:spPr>
          <a:xfrm>
            <a:off x="2059792" y="6780108"/>
            <a:ext cx="2098655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3"/>
          <p:cNvSpPr txBox="1">
            <a:spLocks noGrp="1"/>
          </p:cNvSpPr>
          <p:nvPr>
            <p:ph type="sldNum" idx="12"/>
          </p:nvPr>
        </p:nvSpPr>
        <p:spPr>
          <a:xfrm>
            <a:off x="4391630" y="6780108"/>
            <a:ext cx="1399104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14"/>
          <p:cNvSpPr txBox="1">
            <a:spLocks noGrp="1"/>
          </p:cNvSpPr>
          <p:nvPr>
            <p:ph type="title"/>
          </p:nvPr>
        </p:nvSpPr>
        <p:spPr>
          <a:xfrm>
            <a:off x="427504" y="389468"/>
            <a:ext cx="5363230" cy="14139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4"/>
          <p:cNvSpPr txBox="1">
            <a:spLocks noGrp="1"/>
          </p:cNvSpPr>
          <p:nvPr>
            <p:ph type="body" idx="1"/>
          </p:nvPr>
        </p:nvSpPr>
        <p:spPr>
          <a:xfrm>
            <a:off x="427504" y="1947333"/>
            <a:ext cx="2642751" cy="46414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4"/>
          <p:cNvSpPr txBox="1">
            <a:spLocks noGrp="1"/>
          </p:cNvSpPr>
          <p:nvPr>
            <p:ph type="body" idx="2"/>
          </p:nvPr>
        </p:nvSpPr>
        <p:spPr>
          <a:xfrm>
            <a:off x="3147983" y="1947333"/>
            <a:ext cx="2642751" cy="46414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14"/>
          <p:cNvSpPr txBox="1">
            <a:spLocks noGrp="1"/>
          </p:cNvSpPr>
          <p:nvPr>
            <p:ph type="dt" idx="10"/>
          </p:nvPr>
        </p:nvSpPr>
        <p:spPr>
          <a:xfrm>
            <a:off x="427504" y="6780108"/>
            <a:ext cx="1399104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4"/>
          <p:cNvSpPr txBox="1">
            <a:spLocks noGrp="1"/>
          </p:cNvSpPr>
          <p:nvPr>
            <p:ph type="ftr" idx="11"/>
          </p:nvPr>
        </p:nvSpPr>
        <p:spPr>
          <a:xfrm>
            <a:off x="2059792" y="6780108"/>
            <a:ext cx="2098655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4"/>
          <p:cNvSpPr txBox="1">
            <a:spLocks noGrp="1"/>
          </p:cNvSpPr>
          <p:nvPr>
            <p:ph type="sldNum" idx="12"/>
          </p:nvPr>
        </p:nvSpPr>
        <p:spPr>
          <a:xfrm>
            <a:off x="4391630" y="6780108"/>
            <a:ext cx="1399104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5"/>
          <p:cNvSpPr txBox="1">
            <a:spLocks noGrp="1"/>
          </p:cNvSpPr>
          <p:nvPr>
            <p:ph type="title"/>
          </p:nvPr>
        </p:nvSpPr>
        <p:spPr>
          <a:xfrm>
            <a:off x="428314" y="389468"/>
            <a:ext cx="5363230" cy="14139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15"/>
          <p:cNvSpPr txBox="1">
            <a:spLocks noGrp="1"/>
          </p:cNvSpPr>
          <p:nvPr>
            <p:ph type="body" idx="1"/>
          </p:nvPr>
        </p:nvSpPr>
        <p:spPr>
          <a:xfrm>
            <a:off x="428314" y="1793241"/>
            <a:ext cx="2630606" cy="87883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1632"/>
              <a:buNone/>
              <a:defRPr sz="1632" b="1"/>
            </a:lvl1pPr>
            <a:lvl2pPr marL="914400" lvl="1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360"/>
              <a:buNone/>
              <a:defRPr sz="1360" b="1"/>
            </a:lvl2pPr>
            <a:lvl3pPr marL="1371600" lvl="2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224"/>
              <a:buNone/>
              <a:defRPr sz="1224" b="1"/>
            </a:lvl3pPr>
            <a:lvl4pPr marL="1828800" lvl="3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088" b="1"/>
            </a:lvl4pPr>
            <a:lvl5pPr marL="2286000" lvl="4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088" b="1"/>
            </a:lvl5pPr>
            <a:lvl6pPr marL="2743200" lvl="5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088" b="1"/>
            </a:lvl6pPr>
            <a:lvl7pPr marL="3200400" lvl="6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088" b="1"/>
            </a:lvl7pPr>
            <a:lvl8pPr marL="3657600" lvl="7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088" b="1"/>
            </a:lvl8pPr>
            <a:lvl9pPr marL="4114800" lvl="8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088" b="1"/>
            </a:lvl9pPr>
          </a:lstStyle>
          <a:p>
            <a:endParaRPr/>
          </a:p>
        </p:txBody>
      </p:sp>
      <p:sp>
        <p:nvSpPr>
          <p:cNvPr id="47" name="Google Shape;47;p15"/>
          <p:cNvSpPr txBox="1">
            <a:spLocks noGrp="1"/>
          </p:cNvSpPr>
          <p:nvPr>
            <p:ph type="body" idx="2"/>
          </p:nvPr>
        </p:nvSpPr>
        <p:spPr>
          <a:xfrm>
            <a:off x="428314" y="2672080"/>
            <a:ext cx="2630606" cy="39302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15"/>
          <p:cNvSpPr txBox="1">
            <a:spLocks noGrp="1"/>
          </p:cNvSpPr>
          <p:nvPr>
            <p:ph type="body" idx="3"/>
          </p:nvPr>
        </p:nvSpPr>
        <p:spPr>
          <a:xfrm>
            <a:off x="3147983" y="1793241"/>
            <a:ext cx="2643561" cy="87883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1632"/>
              <a:buNone/>
              <a:defRPr sz="1632" b="1"/>
            </a:lvl1pPr>
            <a:lvl2pPr marL="914400" lvl="1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360"/>
              <a:buNone/>
              <a:defRPr sz="1360" b="1"/>
            </a:lvl2pPr>
            <a:lvl3pPr marL="1371600" lvl="2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224"/>
              <a:buNone/>
              <a:defRPr sz="1224" b="1"/>
            </a:lvl3pPr>
            <a:lvl4pPr marL="1828800" lvl="3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088" b="1"/>
            </a:lvl4pPr>
            <a:lvl5pPr marL="2286000" lvl="4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088" b="1"/>
            </a:lvl5pPr>
            <a:lvl6pPr marL="2743200" lvl="5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088" b="1"/>
            </a:lvl6pPr>
            <a:lvl7pPr marL="3200400" lvl="6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088" b="1"/>
            </a:lvl7pPr>
            <a:lvl8pPr marL="3657600" lvl="7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088" b="1"/>
            </a:lvl8pPr>
            <a:lvl9pPr marL="4114800" lvl="8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088" b="1"/>
            </a:lvl9pPr>
          </a:lstStyle>
          <a:p>
            <a:endParaRPr/>
          </a:p>
        </p:txBody>
      </p:sp>
      <p:sp>
        <p:nvSpPr>
          <p:cNvPr id="49" name="Google Shape;49;p15"/>
          <p:cNvSpPr txBox="1">
            <a:spLocks noGrp="1"/>
          </p:cNvSpPr>
          <p:nvPr>
            <p:ph type="body" idx="4"/>
          </p:nvPr>
        </p:nvSpPr>
        <p:spPr>
          <a:xfrm>
            <a:off x="3147983" y="2672080"/>
            <a:ext cx="2643561" cy="39302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15"/>
          <p:cNvSpPr txBox="1">
            <a:spLocks noGrp="1"/>
          </p:cNvSpPr>
          <p:nvPr>
            <p:ph type="dt" idx="10"/>
          </p:nvPr>
        </p:nvSpPr>
        <p:spPr>
          <a:xfrm>
            <a:off x="427504" y="6780108"/>
            <a:ext cx="1399104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5"/>
          <p:cNvSpPr txBox="1">
            <a:spLocks noGrp="1"/>
          </p:cNvSpPr>
          <p:nvPr>
            <p:ph type="ftr" idx="11"/>
          </p:nvPr>
        </p:nvSpPr>
        <p:spPr>
          <a:xfrm>
            <a:off x="2059792" y="6780108"/>
            <a:ext cx="2098655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5"/>
          <p:cNvSpPr txBox="1">
            <a:spLocks noGrp="1"/>
          </p:cNvSpPr>
          <p:nvPr>
            <p:ph type="sldNum" idx="12"/>
          </p:nvPr>
        </p:nvSpPr>
        <p:spPr>
          <a:xfrm>
            <a:off x="4391630" y="6780108"/>
            <a:ext cx="1399104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7"/>
          <p:cNvSpPr txBox="1">
            <a:spLocks noGrp="1"/>
          </p:cNvSpPr>
          <p:nvPr>
            <p:ph type="title"/>
          </p:nvPr>
        </p:nvSpPr>
        <p:spPr>
          <a:xfrm>
            <a:off x="428314" y="487680"/>
            <a:ext cx="2005544" cy="1706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176"/>
              <a:buFont typeface="Calibri"/>
              <a:buNone/>
              <a:defRPr sz="2176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7"/>
          <p:cNvSpPr txBox="1">
            <a:spLocks noGrp="1"/>
          </p:cNvSpPr>
          <p:nvPr>
            <p:ph type="body" idx="1"/>
          </p:nvPr>
        </p:nvSpPr>
        <p:spPr>
          <a:xfrm>
            <a:off x="2643561" y="1053255"/>
            <a:ext cx="3147983" cy="51985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66776" algn="l">
              <a:lnSpc>
                <a:spcPct val="90000"/>
              </a:lnSpc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2176"/>
              <a:buChar char="•"/>
              <a:defRPr sz="2176"/>
            </a:lvl1pPr>
            <a:lvl2pPr marL="914400" lvl="1" indent="-349504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904"/>
              <a:buChar char="•"/>
              <a:defRPr sz="1904"/>
            </a:lvl2pPr>
            <a:lvl3pPr marL="1371600" lvl="2" indent="-332232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632"/>
              <a:buChar char="•"/>
              <a:defRPr sz="1632"/>
            </a:lvl3pPr>
            <a:lvl4pPr marL="1828800" lvl="3" indent="-31496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360"/>
              <a:buChar char="•"/>
              <a:defRPr sz="1360"/>
            </a:lvl4pPr>
            <a:lvl5pPr marL="2286000" lvl="4" indent="-31496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360"/>
              <a:buChar char="•"/>
              <a:defRPr sz="1360"/>
            </a:lvl5pPr>
            <a:lvl6pPr marL="2743200" lvl="5" indent="-31496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360"/>
              <a:buChar char="•"/>
              <a:defRPr sz="1360"/>
            </a:lvl6pPr>
            <a:lvl7pPr marL="3200400" lvl="6" indent="-31496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360"/>
              <a:buChar char="•"/>
              <a:defRPr sz="1360"/>
            </a:lvl7pPr>
            <a:lvl8pPr marL="3657600" lvl="7" indent="-314959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360"/>
              <a:buChar char="•"/>
              <a:defRPr sz="1360"/>
            </a:lvl8pPr>
            <a:lvl9pPr marL="4114800" lvl="8" indent="-314959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360"/>
              <a:buChar char="•"/>
              <a:defRPr sz="1360"/>
            </a:lvl9pPr>
          </a:lstStyle>
          <a:p>
            <a:endParaRPr/>
          </a:p>
        </p:txBody>
      </p:sp>
      <p:sp>
        <p:nvSpPr>
          <p:cNvPr id="61" name="Google Shape;61;p17"/>
          <p:cNvSpPr txBox="1">
            <a:spLocks noGrp="1"/>
          </p:cNvSpPr>
          <p:nvPr>
            <p:ph type="body" idx="2"/>
          </p:nvPr>
        </p:nvSpPr>
        <p:spPr>
          <a:xfrm>
            <a:off x="428314" y="2194560"/>
            <a:ext cx="2005544" cy="406569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088"/>
            </a:lvl1pPr>
            <a:lvl2pPr marL="914400" lvl="1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952"/>
              <a:buNone/>
              <a:defRPr sz="952"/>
            </a:lvl2pPr>
            <a:lvl3pPr marL="1371600" lvl="2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816"/>
              <a:buNone/>
              <a:defRPr sz="816"/>
            </a:lvl3pPr>
            <a:lvl4pPr marL="1828800" lvl="3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680"/>
              <a:buNone/>
              <a:defRPr sz="680"/>
            </a:lvl4pPr>
            <a:lvl5pPr marL="2286000" lvl="4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680"/>
              <a:buNone/>
              <a:defRPr sz="680"/>
            </a:lvl5pPr>
            <a:lvl6pPr marL="2743200" lvl="5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680"/>
              <a:buNone/>
              <a:defRPr sz="680"/>
            </a:lvl6pPr>
            <a:lvl7pPr marL="3200400" lvl="6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680"/>
              <a:buNone/>
              <a:defRPr sz="680"/>
            </a:lvl7pPr>
            <a:lvl8pPr marL="3657600" lvl="7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680"/>
              <a:buNone/>
              <a:defRPr sz="680"/>
            </a:lvl8pPr>
            <a:lvl9pPr marL="4114800" lvl="8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680"/>
              <a:buNone/>
              <a:defRPr sz="680"/>
            </a:lvl9pPr>
          </a:lstStyle>
          <a:p>
            <a:endParaRPr/>
          </a:p>
        </p:txBody>
      </p:sp>
      <p:sp>
        <p:nvSpPr>
          <p:cNvPr id="62" name="Google Shape;62;p17"/>
          <p:cNvSpPr txBox="1">
            <a:spLocks noGrp="1"/>
          </p:cNvSpPr>
          <p:nvPr>
            <p:ph type="dt" idx="10"/>
          </p:nvPr>
        </p:nvSpPr>
        <p:spPr>
          <a:xfrm>
            <a:off x="427504" y="6780108"/>
            <a:ext cx="1399104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7"/>
          <p:cNvSpPr txBox="1">
            <a:spLocks noGrp="1"/>
          </p:cNvSpPr>
          <p:nvPr>
            <p:ph type="ftr" idx="11"/>
          </p:nvPr>
        </p:nvSpPr>
        <p:spPr>
          <a:xfrm>
            <a:off x="2059792" y="6780108"/>
            <a:ext cx="2098655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7"/>
          <p:cNvSpPr txBox="1">
            <a:spLocks noGrp="1"/>
          </p:cNvSpPr>
          <p:nvPr>
            <p:ph type="sldNum" idx="12"/>
          </p:nvPr>
        </p:nvSpPr>
        <p:spPr>
          <a:xfrm>
            <a:off x="4391630" y="6780108"/>
            <a:ext cx="1399104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8"/>
          <p:cNvSpPr txBox="1">
            <a:spLocks noGrp="1"/>
          </p:cNvSpPr>
          <p:nvPr>
            <p:ph type="title"/>
          </p:nvPr>
        </p:nvSpPr>
        <p:spPr>
          <a:xfrm>
            <a:off x="428314" y="487680"/>
            <a:ext cx="2005544" cy="1706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176"/>
              <a:buFont typeface="Calibri"/>
              <a:buNone/>
              <a:defRPr sz="2176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8"/>
          <p:cNvSpPr>
            <a:spLocks noGrp="1"/>
          </p:cNvSpPr>
          <p:nvPr>
            <p:ph type="pic" idx="2"/>
          </p:nvPr>
        </p:nvSpPr>
        <p:spPr>
          <a:xfrm>
            <a:off x="2643561" y="1053255"/>
            <a:ext cx="3147983" cy="5198533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8"/>
          <p:cNvSpPr txBox="1">
            <a:spLocks noGrp="1"/>
          </p:cNvSpPr>
          <p:nvPr>
            <p:ph type="body" idx="1"/>
          </p:nvPr>
        </p:nvSpPr>
        <p:spPr>
          <a:xfrm>
            <a:off x="428314" y="2194560"/>
            <a:ext cx="2005544" cy="406569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088"/>
            </a:lvl1pPr>
            <a:lvl2pPr marL="914400" lvl="1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952"/>
              <a:buNone/>
              <a:defRPr sz="952"/>
            </a:lvl2pPr>
            <a:lvl3pPr marL="1371600" lvl="2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816"/>
              <a:buNone/>
              <a:defRPr sz="816"/>
            </a:lvl3pPr>
            <a:lvl4pPr marL="1828800" lvl="3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680"/>
              <a:buNone/>
              <a:defRPr sz="680"/>
            </a:lvl4pPr>
            <a:lvl5pPr marL="2286000" lvl="4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680"/>
              <a:buNone/>
              <a:defRPr sz="680"/>
            </a:lvl5pPr>
            <a:lvl6pPr marL="2743200" lvl="5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680"/>
              <a:buNone/>
              <a:defRPr sz="680"/>
            </a:lvl6pPr>
            <a:lvl7pPr marL="3200400" lvl="6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680"/>
              <a:buNone/>
              <a:defRPr sz="680"/>
            </a:lvl7pPr>
            <a:lvl8pPr marL="3657600" lvl="7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680"/>
              <a:buNone/>
              <a:defRPr sz="680"/>
            </a:lvl8pPr>
            <a:lvl9pPr marL="4114800" lvl="8" indent="-2286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680"/>
              <a:buNone/>
              <a:defRPr sz="680"/>
            </a:lvl9pPr>
          </a:lstStyle>
          <a:p>
            <a:endParaRPr/>
          </a:p>
        </p:txBody>
      </p:sp>
      <p:sp>
        <p:nvSpPr>
          <p:cNvPr id="69" name="Google Shape;69;p18"/>
          <p:cNvSpPr txBox="1">
            <a:spLocks noGrp="1"/>
          </p:cNvSpPr>
          <p:nvPr>
            <p:ph type="dt" idx="10"/>
          </p:nvPr>
        </p:nvSpPr>
        <p:spPr>
          <a:xfrm>
            <a:off x="427504" y="6780108"/>
            <a:ext cx="1399104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8"/>
          <p:cNvSpPr txBox="1">
            <a:spLocks noGrp="1"/>
          </p:cNvSpPr>
          <p:nvPr>
            <p:ph type="ftr" idx="11"/>
          </p:nvPr>
        </p:nvSpPr>
        <p:spPr>
          <a:xfrm>
            <a:off x="2059792" y="6780108"/>
            <a:ext cx="2098655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8"/>
          <p:cNvSpPr txBox="1">
            <a:spLocks noGrp="1"/>
          </p:cNvSpPr>
          <p:nvPr>
            <p:ph type="sldNum" idx="12"/>
          </p:nvPr>
        </p:nvSpPr>
        <p:spPr>
          <a:xfrm>
            <a:off x="4391630" y="6780108"/>
            <a:ext cx="1399104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9"/>
          <p:cNvSpPr txBox="1">
            <a:spLocks noGrp="1"/>
          </p:cNvSpPr>
          <p:nvPr>
            <p:ph type="title"/>
          </p:nvPr>
        </p:nvSpPr>
        <p:spPr>
          <a:xfrm>
            <a:off x="427504" y="389468"/>
            <a:ext cx="5363230" cy="14139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9"/>
          <p:cNvSpPr txBox="1">
            <a:spLocks noGrp="1"/>
          </p:cNvSpPr>
          <p:nvPr>
            <p:ph type="body" idx="1"/>
          </p:nvPr>
        </p:nvSpPr>
        <p:spPr>
          <a:xfrm rot="5400000">
            <a:off x="788406" y="1586431"/>
            <a:ext cx="4641427" cy="53632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9"/>
          <p:cNvSpPr txBox="1">
            <a:spLocks noGrp="1"/>
          </p:cNvSpPr>
          <p:nvPr>
            <p:ph type="dt" idx="10"/>
          </p:nvPr>
        </p:nvSpPr>
        <p:spPr>
          <a:xfrm>
            <a:off x="427504" y="6780108"/>
            <a:ext cx="1399104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9"/>
          <p:cNvSpPr txBox="1">
            <a:spLocks noGrp="1"/>
          </p:cNvSpPr>
          <p:nvPr>
            <p:ph type="ftr" idx="11"/>
          </p:nvPr>
        </p:nvSpPr>
        <p:spPr>
          <a:xfrm>
            <a:off x="2059792" y="6780108"/>
            <a:ext cx="2098655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9"/>
          <p:cNvSpPr txBox="1">
            <a:spLocks noGrp="1"/>
          </p:cNvSpPr>
          <p:nvPr>
            <p:ph type="sldNum" idx="12"/>
          </p:nvPr>
        </p:nvSpPr>
        <p:spPr>
          <a:xfrm>
            <a:off x="4391630" y="6780108"/>
            <a:ext cx="1399104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0"/>
          <p:cNvSpPr txBox="1">
            <a:spLocks noGrp="1"/>
          </p:cNvSpPr>
          <p:nvPr>
            <p:ph type="title"/>
          </p:nvPr>
        </p:nvSpPr>
        <p:spPr>
          <a:xfrm rot="5400000">
            <a:off x="2020684" y="2818710"/>
            <a:ext cx="6199294" cy="134080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0"/>
          <p:cNvSpPr txBox="1">
            <a:spLocks noGrp="1"/>
          </p:cNvSpPr>
          <p:nvPr>
            <p:ph type="body" idx="1"/>
          </p:nvPr>
        </p:nvSpPr>
        <p:spPr>
          <a:xfrm rot="5400000">
            <a:off x="-699796" y="1516767"/>
            <a:ext cx="6199294" cy="39446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0"/>
          <p:cNvSpPr txBox="1">
            <a:spLocks noGrp="1"/>
          </p:cNvSpPr>
          <p:nvPr>
            <p:ph type="dt" idx="10"/>
          </p:nvPr>
        </p:nvSpPr>
        <p:spPr>
          <a:xfrm>
            <a:off x="427504" y="6780108"/>
            <a:ext cx="1399104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0"/>
          <p:cNvSpPr txBox="1">
            <a:spLocks noGrp="1"/>
          </p:cNvSpPr>
          <p:nvPr>
            <p:ph type="ftr" idx="11"/>
          </p:nvPr>
        </p:nvSpPr>
        <p:spPr>
          <a:xfrm>
            <a:off x="2059792" y="6780108"/>
            <a:ext cx="2098655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0"/>
          <p:cNvSpPr txBox="1">
            <a:spLocks noGrp="1"/>
          </p:cNvSpPr>
          <p:nvPr>
            <p:ph type="sldNum" idx="12"/>
          </p:nvPr>
        </p:nvSpPr>
        <p:spPr>
          <a:xfrm>
            <a:off x="4391630" y="6780108"/>
            <a:ext cx="1399104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9"/>
          <p:cNvSpPr txBox="1">
            <a:spLocks noGrp="1"/>
          </p:cNvSpPr>
          <p:nvPr>
            <p:ph type="title"/>
          </p:nvPr>
        </p:nvSpPr>
        <p:spPr>
          <a:xfrm>
            <a:off x="427504" y="389468"/>
            <a:ext cx="5363230" cy="14139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992"/>
              <a:buFont typeface="Calibri"/>
              <a:buNone/>
              <a:defRPr sz="2992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9"/>
          <p:cNvSpPr txBox="1">
            <a:spLocks noGrp="1"/>
          </p:cNvSpPr>
          <p:nvPr>
            <p:ph type="body" idx="1"/>
          </p:nvPr>
        </p:nvSpPr>
        <p:spPr>
          <a:xfrm>
            <a:off x="427504" y="1947333"/>
            <a:ext cx="5363230" cy="46414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49504" algn="l" rtl="0">
              <a:lnSpc>
                <a:spcPct val="90000"/>
              </a:lnSpc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1904"/>
              <a:buFont typeface="Arial"/>
              <a:buChar char="•"/>
              <a:defRPr sz="190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32232" algn="l" rtl="0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632"/>
              <a:buFont typeface="Arial"/>
              <a:buChar char="•"/>
              <a:defRPr sz="1632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14960" algn="l" rtl="0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360"/>
              <a:buFont typeface="Arial"/>
              <a:buChar char="•"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06324" algn="l" rtl="0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224"/>
              <a:buFont typeface="Arial"/>
              <a:buChar char="•"/>
              <a:defRPr sz="122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06323" algn="l" rtl="0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224"/>
              <a:buFont typeface="Arial"/>
              <a:buChar char="•"/>
              <a:defRPr sz="122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06323" algn="l" rtl="0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224"/>
              <a:buFont typeface="Arial"/>
              <a:buChar char="•"/>
              <a:defRPr sz="122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06323" algn="l" rtl="0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224"/>
              <a:buFont typeface="Arial"/>
              <a:buChar char="•"/>
              <a:defRPr sz="122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06323" algn="l" rtl="0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224"/>
              <a:buFont typeface="Arial"/>
              <a:buChar char="•"/>
              <a:defRPr sz="122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06323" algn="l" rtl="0">
              <a:lnSpc>
                <a:spcPct val="90000"/>
              </a:lnSpc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224"/>
              <a:buFont typeface="Arial"/>
              <a:buChar char="•"/>
              <a:defRPr sz="122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9"/>
          <p:cNvSpPr txBox="1">
            <a:spLocks noGrp="1"/>
          </p:cNvSpPr>
          <p:nvPr>
            <p:ph type="dt" idx="10"/>
          </p:nvPr>
        </p:nvSpPr>
        <p:spPr>
          <a:xfrm>
            <a:off x="427504" y="6780108"/>
            <a:ext cx="1399104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81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9"/>
          <p:cNvSpPr txBox="1">
            <a:spLocks noGrp="1"/>
          </p:cNvSpPr>
          <p:nvPr>
            <p:ph type="ftr" idx="11"/>
          </p:nvPr>
        </p:nvSpPr>
        <p:spPr>
          <a:xfrm>
            <a:off x="2059792" y="6780108"/>
            <a:ext cx="2098655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81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9"/>
          <p:cNvSpPr txBox="1">
            <a:spLocks noGrp="1"/>
          </p:cNvSpPr>
          <p:nvPr>
            <p:ph type="sldNum" idx="12"/>
          </p:nvPr>
        </p:nvSpPr>
        <p:spPr>
          <a:xfrm>
            <a:off x="4391630" y="6780108"/>
            <a:ext cx="1399104" cy="389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81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81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81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81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81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81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81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81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81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2" r:id="rId3"/>
    <p:sldLayoutId id="2147483653" r:id="rId4"/>
    <p:sldLayoutId id="2147483654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E9FF416-EEFF-CE19-5298-746DEA5B32F9}"/>
              </a:ext>
            </a:extLst>
          </p:cNvPr>
          <p:cNvSpPr txBox="1"/>
          <p:nvPr/>
        </p:nvSpPr>
        <p:spPr>
          <a:xfrm>
            <a:off x="87563" y="164261"/>
            <a:ext cx="16930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dk1"/>
                </a:solidFill>
                <a:latin typeface="Calibri"/>
                <a:cs typeface="Calibri"/>
                <a:sym typeface="Calibri"/>
              </a:rPr>
              <a:t>Supplemental Figure S1</a:t>
            </a:r>
            <a:endParaRPr lang="en-US" sz="1200" b="1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B531C77-987D-8746-A4F5-8AC0BC8BD6B0}"/>
              </a:ext>
            </a:extLst>
          </p:cNvPr>
          <p:cNvSpPr txBox="1"/>
          <p:nvPr/>
        </p:nvSpPr>
        <p:spPr>
          <a:xfrm>
            <a:off x="24446" y="497312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.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6271395-56ED-CF43-AA4F-2ACB93C91082}"/>
              </a:ext>
            </a:extLst>
          </p:cNvPr>
          <p:cNvSpPr txBox="1"/>
          <p:nvPr/>
        </p:nvSpPr>
        <p:spPr>
          <a:xfrm>
            <a:off x="0" y="199651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.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E36D6E59-9795-9246-80A8-3F43BAD7D8D1}"/>
              </a:ext>
            </a:extLst>
          </p:cNvPr>
          <p:cNvGrpSpPr/>
          <p:nvPr/>
        </p:nvGrpSpPr>
        <p:grpSpPr>
          <a:xfrm>
            <a:off x="24446" y="718259"/>
            <a:ext cx="6280936" cy="1099919"/>
            <a:chOff x="24446" y="1016861"/>
            <a:chExt cx="6280936" cy="1099919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3F70E83-41A2-2A40-90AD-9170333F2E46}"/>
                </a:ext>
              </a:extLst>
            </p:cNvPr>
            <p:cNvSpPr txBox="1"/>
            <p:nvPr/>
          </p:nvSpPr>
          <p:spPr>
            <a:xfrm>
              <a:off x="122274" y="1090227"/>
              <a:ext cx="8095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Lymphocytes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1C4033AC-A1F6-654B-8B77-092523ADD2FD}"/>
                </a:ext>
              </a:extLst>
            </p:cNvPr>
            <p:cNvSpPr txBox="1"/>
            <p:nvPr/>
          </p:nvSpPr>
          <p:spPr>
            <a:xfrm>
              <a:off x="1003398" y="1016861"/>
              <a:ext cx="80957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/>
                <a:t>Single Cell SSC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98AB6177-4862-254F-9FE0-5A70104AAA24}"/>
                </a:ext>
              </a:extLst>
            </p:cNvPr>
            <p:cNvSpPr txBox="1"/>
            <p:nvPr/>
          </p:nvSpPr>
          <p:spPr>
            <a:xfrm>
              <a:off x="1873588" y="1016861"/>
              <a:ext cx="80957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/>
                <a:t>Single Cell FSC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ACF7071C-DF97-4246-8B8B-267CDDEFFB8C}"/>
                </a:ext>
              </a:extLst>
            </p:cNvPr>
            <p:cNvSpPr txBox="1"/>
            <p:nvPr/>
          </p:nvSpPr>
          <p:spPr>
            <a:xfrm>
              <a:off x="2813434" y="1107838"/>
              <a:ext cx="8095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Live/Dead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4F8C2F90-8F16-FA4F-A74A-6203B5E354C1}"/>
                </a:ext>
              </a:extLst>
            </p:cNvPr>
            <p:cNvSpPr txBox="1"/>
            <p:nvPr/>
          </p:nvSpPr>
          <p:spPr>
            <a:xfrm>
              <a:off x="3796721" y="1103850"/>
              <a:ext cx="4196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CD3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71B106A2-2518-934E-A659-0C5DE45055E7}"/>
                </a:ext>
              </a:extLst>
            </p:cNvPr>
            <p:cNvSpPr txBox="1"/>
            <p:nvPr/>
          </p:nvSpPr>
          <p:spPr>
            <a:xfrm>
              <a:off x="4548066" y="1102800"/>
              <a:ext cx="6927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CD8/CD4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932A0D75-FDA5-1D46-989E-26F028342970}"/>
                </a:ext>
              </a:extLst>
            </p:cNvPr>
            <p:cNvSpPr txBox="1"/>
            <p:nvPr/>
          </p:nvSpPr>
          <p:spPr>
            <a:xfrm>
              <a:off x="5356851" y="1102800"/>
              <a:ext cx="9485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CD4 Tetramer</a:t>
              </a:r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29E133E5-05F1-2444-9C35-1391E930456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15" t="5206" r="422" b="8255"/>
            <a:stretch/>
          </p:blipFill>
          <p:spPr>
            <a:xfrm>
              <a:off x="24446" y="1286171"/>
              <a:ext cx="6141404" cy="830609"/>
            </a:xfrm>
            <a:prstGeom prst="rect">
              <a:avLst/>
            </a:prstGeom>
          </p:spPr>
        </p:pic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27E8DD91-9FC6-E14E-849F-5DB8EE35F3D6}"/>
              </a:ext>
            </a:extLst>
          </p:cNvPr>
          <p:cNvGrpSpPr/>
          <p:nvPr/>
        </p:nvGrpSpPr>
        <p:grpSpPr>
          <a:xfrm>
            <a:off x="19160" y="2266372"/>
            <a:ext cx="6220709" cy="1133621"/>
            <a:chOff x="19160" y="2266372"/>
            <a:chExt cx="6220709" cy="1133621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F1B6BE40-C366-1F48-B160-05B18B1201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850" r="909"/>
            <a:stretch/>
          </p:blipFill>
          <p:spPr>
            <a:xfrm>
              <a:off x="19160" y="2488842"/>
              <a:ext cx="6038387" cy="911151"/>
            </a:xfrm>
            <a:prstGeom prst="rect">
              <a:avLst/>
            </a:prstGeom>
          </p:spPr>
        </p:pic>
        <p:grpSp>
          <p:nvGrpSpPr>
            <p:cNvPr id="80" name="Group 79">
              <a:extLst>
                <a:ext uri="{FF2B5EF4-FFF2-40B4-BE49-F238E27FC236}">
                  <a16:creationId xmlns:a16="http://schemas.microsoft.com/office/drawing/2014/main" id="{E38235EF-FA9E-BE4E-908B-66337A97C0DB}"/>
                </a:ext>
              </a:extLst>
            </p:cNvPr>
            <p:cNvGrpSpPr/>
            <p:nvPr/>
          </p:nvGrpSpPr>
          <p:grpSpPr>
            <a:xfrm>
              <a:off x="106491" y="2266372"/>
              <a:ext cx="6133378" cy="345692"/>
              <a:chOff x="106491" y="1035905"/>
              <a:chExt cx="6133378" cy="345692"/>
            </a:xfrm>
          </p:grpSpPr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6AC992DE-012D-5A41-817C-193E91C8092F}"/>
                  </a:ext>
                </a:extLst>
              </p:cNvPr>
              <p:cNvSpPr txBox="1"/>
              <p:nvPr/>
            </p:nvSpPr>
            <p:spPr>
              <a:xfrm>
                <a:off x="106491" y="1139971"/>
                <a:ext cx="80957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/>
                  <a:t>Lymphocytes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C25575CF-E348-7143-96A5-EA7D34C1182D}"/>
                  </a:ext>
                </a:extLst>
              </p:cNvPr>
              <p:cNvSpPr txBox="1"/>
              <p:nvPr/>
            </p:nvSpPr>
            <p:spPr>
              <a:xfrm>
                <a:off x="977156" y="1043043"/>
                <a:ext cx="80957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Single Cell SSC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8D712A40-BAC7-044A-B723-0020AF14B03D}"/>
                  </a:ext>
                </a:extLst>
              </p:cNvPr>
              <p:cNvSpPr txBox="1"/>
              <p:nvPr/>
            </p:nvSpPr>
            <p:spPr>
              <a:xfrm>
                <a:off x="1826537" y="1035905"/>
                <a:ext cx="80957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Single Cell FSC</a:t>
                </a: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7336C7CC-AE7B-2E49-9A0F-27D45AF6DC71}"/>
                  </a:ext>
                </a:extLst>
              </p:cNvPr>
              <p:cNvSpPr txBox="1"/>
              <p:nvPr/>
            </p:nvSpPr>
            <p:spPr>
              <a:xfrm>
                <a:off x="2773956" y="1137025"/>
                <a:ext cx="80957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/>
                  <a:t>Live/Dead</a:t>
                </a:r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AA7C93D5-D010-344F-B1A0-C30A537C1BCC}"/>
                  </a:ext>
                </a:extLst>
              </p:cNvPr>
              <p:cNvSpPr txBox="1"/>
              <p:nvPr/>
            </p:nvSpPr>
            <p:spPr>
              <a:xfrm>
                <a:off x="3778481" y="1150653"/>
                <a:ext cx="41968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/>
                  <a:t>CD3</a:t>
                </a: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5721FF2F-831F-0D46-89D6-89980C9738CB}"/>
                  </a:ext>
                </a:extLst>
              </p:cNvPr>
              <p:cNvSpPr txBox="1"/>
              <p:nvPr/>
            </p:nvSpPr>
            <p:spPr>
              <a:xfrm>
                <a:off x="4532207" y="1150653"/>
                <a:ext cx="69272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/>
                  <a:t>CD8/CD4</a:t>
                </a: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28FE7267-9C5B-5348-9CB7-AF1F581B1FE0}"/>
                  </a:ext>
                </a:extLst>
              </p:cNvPr>
              <p:cNvSpPr txBox="1"/>
              <p:nvPr/>
            </p:nvSpPr>
            <p:spPr>
              <a:xfrm>
                <a:off x="5291338" y="1138642"/>
                <a:ext cx="94853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/>
                  <a:t>CD8 Tetramer</a:t>
                </a:r>
              </a:p>
            </p:txBody>
          </p:sp>
        </p:grp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B93BC797-348E-7A4A-F9FA-560E95CF0330}"/>
              </a:ext>
            </a:extLst>
          </p:cNvPr>
          <p:cNvSpPr txBox="1"/>
          <p:nvPr/>
        </p:nvSpPr>
        <p:spPr>
          <a:xfrm>
            <a:off x="0" y="3809047"/>
            <a:ext cx="60959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Supplemental Figure S1: 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Gating strategy for Ag85B/MHC-II tetramer-positive CD4 T cells (A) and ESAT6/MHC-I </a:t>
            </a:r>
            <a:r>
              <a:rPr lang="en-US" sz="1200" dirty="0">
                <a:latin typeface="Calibri" panose="020F0502020204030204" pitchFamily="34" charset="0"/>
              </a:rPr>
              <a:t>te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tramer-positive CD8 T cells </a:t>
            </a:r>
            <a:r>
              <a:rPr lang="en-US" sz="1200" b="1" dirty="0">
                <a:latin typeface="Calibri" panose="020F0502020204030204" pitchFamily="34" charset="0"/>
              </a:rPr>
              <a:t>(B) 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14077868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E9FF416-EEFF-CE19-5298-746DEA5B32F9}"/>
              </a:ext>
            </a:extLst>
          </p:cNvPr>
          <p:cNvSpPr txBox="1"/>
          <p:nvPr/>
        </p:nvSpPr>
        <p:spPr>
          <a:xfrm>
            <a:off x="-69506" y="47437"/>
            <a:ext cx="16930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dk1"/>
                </a:solidFill>
                <a:latin typeface="Calibri"/>
                <a:cs typeface="Calibri"/>
                <a:sym typeface="Calibri"/>
              </a:rPr>
              <a:t>Supplemental Figure S2</a:t>
            </a:r>
            <a:endParaRPr lang="en-US" sz="1200" b="1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B531C77-987D-8746-A4F5-8AC0BC8BD6B0}"/>
              </a:ext>
            </a:extLst>
          </p:cNvPr>
          <p:cNvSpPr txBox="1"/>
          <p:nvPr/>
        </p:nvSpPr>
        <p:spPr>
          <a:xfrm>
            <a:off x="-69506" y="33971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.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6271395-56ED-CF43-AA4F-2ACB93C91082}"/>
              </a:ext>
            </a:extLst>
          </p:cNvPr>
          <p:cNvSpPr txBox="1"/>
          <p:nvPr/>
        </p:nvSpPr>
        <p:spPr>
          <a:xfrm>
            <a:off x="-44226" y="315263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.</a:t>
            </a:r>
          </a:p>
        </p:txBody>
      </p:sp>
      <p:grpSp>
        <p:nvGrpSpPr>
          <p:cNvPr id="48" name="Group 47">
            <a:extLst>
              <a:ext uri="{FF2B5EF4-FFF2-40B4-BE49-F238E27FC236}">
                <a16:creationId xmlns:a16="http://schemas.microsoft.com/office/drawing/2014/main" id="{F6189E75-B7FE-924B-966C-790D916A098E}"/>
              </a:ext>
            </a:extLst>
          </p:cNvPr>
          <p:cNvGrpSpPr/>
          <p:nvPr/>
        </p:nvGrpSpPr>
        <p:grpSpPr>
          <a:xfrm>
            <a:off x="0" y="480228"/>
            <a:ext cx="6218238" cy="2703232"/>
            <a:chOff x="0" y="408978"/>
            <a:chExt cx="6218238" cy="2703232"/>
          </a:xfrm>
        </p:grpSpPr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08888D9F-0A48-AB4D-A192-A5BBF8B510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4874" r="966" b="65714"/>
            <a:stretch/>
          </p:blipFill>
          <p:spPr>
            <a:xfrm>
              <a:off x="3324032" y="1923139"/>
              <a:ext cx="942116" cy="1016384"/>
            </a:xfrm>
            <a:prstGeom prst="rect">
              <a:avLst/>
            </a:prstGeom>
          </p:spPr>
        </p:pic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24D6317F-F0F7-4A41-9920-8C91A70A4E4B}"/>
                </a:ext>
              </a:extLst>
            </p:cNvPr>
            <p:cNvGrpSpPr/>
            <p:nvPr/>
          </p:nvGrpSpPr>
          <p:grpSpPr>
            <a:xfrm>
              <a:off x="0" y="408978"/>
              <a:ext cx="5674361" cy="1254681"/>
              <a:chOff x="40538" y="739727"/>
              <a:chExt cx="5303765" cy="1111933"/>
            </a:xfrm>
          </p:grpSpPr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95E16295-F80B-A749-BEA8-4C50FF7D713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652" r="14984" b="65714"/>
              <a:stretch/>
            </p:blipFill>
            <p:spPr>
              <a:xfrm>
                <a:off x="40538" y="950912"/>
                <a:ext cx="5246026" cy="900748"/>
              </a:xfrm>
              <a:prstGeom prst="rect">
                <a:avLst/>
              </a:prstGeom>
            </p:spPr>
          </p:pic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CB10BB9F-9B2E-6847-94E0-FC91D02C48AD}"/>
                  </a:ext>
                </a:extLst>
              </p:cNvPr>
              <p:cNvSpPr txBox="1"/>
              <p:nvPr/>
            </p:nvSpPr>
            <p:spPr>
              <a:xfrm>
                <a:off x="157422" y="827239"/>
                <a:ext cx="80957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/>
                  <a:t>Lymphocytes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0CB03238-E2D3-E64B-81EE-46852B405D82}"/>
                  </a:ext>
                </a:extLst>
              </p:cNvPr>
              <p:cNvSpPr txBox="1"/>
              <p:nvPr/>
            </p:nvSpPr>
            <p:spPr>
              <a:xfrm>
                <a:off x="1006272" y="742643"/>
                <a:ext cx="80957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Single Cell SSC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DB7A12AB-4AAE-CC43-8E31-2B7B2F4D63E6}"/>
                  </a:ext>
                </a:extLst>
              </p:cNvPr>
              <p:cNvSpPr txBox="1"/>
              <p:nvPr/>
            </p:nvSpPr>
            <p:spPr>
              <a:xfrm>
                <a:off x="1873588" y="739727"/>
                <a:ext cx="80957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Single Cell FSC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C186066C-B684-5345-9589-CBF6C1C0848A}"/>
                  </a:ext>
                </a:extLst>
              </p:cNvPr>
              <p:cNvSpPr txBox="1"/>
              <p:nvPr/>
            </p:nvSpPr>
            <p:spPr>
              <a:xfrm>
                <a:off x="2831900" y="843191"/>
                <a:ext cx="80957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/>
                  <a:t>Live/Dead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518A44A6-DE8A-6849-A994-4CAB07859C08}"/>
                  </a:ext>
                </a:extLst>
              </p:cNvPr>
              <p:cNvSpPr txBox="1"/>
              <p:nvPr/>
            </p:nvSpPr>
            <p:spPr>
              <a:xfrm>
                <a:off x="3715155" y="848558"/>
                <a:ext cx="727301" cy="190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/>
                  <a:t>CD4/CD8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0BE6D9D7-938F-E145-8222-67D351343506}"/>
                  </a:ext>
                </a:extLst>
              </p:cNvPr>
              <p:cNvSpPr txBox="1"/>
              <p:nvPr/>
            </p:nvSpPr>
            <p:spPr>
              <a:xfrm>
                <a:off x="4570883" y="848558"/>
                <a:ext cx="773420" cy="190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/>
                  <a:t>CD4 </a:t>
                </a:r>
                <a:r>
                  <a:rPr lang="en-US" sz="800" dirty="0">
                    <a:solidFill>
                      <a:schemeClr val="tx1"/>
                    </a:solidFill>
                  </a:rPr>
                  <a:t>CD44</a:t>
                </a:r>
                <a:r>
                  <a:rPr lang="en-US" sz="800" baseline="30000" dirty="0">
                    <a:solidFill>
                      <a:schemeClr val="tx1"/>
                    </a:solidFill>
                  </a:rPr>
                  <a:t>hi</a:t>
                </a:r>
                <a:endParaRPr lang="en-US" sz="800" dirty="0">
                  <a:solidFill>
                    <a:schemeClr val="tx1"/>
                  </a:solidFill>
                </a:endParaRPr>
              </a:p>
            </p:txBody>
          </p:sp>
        </p:grpSp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5B4A223B-32A1-A44F-BB92-EA0BA1BFC4B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12062" y="1546389"/>
              <a:ext cx="657998" cy="38664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Straight Arrow Connector 29">
              <a:extLst>
                <a:ext uri="{FF2B5EF4-FFF2-40B4-BE49-F238E27FC236}">
                  <a16:creationId xmlns:a16="http://schemas.microsoft.com/office/drawing/2014/main" id="{11B9BE74-A4E8-D848-9052-0FCAF1F5E2C4}"/>
                </a:ext>
              </a:extLst>
            </p:cNvPr>
            <p:cNvCxnSpPr>
              <a:cxnSpLocks/>
            </p:cNvCxnSpPr>
            <p:nvPr/>
          </p:nvCxnSpPr>
          <p:spPr>
            <a:xfrm>
              <a:off x="5588032" y="1553429"/>
              <a:ext cx="215944" cy="36971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" name="Straight Arrow Connector 31">
              <a:extLst>
                <a:ext uri="{FF2B5EF4-FFF2-40B4-BE49-F238E27FC236}">
                  <a16:creationId xmlns:a16="http://schemas.microsoft.com/office/drawing/2014/main" id="{0DDC36D9-98DA-A144-B50C-E26DAC04D2ED}"/>
                </a:ext>
              </a:extLst>
            </p:cNvPr>
            <p:cNvCxnSpPr>
              <a:cxnSpLocks/>
            </p:cNvCxnSpPr>
            <p:nvPr/>
          </p:nvCxnSpPr>
          <p:spPr>
            <a:xfrm>
              <a:off x="5020256" y="1666226"/>
              <a:ext cx="0" cy="25948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9A378A21-87ED-9A4D-BCCE-A0F2365C25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4821" t="33640" r="1019" b="34165"/>
            <a:stretch/>
          </p:blipFill>
          <p:spPr>
            <a:xfrm>
              <a:off x="4269478" y="1970326"/>
              <a:ext cx="942116" cy="954367"/>
            </a:xfrm>
            <a:prstGeom prst="rect">
              <a:avLst/>
            </a:prstGeom>
          </p:spPr>
        </p:pic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733A2F84-5A39-664E-A49F-803D9F86EA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5335" t="65964" r="967" b="1944"/>
            <a:stretch/>
          </p:blipFill>
          <p:spPr>
            <a:xfrm>
              <a:off x="5240289" y="1973348"/>
              <a:ext cx="911430" cy="951345"/>
            </a:xfrm>
            <a:prstGeom prst="rect">
              <a:avLst/>
            </a:prstGeom>
          </p:spPr>
        </p:pic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0CCCE1EF-C289-504D-B34B-6D0922EC8175}"/>
                </a:ext>
              </a:extLst>
            </p:cNvPr>
            <p:cNvSpPr txBox="1"/>
            <p:nvPr/>
          </p:nvSpPr>
          <p:spPr>
            <a:xfrm>
              <a:off x="3498305" y="2896766"/>
              <a:ext cx="8661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TNFa/IFNg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F85E8482-4AD8-C941-9C9E-7B33F2064B8D}"/>
                </a:ext>
              </a:extLst>
            </p:cNvPr>
            <p:cNvSpPr txBox="1"/>
            <p:nvPr/>
          </p:nvSpPr>
          <p:spPr>
            <a:xfrm>
              <a:off x="4538724" y="2896766"/>
              <a:ext cx="7488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IL2/IFNg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FD251D5B-F3CB-BB4A-A1D9-854CE4DFEDEA}"/>
                </a:ext>
              </a:extLst>
            </p:cNvPr>
            <p:cNvSpPr txBox="1"/>
            <p:nvPr/>
          </p:nvSpPr>
          <p:spPr>
            <a:xfrm>
              <a:off x="5469397" y="2896766"/>
              <a:ext cx="7488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IL2/TNFa</a:t>
              </a:r>
            </a:p>
          </p:txBody>
        </p:sp>
      </p:grpSp>
      <p:grpSp>
        <p:nvGrpSpPr>
          <p:cNvPr id="47" name="Group 46">
            <a:extLst>
              <a:ext uri="{FF2B5EF4-FFF2-40B4-BE49-F238E27FC236}">
                <a16:creationId xmlns:a16="http://schemas.microsoft.com/office/drawing/2014/main" id="{D550EF26-98E2-9F49-BA0F-484EF59A4B81}"/>
              </a:ext>
            </a:extLst>
          </p:cNvPr>
          <p:cNvGrpSpPr/>
          <p:nvPr/>
        </p:nvGrpSpPr>
        <p:grpSpPr>
          <a:xfrm>
            <a:off x="0" y="3333507"/>
            <a:ext cx="6218238" cy="1323135"/>
            <a:chOff x="0" y="3913150"/>
            <a:chExt cx="6218238" cy="1323135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242C6F91-B9E0-FD40-B372-9520F8FE8FC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0" y="4157800"/>
              <a:ext cx="6218238" cy="1078485"/>
            </a:xfrm>
            <a:prstGeom prst="rect">
              <a:avLst/>
            </a:prstGeom>
          </p:spPr>
        </p:pic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268EE704-7575-A54A-80DB-D5D80F5EC822}"/>
                </a:ext>
              </a:extLst>
            </p:cNvPr>
            <p:cNvSpPr txBox="1"/>
            <p:nvPr/>
          </p:nvSpPr>
          <p:spPr>
            <a:xfrm>
              <a:off x="224552" y="4011897"/>
              <a:ext cx="866146" cy="243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Lymphocytes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E9F18DB0-2794-7947-A6AF-2BD8984C9C0D}"/>
                </a:ext>
              </a:extLst>
            </p:cNvPr>
            <p:cNvSpPr txBox="1"/>
            <p:nvPr/>
          </p:nvSpPr>
          <p:spPr>
            <a:xfrm>
              <a:off x="1175200" y="3913150"/>
              <a:ext cx="866146" cy="382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/>
                <a:t>Single Cell SSC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A613097C-C272-BA4B-B4C1-634400C207D3}"/>
                </a:ext>
              </a:extLst>
            </p:cNvPr>
            <p:cNvSpPr txBox="1"/>
            <p:nvPr/>
          </p:nvSpPr>
          <p:spPr>
            <a:xfrm>
              <a:off x="2196367" y="3913150"/>
              <a:ext cx="866146" cy="382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/>
                <a:t>Single Cell FSC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B0E378E8-23FE-E341-BFF5-134B59B77E87}"/>
                </a:ext>
              </a:extLst>
            </p:cNvPr>
            <p:cNvSpPr txBox="1"/>
            <p:nvPr/>
          </p:nvSpPr>
          <p:spPr>
            <a:xfrm>
              <a:off x="3324032" y="4029897"/>
              <a:ext cx="866146" cy="243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Live/Dead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1C025EA8-9A7B-0043-974A-CCF87D768AB7}"/>
                </a:ext>
              </a:extLst>
            </p:cNvPr>
            <p:cNvSpPr txBox="1"/>
            <p:nvPr/>
          </p:nvSpPr>
          <p:spPr>
            <a:xfrm>
              <a:off x="4399493" y="4036249"/>
              <a:ext cx="741133" cy="243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CD8/CD4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C95B6552-9C3D-2A41-BCE2-7720827636D8}"/>
                </a:ext>
              </a:extLst>
            </p:cNvPr>
            <p:cNvSpPr txBox="1"/>
            <p:nvPr/>
          </p:nvSpPr>
          <p:spPr>
            <a:xfrm>
              <a:off x="5395718" y="4028853"/>
              <a:ext cx="7411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CD4 IL-17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65492686-6B82-33DD-2084-1EA837C26538}"/>
              </a:ext>
            </a:extLst>
          </p:cNvPr>
          <p:cNvSpPr txBox="1"/>
          <p:nvPr/>
        </p:nvSpPr>
        <p:spPr>
          <a:xfrm>
            <a:off x="125051" y="4767072"/>
            <a:ext cx="59099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rtl="0"/>
            <a:r>
              <a:rPr lang="en-US" sz="1200" b="1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Supplemental Figure S2: 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Gating strategy for the intracellular </a:t>
            </a:r>
            <a:r>
              <a:rPr lang="en-US" sz="1200" dirty="0">
                <a:latin typeface="Calibri" panose="020F0502020204030204" pitchFamily="34" charset="0"/>
              </a:rPr>
              <a:t>c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ytokine </a:t>
            </a:r>
            <a:r>
              <a:rPr lang="en-US" sz="1200" dirty="0">
                <a:latin typeface="Calibri" panose="020F0502020204030204" pitchFamily="34" charset="0"/>
              </a:rPr>
              <a:t>s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taining of double-positive Th1 CD4 T cells (</a:t>
            </a:r>
            <a:r>
              <a:rPr lang="en-US" sz="1200" b="1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A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) and IL-17-positive Th17 Cells (</a:t>
            </a:r>
            <a:r>
              <a:rPr lang="en-US" sz="1200" b="1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B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). </a:t>
            </a:r>
          </a:p>
        </p:txBody>
      </p:sp>
    </p:spTree>
    <p:extLst>
      <p:ext uri="{BB962C8B-B14F-4D97-AF65-F5344CB8AC3E}">
        <p14:creationId xmlns:p14="http://schemas.microsoft.com/office/powerpoint/2010/main" val="15398958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301</TotalTime>
  <Words>196</Words>
  <Application>Microsoft Macintosh PowerPoint</Application>
  <PresentationFormat>Custom</PresentationFormat>
  <Paragraphs>41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a Cain</dc:creator>
  <cp:lastModifiedBy>Hinh Ly</cp:lastModifiedBy>
  <cp:revision>527</cp:revision>
  <cp:lastPrinted>2025-06-25T16:56:04Z</cp:lastPrinted>
  <dcterms:created xsi:type="dcterms:W3CDTF">2024-03-26T16:42:02Z</dcterms:created>
  <dcterms:modified xsi:type="dcterms:W3CDTF">2026-06-02T03:04:19Z</dcterms:modified>
</cp:coreProperties>
</file>